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78" r:id="rId2"/>
    <p:sldId id="263" r:id="rId3"/>
    <p:sldId id="272" r:id="rId4"/>
    <p:sldId id="270" r:id="rId5"/>
    <p:sldId id="274" r:id="rId6"/>
    <p:sldId id="273" r:id="rId7"/>
    <p:sldId id="276" r:id="rId8"/>
    <p:sldId id="275" r:id="rId9"/>
    <p:sldId id="281" r:id="rId10"/>
    <p:sldId id="280" r:id="rId11"/>
    <p:sldId id="284" r:id="rId12"/>
    <p:sldId id="282" r:id="rId13"/>
    <p:sldId id="277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17BE6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06" autoAdjust="0"/>
    <p:restoredTop sz="92912" autoAdjust="0"/>
  </p:normalViewPr>
  <p:slideViewPr>
    <p:cSldViewPr snapToGrid="0">
      <p:cViewPr>
        <p:scale>
          <a:sx n="75" d="100"/>
          <a:sy n="75" d="100"/>
        </p:scale>
        <p:origin x="1456" y="-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501E6A-7AFB-480A-9695-805125AEFADC}" type="datetimeFigureOut">
              <a:rPr lang="en-IN" smtClean="0"/>
              <a:t>06-07-202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A1DF62-903C-434C-89B8-4E3EF37DDE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54446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A1DF62-903C-434C-89B8-4E3EF37DDE78}" type="slidenum">
              <a:rPr lang="en-IN" smtClean="0"/>
              <a:t>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85768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A1DF62-903C-434C-89B8-4E3EF37DDE78}" type="slidenum">
              <a:rPr lang="en-IN" smtClean="0"/>
              <a:t>1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92424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FCD8D-8498-8C44-AE63-B3E7E1FCF959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01577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9DD4-AB27-CC46-BA90-232174B9C9CA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0508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6DB32-A331-1D4C-9D39-15F9A560E9EB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15504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D2345B-A69B-8141-BA70-6BC1D4DA3F8A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113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F1752-03E0-DB45-8E27-8C44B1540229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704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B12CB-21CC-464B-A3A5-417593461473}" type="datetime1">
              <a:rPr lang="en-IN" smtClean="0"/>
              <a:t>06-07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03811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AB3A4-7FD6-9341-9CD8-A2BD7FA15909}" type="datetime1">
              <a:rPr lang="en-IN" smtClean="0"/>
              <a:t>06-07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3106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C5347-7AE2-644F-AD8F-20FEAEC1BED8}" type="datetime1">
              <a:rPr lang="en-IN" smtClean="0"/>
              <a:t>06-07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208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9C926-2C1C-A045-95EE-922E1267BA90}" type="datetime1">
              <a:rPr lang="en-IN" smtClean="0"/>
              <a:t>06-07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8662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89CA6F-C1F3-A248-8517-4395077A716C}" type="datetime1">
              <a:rPr lang="en-IN" smtClean="0"/>
              <a:t>06-07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2005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6C9DD-959E-494A-A831-5A7C7320E3AD}" type="datetime1">
              <a:rPr lang="en-IN" smtClean="0"/>
              <a:t>06-07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3356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473B0-A6E3-8642-B3D2-DFCD35458470}" type="datetime1">
              <a:rPr lang="en-IN" smtClean="0"/>
              <a:t>06-07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2A8AD-D833-4F86-84ED-DA4B57ECCB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9148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7.bin"/><Relationship Id="rId13" Type="http://schemas.openxmlformats.org/officeDocument/2006/relationships/image" Target="../media/image100.emf"/><Relationship Id="rId18" Type="http://schemas.openxmlformats.org/officeDocument/2006/relationships/oleObject" Target="../embeddings/oleObject52.bin"/><Relationship Id="rId3" Type="http://schemas.openxmlformats.org/officeDocument/2006/relationships/image" Target="../media/image93.png"/><Relationship Id="rId7" Type="http://schemas.openxmlformats.org/officeDocument/2006/relationships/image" Target="../media/image97.png"/><Relationship Id="rId12" Type="http://schemas.openxmlformats.org/officeDocument/2006/relationships/oleObject" Target="../embeddings/oleObject49.bin"/><Relationship Id="rId17" Type="http://schemas.openxmlformats.org/officeDocument/2006/relationships/image" Target="../media/image102.emf"/><Relationship Id="rId2" Type="http://schemas.openxmlformats.org/officeDocument/2006/relationships/notesSlide" Target="../notesSlides/notesSlide2.xml"/><Relationship Id="rId16" Type="http://schemas.openxmlformats.org/officeDocument/2006/relationships/oleObject" Target="../embeddings/oleObject5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6.jpeg"/><Relationship Id="rId11" Type="http://schemas.openxmlformats.org/officeDocument/2006/relationships/image" Target="../media/image99.emf"/><Relationship Id="rId5" Type="http://schemas.openxmlformats.org/officeDocument/2006/relationships/image" Target="../media/image95.jpeg"/><Relationship Id="rId15" Type="http://schemas.openxmlformats.org/officeDocument/2006/relationships/image" Target="../media/image101.emf"/><Relationship Id="rId10" Type="http://schemas.openxmlformats.org/officeDocument/2006/relationships/oleObject" Target="../embeddings/oleObject48.bin"/><Relationship Id="rId19" Type="http://schemas.openxmlformats.org/officeDocument/2006/relationships/image" Target="../media/image103.emf"/><Relationship Id="rId4" Type="http://schemas.openxmlformats.org/officeDocument/2006/relationships/image" Target="../media/image94.jpeg"/><Relationship Id="rId9" Type="http://schemas.openxmlformats.org/officeDocument/2006/relationships/image" Target="../media/image98.emf"/><Relationship Id="rId14" Type="http://schemas.openxmlformats.org/officeDocument/2006/relationships/oleObject" Target="../embeddings/oleObject50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6.bin"/><Relationship Id="rId3" Type="http://schemas.openxmlformats.org/officeDocument/2006/relationships/image" Target="../media/image104.emf"/><Relationship Id="rId7" Type="http://schemas.openxmlformats.org/officeDocument/2006/relationships/image" Target="../media/image106.emf"/><Relationship Id="rId2" Type="http://schemas.openxmlformats.org/officeDocument/2006/relationships/oleObject" Target="../embeddings/oleObject5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5.bin"/><Relationship Id="rId11" Type="http://schemas.openxmlformats.org/officeDocument/2006/relationships/image" Target="../media/image108.emf"/><Relationship Id="rId5" Type="http://schemas.openxmlformats.org/officeDocument/2006/relationships/image" Target="../media/image105.emf"/><Relationship Id="rId10" Type="http://schemas.openxmlformats.org/officeDocument/2006/relationships/oleObject" Target="../embeddings/oleObject57.bin"/><Relationship Id="rId4" Type="http://schemas.openxmlformats.org/officeDocument/2006/relationships/oleObject" Target="../embeddings/oleObject54.bin"/><Relationship Id="rId9" Type="http://schemas.openxmlformats.org/officeDocument/2006/relationships/image" Target="../media/image107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1.bin"/><Relationship Id="rId13" Type="http://schemas.openxmlformats.org/officeDocument/2006/relationships/image" Target="../media/image114.emf"/><Relationship Id="rId3" Type="http://schemas.openxmlformats.org/officeDocument/2006/relationships/image" Target="../media/image109.emf"/><Relationship Id="rId7" Type="http://schemas.openxmlformats.org/officeDocument/2006/relationships/image" Target="../media/image111.emf"/><Relationship Id="rId12" Type="http://schemas.openxmlformats.org/officeDocument/2006/relationships/oleObject" Target="../embeddings/oleObject63.bin"/><Relationship Id="rId17" Type="http://schemas.openxmlformats.org/officeDocument/2006/relationships/image" Target="../media/image116.emf"/><Relationship Id="rId2" Type="http://schemas.openxmlformats.org/officeDocument/2006/relationships/oleObject" Target="../embeddings/oleObject58.bin"/><Relationship Id="rId16" Type="http://schemas.openxmlformats.org/officeDocument/2006/relationships/oleObject" Target="../embeddings/oleObject6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0.bin"/><Relationship Id="rId11" Type="http://schemas.openxmlformats.org/officeDocument/2006/relationships/image" Target="../media/image113.emf"/><Relationship Id="rId5" Type="http://schemas.openxmlformats.org/officeDocument/2006/relationships/image" Target="../media/image110.emf"/><Relationship Id="rId15" Type="http://schemas.openxmlformats.org/officeDocument/2006/relationships/image" Target="../media/image115.emf"/><Relationship Id="rId10" Type="http://schemas.openxmlformats.org/officeDocument/2006/relationships/oleObject" Target="../embeddings/oleObject62.bin"/><Relationship Id="rId4" Type="http://schemas.openxmlformats.org/officeDocument/2006/relationships/oleObject" Target="../embeddings/oleObject59.bin"/><Relationship Id="rId9" Type="http://schemas.openxmlformats.org/officeDocument/2006/relationships/image" Target="../media/image112.emf"/><Relationship Id="rId14" Type="http://schemas.openxmlformats.org/officeDocument/2006/relationships/oleObject" Target="../embeddings/oleObject64.bin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8.bin"/><Relationship Id="rId13" Type="http://schemas.openxmlformats.org/officeDocument/2006/relationships/image" Target="../media/image123.emf"/><Relationship Id="rId3" Type="http://schemas.openxmlformats.org/officeDocument/2006/relationships/image" Target="../media/image117.emf"/><Relationship Id="rId7" Type="http://schemas.openxmlformats.org/officeDocument/2006/relationships/image" Target="../media/image120.png"/><Relationship Id="rId12" Type="http://schemas.openxmlformats.org/officeDocument/2006/relationships/oleObject" Target="../embeddings/oleObject70.bin"/><Relationship Id="rId2" Type="http://schemas.openxmlformats.org/officeDocument/2006/relationships/oleObject" Target="../embeddings/oleObject66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9.jpeg"/><Relationship Id="rId11" Type="http://schemas.openxmlformats.org/officeDocument/2006/relationships/image" Target="../media/image122.emf"/><Relationship Id="rId5" Type="http://schemas.openxmlformats.org/officeDocument/2006/relationships/image" Target="../media/image118.emf"/><Relationship Id="rId10" Type="http://schemas.openxmlformats.org/officeDocument/2006/relationships/oleObject" Target="../embeddings/oleObject69.bin"/><Relationship Id="rId4" Type="http://schemas.openxmlformats.org/officeDocument/2006/relationships/oleObject" Target="../embeddings/oleObject67.bin"/><Relationship Id="rId9" Type="http://schemas.openxmlformats.org/officeDocument/2006/relationships/image" Target="../media/image1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5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7.emf"/><Relationship Id="rId5" Type="http://schemas.openxmlformats.org/officeDocument/2006/relationships/image" Target="../media/image14.emf"/><Relationship Id="rId15" Type="http://schemas.openxmlformats.org/officeDocument/2006/relationships/image" Target="../media/image19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6.emf"/><Relationship Id="rId1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13" Type="http://schemas.openxmlformats.org/officeDocument/2006/relationships/image" Target="../media/image26.e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28.emf"/><Relationship Id="rId2" Type="http://schemas.openxmlformats.org/officeDocument/2006/relationships/image" Target="../media/image20.png"/><Relationship Id="rId16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11" Type="http://schemas.openxmlformats.org/officeDocument/2006/relationships/image" Target="../media/image25.emf"/><Relationship Id="rId5" Type="http://schemas.openxmlformats.org/officeDocument/2006/relationships/oleObject" Target="../embeddings/oleObject9.bin"/><Relationship Id="rId15" Type="http://schemas.openxmlformats.org/officeDocument/2006/relationships/image" Target="../media/image27.emf"/><Relationship Id="rId10" Type="http://schemas.openxmlformats.org/officeDocument/2006/relationships/oleObject" Target="../embeddings/oleObject11.bin"/><Relationship Id="rId4" Type="http://schemas.openxmlformats.org/officeDocument/2006/relationships/image" Target="../media/image21.emf"/><Relationship Id="rId9" Type="http://schemas.openxmlformats.org/officeDocument/2006/relationships/image" Target="../media/image24.emf"/><Relationship Id="rId14" Type="http://schemas.openxmlformats.org/officeDocument/2006/relationships/oleObject" Target="../embeddings/oleObject1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34.emf"/><Relationship Id="rId18" Type="http://schemas.openxmlformats.org/officeDocument/2006/relationships/image" Target="../media/image37.png"/><Relationship Id="rId3" Type="http://schemas.openxmlformats.org/officeDocument/2006/relationships/image" Target="../media/image29.emf"/><Relationship Id="rId21" Type="http://schemas.openxmlformats.org/officeDocument/2006/relationships/image" Target="../media/image40.png"/><Relationship Id="rId7" Type="http://schemas.openxmlformats.org/officeDocument/2006/relationships/image" Target="../media/image31.emf"/><Relationship Id="rId12" Type="http://schemas.openxmlformats.org/officeDocument/2006/relationships/oleObject" Target="../embeddings/oleObject20.bin"/><Relationship Id="rId17" Type="http://schemas.openxmlformats.org/officeDocument/2006/relationships/image" Target="../media/image36.emf"/><Relationship Id="rId25" Type="http://schemas.openxmlformats.org/officeDocument/2006/relationships/image" Target="../media/image44.png"/><Relationship Id="rId2" Type="http://schemas.openxmlformats.org/officeDocument/2006/relationships/oleObject" Target="../embeddings/oleObject15.bin"/><Relationship Id="rId16" Type="http://schemas.openxmlformats.org/officeDocument/2006/relationships/oleObject" Target="../embeddings/oleObject22.bin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33.emf"/><Relationship Id="rId24" Type="http://schemas.openxmlformats.org/officeDocument/2006/relationships/image" Target="../media/image43.png"/><Relationship Id="rId5" Type="http://schemas.openxmlformats.org/officeDocument/2006/relationships/image" Target="../media/image30.emf"/><Relationship Id="rId15" Type="http://schemas.openxmlformats.org/officeDocument/2006/relationships/image" Target="../media/image35.emf"/><Relationship Id="rId23" Type="http://schemas.openxmlformats.org/officeDocument/2006/relationships/image" Target="../media/image42.png"/><Relationship Id="rId10" Type="http://schemas.openxmlformats.org/officeDocument/2006/relationships/oleObject" Target="../embeddings/oleObject19.bin"/><Relationship Id="rId19" Type="http://schemas.openxmlformats.org/officeDocument/2006/relationships/image" Target="../media/image38.png"/><Relationship Id="rId4" Type="http://schemas.openxmlformats.org/officeDocument/2006/relationships/oleObject" Target="../embeddings/oleObject16.bin"/><Relationship Id="rId9" Type="http://schemas.openxmlformats.org/officeDocument/2006/relationships/image" Target="../media/image32.emf"/><Relationship Id="rId14" Type="http://schemas.openxmlformats.org/officeDocument/2006/relationships/oleObject" Target="../embeddings/oleObject21.bin"/><Relationship Id="rId22" Type="http://schemas.openxmlformats.org/officeDocument/2006/relationships/image" Target="../media/image4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6.bin"/><Relationship Id="rId13" Type="http://schemas.openxmlformats.org/officeDocument/2006/relationships/image" Target="../media/image50.emf"/><Relationship Id="rId18" Type="http://schemas.openxmlformats.org/officeDocument/2006/relationships/oleObject" Target="../embeddings/oleObject31.bin"/><Relationship Id="rId26" Type="http://schemas.openxmlformats.org/officeDocument/2006/relationships/oleObject" Target="../embeddings/oleObject35.bin"/><Relationship Id="rId3" Type="http://schemas.openxmlformats.org/officeDocument/2006/relationships/image" Target="../media/image45.emf"/><Relationship Id="rId21" Type="http://schemas.openxmlformats.org/officeDocument/2006/relationships/image" Target="../media/image54.emf"/><Relationship Id="rId7" Type="http://schemas.openxmlformats.org/officeDocument/2006/relationships/image" Target="../media/image47.emf"/><Relationship Id="rId12" Type="http://schemas.openxmlformats.org/officeDocument/2006/relationships/oleObject" Target="../embeddings/oleObject28.bin"/><Relationship Id="rId17" Type="http://schemas.openxmlformats.org/officeDocument/2006/relationships/image" Target="../media/image52.emf"/><Relationship Id="rId25" Type="http://schemas.openxmlformats.org/officeDocument/2006/relationships/image" Target="../media/image56.emf"/><Relationship Id="rId2" Type="http://schemas.openxmlformats.org/officeDocument/2006/relationships/oleObject" Target="../embeddings/oleObject23.bin"/><Relationship Id="rId16" Type="http://schemas.openxmlformats.org/officeDocument/2006/relationships/oleObject" Target="../embeddings/oleObject30.bin"/><Relationship Id="rId20" Type="http://schemas.openxmlformats.org/officeDocument/2006/relationships/oleObject" Target="../embeddings/oleObject3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5.bin"/><Relationship Id="rId11" Type="http://schemas.openxmlformats.org/officeDocument/2006/relationships/image" Target="../media/image49.emf"/><Relationship Id="rId24" Type="http://schemas.openxmlformats.org/officeDocument/2006/relationships/oleObject" Target="../embeddings/oleObject34.bin"/><Relationship Id="rId5" Type="http://schemas.openxmlformats.org/officeDocument/2006/relationships/image" Target="../media/image46.emf"/><Relationship Id="rId15" Type="http://schemas.openxmlformats.org/officeDocument/2006/relationships/image" Target="../media/image51.emf"/><Relationship Id="rId23" Type="http://schemas.openxmlformats.org/officeDocument/2006/relationships/image" Target="../media/image55.emf"/><Relationship Id="rId10" Type="http://schemas.openxmlformats.org/officeDocument/2006/relationships/oleObject" Target="../embeddings/oleObject27.bin"/><Relationship Id="rId19" Type="http://schemas.openxmlformats.org/officeDocument/2006/relationships/image" Target="../media/image53.emf"/><Relationship Id="rId4" Type="http://schemas.openxmlformats.org/officeDocument/2006/relationships/oleObject" Target="../embeddings/oleObject24.bin"/><Relationship Id="rId9" Type="http://schemas.openxmlformats.org/officeDocument/2006/relationships/image" Target="../media/image48.emf"/><Relationship Id="rId14" Type="http://schemas.openxmlformats.org/officeDocument/2006/relationships/oleObject" Target="../embeddings/oleObject29.bin"/><Relationship Id="rId22" Type="http://schemas.openxmlformats.org/officeDocument/2006/relationships/oleObject" Target="../embeddings/oleObject33.bin"/><Relationship Id="rId27" Type="http://schemas.openxmlformats.org/officeDocument/2006/relationships/image" Target="../media/image57.em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5.jpeg"/><Relationship Id="rId18" Type="http://schemas.openxmlformats.org/officeDocument/2006/relationships/image" Target="../media/image70.jpeg"/><Relationship Id="rId26" Type="http://schemas.openxmlformats.org/officeDocument/2006/relationships/image" Target="../media/image75.emf"/><Relationship Id="rId21" Type="http://schemas.openxmlformats.org/officeDocument/2006/relationships/oleObject" Target="../embeddings/oleObject39.bin"/><Relationship Id="rId34" Type="http://schemas.openxmlformats.org/officeDocument/2006/relationships/image" Target="../media/image81.jpeg"/><Relationship Id="rId7" Type="http://schemas.openxmlformats.org/officeDocument/2006/relationships/image" Target="../media/image60.emf"/><Relationship Id="rId12" Type="http://schemas.openxmlformats.org/officeDocument/2006/relationships/image" Target="../media/image64.jpeg"/><Relationship Id="rId17" Type="http://schemas.openxmlformats.org/officeDocument/2006/relationships/image" Target="../media/image69.jpeg"/><Relationship Id="rId25" Type="http://schemas.openxmlformats.org/officeDocument/2006/relationships/oleObject" Target="../embeddings/oleObject41.bin"/><Relationship Id="rId33" Type="http://schemas.openxmlformats.org/officeDocument/2006/relationships/image" Target="../media/image8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68.jpeg"/><Relationship Id="rId20" Type="http://schemas.openxmlformats.org/officeDocument/2006/relationships/image" Target="../media/image72.jpeg"/><Relationship Id="rId29" Type="http://schemas.openxmlformats.org/officeDocument/2006/relationships/oleObject" Target="../embeddings/oleObject4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7.bin"/><Relationship Id="rId11" Type="http://schemas.openxmlformats.org/officeDocument/2006/relationships/image" Target="../media/image63.png"/><Relationship Id="rId24" Type="http://schemas.openxmlformats.org/officeDocument/2006/relationships/image" Target="../media/image74.emf"/><Relationship Id="rId32" Type="http://schemas.openxmlformats.org/officeDocument/2006/relationships/image" Target="../media/image79.jpeg"/><Relationship Id="rId37" Type="http://schemas.openxmlformats.org/officeDocument/2006/relationships/image" Target="../media/image83.emf"/><Relationship Id="rId5" Type="http://schemas.openxmlformats.org/officeDocument/2006/relationships/image" Target="../media/image59.png"/><Relationship Id="rId15" Type="http://schemas.openxmlformats.org/officeDocument/2006/relationships/image" Target="../media/image67.jpeg"/><Relationship Id="rId23" Type="http://schemas.openxmlformats.org/officeDocument/2006/relationships/oleObject" Target="../embeddings/oleObject40.bin"/><Relationship Id="rId28" Type="http://schemas.openxmlformats.org/officeDocument/2006/relationships/image" Target="../media/image76.emf"/><Relationship Id="rId36" Type="http://schemas.openxmlformats.org/officeDocument/2006/relationships/oleObject" Target="../embeddings/oleObject44.bin"/><Relationship Id="rId10" Type="http://schemas.openxmlformats.org/officeDocument/2006/relationships/image" Target="../media/image62.emf"/><Relationship Id="rId19" Type="http://schemas.openxmlformats.org/officeDocument/2006/relationships/image" Target="../media/image71.jpeg"/><Relationship Id="rId31" Type="http://schemas.openxmlformats.org/officeDocument/2006/relationships/image" Target="../media/image78.jpeg"/><Relationship Id="rId4" Type="http://schemas.openxmlformats.org/officeDocument/2006/relationships/image" Target="../media/image58.emf"/><Relationship Id="rId9" Type="http://schemas.openxmlformats.org/officeDocument/2006/relationships/oleObject" Target="../embeddings/oleObject38.bin"/><Relationship Id="rId14" Type="http://schemas.openxmlformats.org/officeDocument/2006/relationships/image" Target="../media/image66.jpeg"/><Relationship Id="rId22" Type="http://schemas.openxmlformats.org/officeDocument/2006/relationships/image" Target="../media/image73.emf"/><Relationship Id="rId27" Type="http://schemas.openxmlformats.org/officeDocument/2006/relationships/oleObject" Target="../embeddings/oleObject42.bin"/><Relationship Id="rId30" Type="http://schemas.openxmlformats.org/officeDocument/2006/relationships/image" Target="../media/image77.emf"/><Relationship Id="rId35" Type="http://schemas.openxmlformats.org/officeDocument/2006/relationships/image" Target="../media/image82.jpeg"/><Relationship Id="rId8" Type="http://schemas.openxmlformats.org/officeDocument/2006/relationships/image" Target="../media/image61.png"/><Relationship Id="rId3" Type="http://schemas.openxmlformats.org/officeDocument/2006/relationships/oleObject" Target="../embeddings/oleObject36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3" Type="http://schemas.openxmlformats.org/officeDocument/2006/relationships/image" Target="../media/image84.emf"/><Relationship Id="rId7" Type="http://schemas.openxmlformats.org/officeDocument/2006/relationships/image" Target="../media/image87.png"/><Relationship Id="rId12" Type="http://schemas.openxmlformats.org/officeDocument/2006/relationships/image" Target="../media/image92.jpeg"/><Relationship Id="rId2" Type="http://schemas.openxmlformats.org/officeDocument/2006/relationships/oleObject" Target="../embeddings/oleObject45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png"/><Relationship Id="rId11" Type="http://schemas.openxmlformats.org/officeDocument/2006/relationships/image" Target="../media/image91.png"/><Relationship Id="rId5" Type="http://schemas.openxmlformats.org/officeDocument/2006/relationships/image" Target="../media/image85.emf"/><Relationship Id="rId10" Type="http://schemas.openxmlformats.org/officeDocument/2006/relationships/image" Target="../media/image90.png"/><Relationship Id="rId4" Type="http://schemas.openxmlformats.org/officeDocument/2006/relationships/oleObject" Target="../embeddings/oleObject46.bin"/><Relationship Id="rId9" Type="http://schemas.openxmlformats.org/officeDocument/2006/relationships/image" Target="../media/image8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DEB3FC0-E097-817F-620B-D57241E4A43C}"/>
              </a:ext>
            </a:extLst>
          </p:cNvPr>
          <p:cNvSpPr txBox="1"/>
          <p:nvPr/>
        </p:nvSpPr>
        <p:spPr>
          <a:xfrm>
            <a:off x="607483" y="359431"/>
            <a:ext cx="564303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ionine metabolism shapes immune response in macrophages against </a:t>
            </a:r>
            <a:r>
              <a:rPr lang="en-I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um tuberculosi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dhi Yadav, Ashish Gupta, Satya Ranjan Sahoo, Suchitra Jena,  Nainy Goel, Mothe Sravya,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dup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mgail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upur Sharm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eshwar Nath Jha,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hishma Narayan Pand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mesh Gupta,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swinder Singh Maras,</a:t>
            </a:r>
            <a:r>
              <a:rPr lang="en-I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t Kumar Pandey, Shyam Kumar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akapalli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ebasis Dash, Ranjan Kumar Nanda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B1FAA6AC-B82D-9E4A-9437-D09410B9A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IN" dirty="0"/>
              <a:t>S-</a:t>
            </a:r>
            <a:fld id="{CB12A8AD-D833-4F86-84ED-DA4B57ECCBB0}" type="slidenum">
              <a:rPr lang="en-IN" smtClean="0"/>
              <a:t>1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9654463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8495AE8-9B54-A315-2A87-B45524794EA4}"/>
              </a:ext>
            </a:extLst>
          </p:cNvPr>
          <p:cNvSpPr txBox="1"/>
          <p:nvPr/>
        </p:nvSpPr>
        <p:spPr>
          <a:xfrm>
            <a:off x="612235" y="515016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9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E11FD6-D080-3EA4-2E5A-CABF203F5249}"/>
              </a:ext>
            </a:extLst>
          </p:cNvPr>
          <p:cNvSpPr txBox="1"/>
          <p:nvPr/>
        </p:nvSpPr>
        <p:spPr>
          <a:xfrm>
            <a:off x="448293" y="7840660"/>
            <a:ext cx="598701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9: Tissue-specific metabolite changes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C57BL/6 mice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showing the levels of various amino acids in the mice groups in serum, lungs and liver, respectivel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 showing the significantly altered metabolic features and the pathway enrichment plots for serum and liver of methionine-supplemented mice compared with infected contro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rank correlation coefficients of fold change of metabolites (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) induced by methionine supplementation in the liver and serum of mice with lungs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I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gt; ±1.0 and log10 (p-value)&gt; 1.3 are considered significant for differences;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i: days post-infection, CT: control, MS: methionine supplemented, MS to CT: Methionine supplemented for 2 weeks, then shifted to control pos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A48612D-4FDC-C418-332D-D08E038B5757}"/>
              </a:ext>
            </a:extLst>
          </p:cNvPr>
          <p:cNvGrpSpPr/>
          <p:nvPr/>
        </p:nvGrpSpPr>
        <p:grpSpPr>
          <a:xfrm>
            <a:off x="866381" y="758080"/>
            <a:ext cx="5940061" cy="2357949"/>
            <a:chOff x="533334" y="1201265"/>
            <a:chExt cx="11507869" cy="372849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B4E49BB-912B-C713-981E-F7D0EB78D578}"/>
                </a:ext>
              </a:extLst>
            </p:cNvPr>
            <p:cNvGrpSpPr/>
            <p:nvPr/>
          </p:nvGrpSpPr>
          <p:grpSpPr>
            <a:xfrm>
              <a:off x="533334" y="1201265"/>
              <a:ext cx="11507869" cy="3728498"/>
              <a:chOff x="481375" y="1543530"/>
              <a:chExt cx="11507869" cy="3728498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6845946-2094-512F-30EE-4782AF75B3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9276044" y="1905000"/>
                <a:ext cx="922901" cy="3290827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BCA872B2-BD75-D49E-C508-714D412745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27675" y="1552450"/>
                <a:ext cx="2677693" cy="3719577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41DD2FA9-4031-6945-72A0-0D92413D54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1"/>
              <a:stretch>
                <a:fillRect/>
              </a:stretch>
            </p:blipFill>
            <p:spPr>
              <a:xfrm>
                <a:off x="3506540" y="1543530"/>
                <a:ext cx="2613701" cy="3728498"/>
              </a:xfrm>
              <a:prstGeom prst="rect">
                <a:avLst/>
              </a:prstGeom>
            </p:spPr>
          </p:pic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BAB21FFB-7BFE-6A6E-0C7D-3B7AFFB0F554}"/>
                  </a:ext>
                </a:extLst>
              </p:cNvPr>
              <p:cNvGrpSpPr/>
              <p:nvPr/>
            </p:nvGrpSpPr>
            <p:grpSpPr>
              <a:xfrm>
                <a:off x="3506541" y="1569041"/>
                <a:ext cx="6777692" cy="3702985"/>
                <a:chOff x="-3566371" y="4001028"/>
                <a:chExt cx="9909184" cy="2413874"/>
              </a:xfrm>
            </p:grpSpPr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2B3CE1D0-97EF-A3DA-5BCD-707C375858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759290" y="4001028"/>
                  <a:ext cx="3984828" cy="2375671"/>
                </a:xfrm>
                <a:prstGeom prst="rect">
                  <a:avLst/>
                </a:prstGeom>
              </p:spPr>
            </p:pic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4F2E3EAD-BE61-FDD6-976E-E7DC26B9D94D}"/>
                    </a:ext>
                  </a:extLst>
                </p:cNvPr>
                <p:cNvSpPr/>
                <p:nvPr/>
              </p:nvSpPr>
              <p:spPr>
                <a:xfrm>
                  <a:off x="-3566371" y="6168303"/>
                  <a:ext cx="9909184" cy="246599"/>
                </a:xfrm>
                <a:prstGeom prst="rect">
                  <a:avLst/>
                </a:prstGeom>
                <a:noFill/>
                <a:ln w="19050">
                  <a:solidFill>
                    <a:srgbClr val="2714DE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</p:grp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315A1B12-F63F-9129-EC6A-74C9D66187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-16094"/>
              <a:stretch>
                <a:fillRect/>
              </a:stretch>
            </p:blipFill>
            <p:spPr>
              <a:xfrm>
                <a:off x="10383357" y="1569037"/>
                <a:ext cx="1605887" cy="2925415"/>
              </a:xfrm>
              <a:prstGeom prst="rect">
                <a:avLst/>
              </a:prstGeom>
            </p:spPr>
          </p:pic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360A4102-6456-4DCE-B0CE-90C26422E010}"/>
                  </a:ext>
                </a:extLst>
              </p:cNvPr>
              <p:cNvSpPr/>
              <p:nvPr/>
            </p:nvSpPr>
            <p:spPr>
              <a:xfrm>
                <a:off x="481375" y="4349099"/>
                <a:ext cx="5702801" cy="326204"/>
              </a:xfrm>
              <a:prstGeom prst="rect">
                <a:avLst/>
              </a:prstGeom>
              <a:noFill/>
              <a:ln w="19050">
                <a:solidFill>
                  <a:srgbClr val="2714DE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7582205-AF17-EB0D-DCD4-75E0A1F5FB18}"/>
                </a:ext>
              </a:extLst>
            </p:cNvPr>
            <p:cNvSpPr/>
            <p:nvPr/>
          </p:nvSpPr>
          <p:spPr>
            <a:xfrm>
              <a:off x="9261301" y="2881944"/>
              <a:ext cx="1193394" cy="274573"/>
            </a:xfrm>
            <a:prstGeom prst="rect">
              <a:avLst/>
            </a:prstGeom>
            <a:noFill/>
            <a:ln w="19050">
              <a:solidFill>
                <a:srgbClr val="2714DE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013E6A6-0288-FFC1-B667-A887B51821D8}"/>
                </a:ext>
              </a:extLst>
            </p:cNvPr>
            <p:cNvSpPr/>
            <p:nvPr/>
          </p:nvSpPr>
          <p:spPr>
            <a:xfrm>
              <a:off x="9251612" y="4020847"/>
              <a:ext cx="999292" cy="219227"/>
            </a:xfrm>
            <a:prstGeom prst="rect">
              <a:avLst/>
            </a:prstGeom>
            <a:noFill/>
            <a:ln w="19050">
              <a:solidFill>
                <a:srgbClr val="2714DE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</p:grp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B7D97D8F-0AD4-85C5-E65D-36521070BC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4596162"/>
              </p:ext>
            </p:extLst>
          </p:nvPr>
        </p:nvGraphicFramePr>
        <p:xfrm>
          <a:off x="2732048" y="3183412"/>
          <a:ext cx="2860334" cy="1417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777921" imgH="2712955" progId="Prism8.Document">
                  <p:embed/>
                </p:oleObj>
              </mc:Choice>
              <mc:Fallback>
                <p:oleObj name="Prism 8" r:id="rId8" imgW="4777921" imgH="2712955" progId="Prism8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B7D97D8F-0AD4-85C5-E65D-36521070BC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32048" y="3183412"/>
                        <a:ext cx="2860334" cy="1417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8439A615-988A-4C33-1343-23F81AE386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1508489"/>
              </p:ext>
            </p:extLst>
          </p:nvPr>
        </p:nvGraphicFramePr>
        <p:xfrm>
          <a:off x="2638982" y="4690477"/>
          <a:ext cx="3243354" cy="1299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5111766" imgH="2712955" progId="Prism8.Document">
                  <p:embed/>
                </p:oleObj>
              </mc:Choice>
              <mc:Fallback>
                <p:oleObj name="Prism 8" r:id="rId10" imgW="5111766" imgH="2712955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8439A615-988A-4C33-1343-23F81AE386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638982" y="4690477"/>
                        <a:ext cx="3243354" cy="1299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866EE4A5-C39A-714D-65E9-7614282D21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0328899"/>
              </p:ext>
            </p:extLst>
          </p:nvPr>
        </p:nvGraphicFramePr>
        <p:xfrm>
          <a:off x="692769" y="3043241"/>
          <a:ext cx="3262312" cy="1697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5730840" imgH="2703954" progId="Prism8.Document">
                  <p:embed/>
                </p:oleObj>
              </mc:Choice>
              <mc:Fallback>
                <p:oleObj name="Prism 8" r:id="rId12" imgW="5730840" imgH="2703954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866EE4A5-C39A-714D-65E9-7614282D21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92769" y="3043241"/>
                        <a:ext cx="3262312" cy="1697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856F4EEA-A96A-BD2A-AD59-8300403048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824078"/>
              </p:ext>
            </p:extLst>
          </p:nvPr>
        </p:nvGraphicFramePr>
        <p:xfrm>
          <a:off x="703881" y="4513073"/>
          <a:ext cx="3251200" cy="187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5604432" imgH="2703954" progId="Prism8.Document">
                  <p:embed/>
                </p:oleObj>
              </mc:Choice>
              <mc:Fallback>
                <p:oleObj name="Prism 8" r:id="rId14" imgW="5604432" imgH="2703954" progId="Prism8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856F4EEA-A96A-BD2A-AD59-8300403048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03881" y="4513073"/>
                        <a:ext cx="3251200" cy="187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FB81CEF8-5460-E78B-8826-379F457A4D6A}"/>
              </a:ext>
            </a:extLst>
          </p:cNvPr>
          <p:cNvSpPr txBox="1"/>
          <p:nvPr/>
        </p:nvSpPr>
        <p:spPr>
          <a:xfrm>
            <a:off x="583570" y="699147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A453387-C42E-888B-F9CB-790930482D56}"/>
              </a:ext>
            </a:extLst>
          </p:cNvPr>
          <p:cNvSpPr txBox="1"/>
          <p:nvPr/>
        </p:nvSpPr>
        <p:spPr>
          <a:xfrm>
            <a:off x="553436" y="3053201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030E3C-DD08-A90A-8EE6-3BA57994D5B1}"/>
              </a:ext>
            </a:extLst>
          </p:cNvPr>
          <p:cNvSpPr txBox="1"/>
          <p:nvPr/>
        </p:nvSpPr>
        <p:spPr>
          <a:xfrm>
            <a:off x="607266" y="6194831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ED663558-8706-6705-DD3C-59FDA9CCB3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8935366"/>
              </p:ext>
            </p:extLst>
          </p:nvPr>
        </p:nvGraphicFramePr>
        <p:xfrm>
          <a:off x="2770725" y="6198661"/>
          <a:ext cx="2390935" cy="17092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753334" imgH="2682711" progId="Prism8.Document">
                  <p:embed/>
                </p:oleObj>
              </mc:Choice>
              <mc:Fallback>
                <p:oleObj name="Prism 8" r:id="rId16" imgW="3753334" imgH="268271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770725" y="6198661"/>
                        <a:ext cx="2390935" cy="17092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D3787A46-80B9-B08E-2FD3-63A9DB2B7B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1417028"/>
              </p:ext>
            </p:extLst>
          </p:nvPr>
        </p:nvGraphicFramePr>
        <p:xfrm>
          <a:off x="607266" y="6166974"/>
          <a:ext cx="2376566" cy="17092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873980" imgH="2682711" progId="Prism8.Document">
                  <p:embed/>
                </p:oleObj>
              </mc:Choice>
              <mc:Fallback>
                <p:oleObj name="Prism 8" r:id="rId18" imgW="3873980" imgH="268271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07266" y="6166974"/>
                        <a:ext cx="2376566" cy="17092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Slide Number Placeholder 17">
            <a:extLst>
              <a:ext uri="{FF2B5EF4-FFF2-40B4-BE49-F238E27FC236}">
                <a16:creationId xmlns:a16="http://schemas.microsoft.com/office/drawing/2014/main" id="{DA78622D-454B-504C-A3C6-928A7D0FA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1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61011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DE91540-35AB-D7B5-37A7-3CC2E30437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8331730"/>
              </p:ext>
            </p:extLst>
          </p:nvPr>
        </p:nvGraphicFramePr>
        <p:xfrm>
          <a:off x="690755" y="770180"/>
          <a:ext cx="2945313" cy="2075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86224" imgH="2738879" progId="Prism8.Document">
                  <p:embed/>
                </p:oleObj>
              </mc:Choice>
              <mc:Fallback>
                <p:oleObj name="Prism 8" r:id="rId2" imgW="3886224" imgH="2738879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BBB5639-2376-267F-F893-085A7496DF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0755" y="770180"/>
                        <a:ext cx="2945313" cy="2075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D6ADB413-B2C2-011B-D6EF-A9A98EEE933E}"/>
              </a:ext>
            </a:extLst>
          </p:cNvPr>
          <p:cNvSpPr txBox="1"/>
          <p:nvPr/>
        </p:nvSpPr>
        <p:spPr>
          <a:xfrm>
            <a:off x="636725" y="377813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0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00462B-4CD4-8F26-31BB-06C99A44849E}"/>
              </a:ext>
            </a:extLst>
          </p:cNvPr>
          <p:cNvSpPr txBox="1"/>
          <p:nvPr/>
        </p:nvSpPr>
        <p:spPr>
          <a:xfrm>
            <a:off x="636725" y="609376"/>
            <a:ext cx="438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DAF30D-ED4F-6577-6F66-81384FF38AFF}"/>
              </a:ext>
            </a:extLst>
          </p:cNvPr>
          <p:cNvSpPr txBox="1"/>
          <p:nvPr/>
        </p:nvSpPr>
        <p:spPr>
          <a:xfrm>
            <a:off x="690755" y="2610635"/>
            <a:ext cx="438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66A9BB48-BDAC-D323-69B8-1401CD6474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9193153"/>
              </p:ext>
            </p:extLst>
          </p:nvPr>
        </p:nvGraphicFramePr>
        <p:xfrm>
          <a:off x="3363099" y="4469747"/>
          <a:ext cx="3220582" cy="18859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5415361" imgH="2748240" progId="Prism8.Document">
                  <p:embed/>
                </p:oleObj>
              </mc:Choice>
              <mc:Fallback>
                <p:oleObj name="Prism 8" r:id="rId4" imgW="5415361" imgH="2748240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9E43837-70B3-13E2-2660-F84C2AC30C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63099" y="4469747"/>
                        <a:ext cx="3220582" cy="18859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3658249B-B472-5F3D-DABE-06E371DF77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9415703"/>
              </p:ext>
            </p:extLst>
          </p:nvPr>
        </p:nvGraphicFramePr>
        <p:xfrm>
          <a:off x="3396937" y="2744656"/>
          <a:ext cx="3089371" cy="1731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5255100" imgH="2787845" progId="Prism8.Document">
                  <p:embed/>
                </p:oleObj>
              </mc:Choice>
              <mc:Fallback>
                <p:oleObj name="Prism 8" r:id="rId6" imgW="5255100" imgH="2787845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B5B5E4D-7E09-0C38-3C02-D8F9E510FF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96937" y="2744656"/>
                        <a:ext cx="3089371" cy="17313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FC364667-981D-53A9-1BC8-0A33BEB6AD10}"/>
              </a:ext>
            </a:extLst>
          </p:cNvPr>
          <p:cNvSpPr txBox="1"/>
          <p:nvPr/>
        </p:nvSpPr>
        <p:spPr>
          <a:xfrm>
            <a:off x="758003" y="4513444"/>
            <a:ext cx="438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905967-6A8F-C2DD-74A5-135497C13820}"/>
              </a:ext>
            </a:extLst>
          </p:cNvPr>
          <p:cNvSpPr txBox="1"/>
          <p:nvPr/>
        </p:nvSpPr>
        <p:spPr>
          <a:xfrm>
            <a:off x="758003" y="6587306"/>
            <a:ext cx="567589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0: Methionine supplementation impacted the liver proteome and increased SAM produc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S-DA plot showing clustering of the liver proteome profile for various groups at 3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 showing the significantly deregulated proteins in the MS group compared with the infected control and the pathway analysis for the deregulated proteins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 showing the significantly deregulated proteins in the MS to CT group compared with the infected control and the pathway analysis for the deregulated proteins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I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&gt;±1.0 and log</a:t>
            </a:r>
            <a:r>
              <a:rPr lang="en-I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&gt;1.3 are considered for significant differenc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S-DA: Partial least square discrimination analysis, Mat1: S-adenosylmethionine synthase 1, CT: control, MS: methionine supplemented, MS to CT: Methionine supplemented for 2 weeks, then shifted to control pos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.</a:t>
            </a: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902CED37-1836-8D99-30C4-50F49282A3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4015777"/>
              </p:ext>
            </p:extLst>
          </p:nvPr>
        </p:nvGraphicFramePr>
        <p:xfrm>
          <a:off x="810413" y="2617759"/>
          <a:ext cx="5105370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6854463" imgH="2766602" progId="Prism8.Document">
                  <p:embed/>
                </p:oleObj>
              </mc:Choice>
              <mc:Fallback>
                <p:oleObj name="Prism 8" r:id="rId8" imgW="6854463" imgH="2766602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E5F5394-4217-C288-F041-962AD9EDFE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10413" y="2617759"/>
                        <a:ext cx="5105370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4D8BD242-A095-2BFA-C8BC-CC8013FA69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2176142"/>
              </p:ext>
            </p:extLst>
          </p:nvPr>
        </p:nvGraphicFramePr>
        <p:xfrm>
          <a:off x="856265" y="4476040"/>
          <a:ext cx="5059517" cy="1959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6799722" imgH="2763362" progId="Prism8.Document">
                  <p:embed/>
                </p:oleObj>
              </mc:Choice>
              <mc:Fallback>
                <p:oleObj name="Prism 8" r:id="rId10" imgW="6799722" imgH="276336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D3B3E85-A839-4E1D-3EE7-4255F4102A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56265" y="4476040"/>
                        <a:ext cx="5059517" cy="19592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488E69B-83B8-7D43-9D79-053D07C2E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1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1884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AB563ED-4F83-D7F9-D5FB-433644B3BFFF}"/>
              </a:ext>
            </a:extLst>
          </p:cNvPr>
          <p:cNvGrpSpPr/>
          <p:nvPr/>
        </p:nvGrpSpPr>
        <p:grpSpPr>
          <a:xfrm>
            <a:off x="850106" y="615049"/>
            <a:ext cx="5157788" cy="6777407"/>
            <a:chOff x="311150" y="1090537"/>
            <a:chExt cx="5157788" cy="6777407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BF507EF6-2707-0645-3670-E89D665B217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1464599"/>
                </p:ext>
              </p:extLst>
            </p:nvPr>
          </p:nvGraphicFramePr>
          <p:xfrm>
            <a:off x="3776663" y="3429000"/>
            <a:ext cx="1692275" cy="2133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2227439" imgH="2807648" progId="Prism8.Document">
                    <p:embed/>
                  </p:oleObj>
                </mc:Choice>
                <mc:Fallback>
                  <p:oleObj name="Prism 8" r:id="rId2" imgW="2227439" imgH="2807648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127B63FC-99A4-D00F-9516-D00AF5429D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776663" y="3429000"/>
                          <a:ext cx="1692275" cy="2133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BAA8EBDF-3A15-B24B-26A0-D3351EEC20E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0976458"/>
                </p:ext>
              </p:extLst>
            </p:nvPr>
          </p:nvGraphicFramePr>
          <p:xfrm>
            <a:off x="2008188" y="1241425"/>
            <a:ext cx="1803400" cy="2084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2430196" imgH="2807648" progId="Prism8.Document">
                    <p:embed/>
                  </p:oleObj>
                </mc:Choice>
                <mc:Fallback>
                  <p:oleObj name="Prism 8" r:id="rId4" imgW="2430196" imgH="2807648" progId="Prism8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128F1A2C-CA3D-C582-BFB1-54BAFAA1245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08188" y="1241425"/>
                          <a:ext cx="1803400" cy="2084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E59EF8B-DA46-EA41-AB01-4AD3C7A459C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0686431"/>
                </p:ext>
              </p:extLst>
            </p:nvPr>
          </p:nvGraphicFramePr>
          <p:xfrm>
            <a:off x="2270125" y="3436938"/>
            <a:ext cx="1625600" cy="2052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224198" imgH="2807648" progId="Prism8.Document">
                    <p:embed/>
                  </p:oleObj>
                </mc:Choice>
                <mc:Fallback>
                  <p:oleObj name="Prism 8" r:id="rId6" imgW="2224198" imgH="2807648" progId="Prism8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6EC05D97-289B-3C8C-061F-A9D46BD01D5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270125" y="3436938"/>
                          <a:ext cx="1625600" cy="2052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36691A66-6F87-29D8-9FDC-17645E43DE1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1196941"/>
                </p:ext>
              </p:extLst>
            </p:nvPr>
          </p:nvGraphicFramePr>
          <p:xfrm>
            <a:off x="422275" y="1241425"/>
            <a:ext cx="1651000" cy="2084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224198" imgH="2807648" progId="Prism8.Document">
                    <p:embed/>
                  </p:oleObj>
                </mc:Choice>
                <mc:Fallback>
                  <p:oleObj name="Prism 8" r:id="rId8" imgW="2224198" imgH="2807648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C1501C3A-4BEF-A0A8-2AA4-ABECD683713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22275" y="1241425"/>
                          <a:ext cx="1651000" cy="2084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C5A0A7F2-2BE5-59D8-0696-897B258763D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60281754"/>
                </p:ext>
              </p:extLst>
            </p:nvPr>
          </p:nvGraphicFramePr>
          <p:xfrm>
            <a:off x="3762375" y="1248553"/>
            <a:ext cx="1684981" cy="2133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219877" imgH="2807648" progId="Prism8.Document">
                    <p:embed/>
                  </p:oleObj>
                </mc:Choice>
                <mc:Fallback>
                  <p:oleObj name="Prism 8" r:id="rId10" imgW="2219877" imgH="2807648" progId="Prism8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FAC5C849-EE9A-9949-5101-2FBD94788B9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762375" y="1248553"/>
                          <a:ext cx="1684981" cy="2133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2C3C78D5-686E-8A53-842A-416AB3ACF84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85122980"/>
                </p:ext>
              </p:extLst>
            </p:nvPr>
          </p:nvGraphicFramePr>
          <p:xfrm>
            <a:off x="311150" y="3392488"/>
            <a:ext cx="1882775" cy="2205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398144" imgH="2807648" progId="Prism8.Document">
                    <p:embed/>
                  </p:oleObj>
                </mc:Choice>
                <mc:Fallback>
                  <p:oleObj name="Prism 8" r:id="rId12" imgW="2398144" imgH="2807648" progId="Prism8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1CCBD527-70BF-7F1B-7379-D02F63A0CB4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11150" y="3392488"/>
                          <a:ext cx="1882775" cy="2205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0D7D0526-CC28-89C7-20D1-BD48DB9238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61748559"/>
                </p:ext>
              </p:extLst>
            </p:nvPr>
          </p:nvGraphicFramePr>
          <p:xfrm>
            <a:off x="468189" y="5653576"/>
            <a:ext cx="1431826" cy="2192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1841734" imgH="2819889" progId="Prism8.Document">
                    <p:embed/>
                  </p:oleObj>
                </mc:Choice>
                <mc:Fallback>
                  <p:oleObj name="Prism 8" r:id="rId14" imgW="1841734" imgH="2819889" progId="Prism8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80BBD1D9-3EC6-3A29-90BE-F4DA1A18E93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68189" y="5653576"/>
                          <a:ext cx="1431826" cy="2192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8360EE87-DA43-02BD-3EF4-75297BB68DC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2943528"/>
                </p:ext>
              </p:extLst>
            </p:nvPr>
          </p:nvGraphicFramePr>
          <p:xfrm>
            <a:off x="2114754" y="5653576"/>
            <a:ext cx="1590953" cy="22143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2026124" imgH="2819889" progId="Prism8.Document">
                    <p:embed/>
                  </p:oleObj>
                </mc:Choice>
                <mc:Fallback>
                  <p:oleObj name="Prism 8" r:id="rId16" imgW="2026124" imgH="2819889" progId="Prism8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898B49F6-B4FF-E186-9841-F4BD9B5C0A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114754" y="5653576"/>
                          <a:ext cx="1590953" cy="22143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67B7658-868E-F141-413C-CEFBB662A4F2}"/>
                </a:ext>
              </a:extLst>
            </p:cNvPr>
            <p:cNvSpPr txBox="1"/>
            <p:nvPr/>
          </p:nvSpPr>
          <p:spPr>
            <a:xfrm>
              <a:off x="323434" y="1090537"/>
              <a:ext cx="438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F823048-23B6-BFB1-A06A-FCDF3A83C420}"/>
                </a:ext>
              </a:extLst>
            </p:cNvPr>
            <p:cNvSpPr txBox="1"/>
            <p:nvPr/>
          </p:nvSpPr>
          <p:spPr>
            <a:xfrm>
              <a:off x="2110508" y="1099450"/>
              <a:ext cx="438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BC43CD0-1506-3AF8-E083-992114DE7D6F}"/>
                </a:ext>
              </a:extLst>
            </p:cNvPr>
            <p:cNvSpPr txBox="1"/>
            <p:nvPr/>
          </p:nvSpPr>
          <p:spPr>
            <a:xfrm>
              <a:off x="3830916" y="1090538"/>
              <a:ext cx="438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A545D93-5F52-E4B2-277F-9C63C3104B6E}"/>
                </a:ext>
              </a:extLst>
            </p:cNvPr>
            <p:cNvSpPr txBox="1"/>
            <p:nvPr/>
          </p:nvSpPr>
          <p:spPr>
            <a:xfrm>
              <a:off x="323435" y="3249599"/>
              <a:ext cx="415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1F4F20-FF89-3461-3C7D-F155479FC403}"/>
                </a:ext>
              </a:extLst>
            </p:cNvPr>
            <p:cNvSpPr txBox="1"/>
            <p:nvPr/>
          </p:nvSpPr>
          <p:spPr>
            <a:xfrm>
              <a:off x="2325490" y="3264959"/>
              <a:ext cx="415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81B2901-7C76-D0C4-988F-AD42ADAD3344}"/>
                </a:ext>
              </a:extLst>
            </p:cNvPr>
            <p:cNvSpPr txBox="1"/>
            <p:nvPr/>
          </p:nvSpPr>
          <p:spPr>
            <a:xfrm>
              <a:off x="3963039" y="3275482"/>
              <a:ext cx="415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1D4D97B-76A2-DD93-D19C-E9036A0B4B48}"/>
                </a:ext>
              </a:extLst>
            </p:cNvPr>
            <p:cNvSpPr txBox="1"/>
            <p:nvPr/>
          </p:nvSpPr>
          <p:spPr>
            <a:xfrm>
              <a:off x="468189" y="5478425"/>
              <a:ext cx="415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5A3957B-4DF7-74B8-D0AA-CE6B41134DE7}"/>
                </a:ext>
              </a:extLst>
            </p:cNvPr>
            <p:cNvSpPr txBox="1"/>
            <p:nvPr/>
          </p:nvSpPr>
          <p:spPr>
            <a:xfrm>
              <a:off x="1947902" y="5478425"/>
              <a:ext cx="415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DF1003E6-8E85-C821-3E9D-54FFA82CF7F3}"/>
              </a:ext>
            </a:extLst>
          </p:cNvPr>
          <p:cNvSpPr txBox="1"/>
          <p:nvPr/>
        </p:nvSpPr>
        <p:spPr>
          <a:xfrm>
            <a:off x="741837" y="7307662"/>
            <a:ext cx="567589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1: Methionine supplementation improves the antioxidant potential of the host by affecting the elemental profiles in circulation. A, B, C, D, 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the levels of selenium, iron, magnesium, calcium, and zinc in the serum from various mouse groups at 21 dp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to zinc ratio in the serum of mice at 21 dp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oxide dismutase activity in the serum of methionine-supplemented and control mice groups at 21 dpi. One-way ANOVA with multiple comparisons is used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1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001, CT: control, MS: methionine supplemented, MS to CT: Methionine supplemented for 2 weeks, then shifted to control pos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3B08122-A7AD-B734-B466-F82D21FFE079}"/>
              </a:ext>
            </a:extLst>
          </p:cNvPr>
          <p:cNvSpPr txBox="1"/>
          <p:nvPr/>
        </p:nvSpPr>
        <p:spPr>
          <a:xfrm>
            <a:off x="636725" y="377813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1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3A8860C-C4E4-4D4A-8C21-1E3362218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1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9756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A172643-BC50-8C7B-DCD5-5EA915F802CD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2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CD3D30-B1B6-CCE3-10CD-5D26AB9152CD}"/>
              </a:ext>
            </a:extLst>
          </p:cNvPr>
          <p:cNvSpPr txBox="1"/>
          <p:nvPr/>
        </p:nvSpPr>
        <p:spPr>
          <a:xfrm>
            <a:off x="602845" y="5997656"/>
            <a:ext cx="574121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2: Methionine-supplemented mice mounted better inflammation through methylation level control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showing the experimental strategy adopted in the stud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al burden at 2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BMDMs from in-vivo methionine-supplemented mice differentiated in control or MS media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inflammatory cytokine levels in the cell culture media of different groups up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 at 2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PCR of H3K4me3 and H3K36me3 enrichment at the promoter region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Student’s t-test is used to compare expression between CT and MS, One-way ANOVA with Tukey’s multiple comparisons is used, BMDMs: Bone marrow-derived macrophages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um tuberculosis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: control, MS: methionine supplemented, CT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M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ells from CT mice but differentiated in MS media during ex-vivo study, MS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ells from MS mice but differentiated in CT media during the ex-vivo study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&lt;0.01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01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001 at 95% confidence, LOD is limit of detection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FC59797-5BBA-04AD-0D4E-752659C608B9}"/>
              </a:ext>
            </a:extLst>
          </p:cNvPr>
          <p:cNvSpPr txBox="1"/>
          <p:nvPr/>
        </p:nvSpPr>
        <p:spPr>
          <a:xfrm>
            <a:off x="425876" y="6024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168A2AB-BF39-5194-BDE5-F0AA19C8B1CE}"/>
              </a:ext>
            </a:extLst>
          </p:cNvPr>
          <p:cNvSpPr txBox="1"/>
          <p:nvPr/>
        </p:nvSpPr>
        <p:spPr>
          <a:xfrm>
            <a:off x="425875" y="220782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DB92BC-2985-642B-35F5-31FBEE0CE886}"/>
              </a:ext>
            </a:extLst>
          </p:cNvPr>
          <p:cNvSpPr txBox="1"/>
          <p:nvPr/>
        </p:nvSpPr>
        <p:spPr>
          <a:xfrm>
            <a:off x="2512919" y="2193150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BF209B7-5027-9A8F-4CCB-9201953944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9580705"/>
              </p:ext>
            </p:extLst>
          </p:nvPr>
        </p:nvGraphicFramePr>
        <p:xfrm>
          <a:off x="2640878" y="2346324"/>
          <a:ext cx="1959085" cy="1751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02019" imgH="2682074" progId="Prism10.Document">
                  <p:embed/>
                </p:oleObj>
              </mc:Choice>
              <mc:Fallback>
                <p:oleObj name="Prism 10" r:id="rId2" imgW="3002019" imgH="2682074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3033D07-72B5-7B5B-61F7-8E10D85EED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40878" y="2346324"/>
                        <a:ext cx="1959085" cy="1751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DBEC182-E0F8-2F0C-5EB7-79430084BE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7127315"/>
              </p:ext>
            </p:extLst>
          </p:nvPr>
        </p:nvGraphicFramePr>
        <p:xfrm>
          <a:off x="4534861" y="2352765"/>
          <a:ext cx="1897264" cy="1739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924269" imgH="2682074" progId="Prism10.Document">
                  <p:embed/>
                </p:oleObj>
              </mc:Choice>
              <mc:Fallback>
                <p:oleObj name="Prism 10" r:id="rId4" imgW="2924269" imgH="2682074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FBAA5AF-4BCA-C2BE-1A5B-B68C9C52AE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34861" y="2352765"/>
                        <a:ext cx="1897264" cy="1739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A0DE90FD-C403-E16C-08B8-DF5ECEFCD17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13616" y="2415948"/>
            <a:ext cx="1935323" cy="166167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178533F-3752-B8D0-73C8-758FB4C9339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602845" y="768204"/>
            <a:ext cx="5509571" cy="1198819"/>
          </a:xfrm>
          <a:prstGeom prst="rect">
            <a:avLst/>
          </a:prstGeom>
        </p:spPr>
      </p:pic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EE97A853-4C07-715E-F087-586B620510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1315697"/>
              </p:ext>
            </p:extLst>
          </p:nvPr>
        </p:nvGraphicFramePr>
        <p:xfrm>
          <a:off x="711352" y="4266836"/>
          <a:ext cx="2600325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849491" imgH="2449401" progId="Prism8.Document">
                  <p:embed/>
                </p:oleObj>
              </mc:Choice>
              <mc:Fallback>
                <p:oleObj name="Prism 8" r:id="rId8" imgW="3849491" imgH="2449401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EE97A853-4C07-715E-F087-586B620510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11352" y="4266836"/>
                        <a:ext cx="2600325" cy="1655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A6321DB-C005-736F-5967-B6F12B2F00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0833060"/>
              </p:ext>
            </p:extLst>
          </p:nvPr>
        </p:nvGraphicFramePr>
        <p:xfrm>
          <a:off x="4878793" y="4332064"/>
          <a:ext cx="1465262" cy="147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430196" imgH="2447960" progId="Prism8.Document">
                  <p:embed/>
                </p:oleObj>
              </mc:Choice>
              <mc:Fallback>
                <p:oleObj name="Prism 8" r:id="rId10" imgW="2430196" imgH="2447960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A6321DB-C005-736F-5967-B6F12B2F00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878793" y="4332064"/>
                        <a:ext cx="1465262" cy="1476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63EDD08-3554-FD64-3DF2-BC1FA9D29A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1982654"/>
              </p:ext>
            </p:extLst>
          </p:nvPr>
        </p:nvGraphicFramePr>
        <p:xfrm>
          <a:off x="3357630" y="4442518"/>
          <a:ext cx="1429257" cy="14329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443881" imgH="2449401" progId="Prism8.Document">
                  <p:embed/>
                </p:oleObj>
              </mc:Choice>
              <mc:Fallback>
                <p:oleObj name="Prism 8" r:id="rId12" imgW="2443881" imgH="2449401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863EDD08-3554-FD64-3DF2-BC1FA9D29A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57630" y="4442518"/>
                        <a:ext cx="1429257" cy="14329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BFF0AAA-4433-E597-847F-37B4B3E862EB}"/>
              </a:ext>
            </a:extLst>
          </p:cNvPr>
          <p:cNvSpPr txBox="1"/>
          <p:nvPr/>
        </p:nvSpPr>
        <p:spPr>
          <a:xfrm>
            <a:off x="452236" y="4097562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lide Number Placeholder 13">
            <a:extLst>
              <a:ext uri="{FF2B5EF4-FFF2-40B4-BE49-F238E27FC236}">
                <a16:creationId xmlns:a16="http://schemas.microsoft.com/office/drawing/2014/main" id="{815153C8-F74F-8F49-AAD7-D49E6CA51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1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4165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5A09EC4B-CF03-95CF-377D-474CE3FD5239}"/>
              </a:ext>
            </a:extLst>
          </p:cNvPr>
          <p:cNvSpPr txBox="1"/>
          <p:nvPr/>
        </p:nvSpPr>
        <p:spPr>
          <a:xfrm>
            <a:off x="648966" y="467177"/>
            <a:ext cx="3580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2FB17A3-8974-CEF7-416B-1A562E3B8339}"/>
              </a:ext>
            </a:extLst>
          </p:cNvPr>
          <p:cNvSpPr txBox="1"/>
          <p:nvPr/>
        </p:nvSpPr>
        <p:spPr>
          <a:xfrm>
            <a:off x="635379" y="894656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1C45F1C-631E-3E75-A316-D86D11687FE7}"/>
              </a:ext>
            </a:extLst>
          </p:cNvPr>
          <p:cNvSpPr txBox="1"/>
          <p:nvPr/>
        </p:nvSpPr>
        <p:spPr>
          <a:xfrm>
            <a:off x="541575" y="8113292"/>
            <a:ext cx="59626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Alveolar macrophages are unable to undergo infection-induced metabolic switching to glycolysis. A, B, 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 showing differences among the transcriptomics profile of various macrophage clusters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group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canonical markers on the three macrophag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ulati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 signalling network in tuberculosis and the healthy group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glycolysis signature in the three macrophage clusters between tuberculosis and the healthy group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showing the gene expression pattern for glycolysis in non-AMs from the two groups. AMs: alveolar macrophages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um tuberculo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37Rv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ingle-cell RNA sequencing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51AD2BB-D60F-6417-AB56-15BFE93334E3}"/>
              </a:ext>
            </a:extLst>
          </p:cNvPr>
          <p:cNvSpPr txBox="1"/>
          <p:nvPr/>
        </p:nvSpPr>
        <p:spPr>
          <a:xfrm>
            <a:off x="2395269" y="894656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DC7A476-6A49-0A02-6847-182F4B5002B5}"/>
              </a:ext>
            </a:extLst>
          </p:cNvPr>
          <p:cNvSpPr txBox="1"/>
          <p:nvPr/>
        </p:nvSpPr>
        <p:spPr>
          <a:xfrm>
            <a:off x="4317602" y="901503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3496CBD-240C-0480-332F-B9DD0C5E20BF}"/>
              </a:ext>
            </a:extLst>
          </p:cNvPr>
          <p:cNvSpPr txBox="1"/>
          <p:nvPr/>
        </p:nvSpPr>
        <p:spPr>
          <a:xfrm>
            <a:off x="2924167" y="2941512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23E5DA6-3571-C088-157E-213400BC195B}"/>
              </a:ext>
            </a:extLst>
          </p:cNvPr>
          <p:cNvSpPr txBox="1"/>
          <p:nvPr/>
        </p:nvSpPr>
        <p:spPr>
          <a:xfrm>
            <a:off x="2913500" y="5049823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35CF8B-B21A-E111-6558-4BDB03E699F3}"/>
              </a:ext>
            </a:extLst>
          </p:cNvPr>
          <p:cNvSpPr txBox="1"/>
          <p:nvPr/>
        </p:nvSpPr>
        <p:spPr>
          <a:xfrm>
            <a:off x="664686" y="4172561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539016D-252A-2E99-45C9-7A5AD72C1565}"/>
              </a:ext>
            </a:extLst>
          </p:cNvPr>
          <p:cNvGrpSpPr/>
          <p:nvPr/>
        </p:nvGrpSpPr>
        <p:grpSpPr>
          <a:xfrm>
            <a:off x="720014" y="4459487"/>
            <a:ext cx="2312461" cy="3672028"/>
            <a:chOff x="3527569" y="124057"/>
            <a:chExt cx="2969771" cy="4720585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3584685-1224-177F-862D-4CA994492FE1}"/>
                </a:ext>
              </a:extLst>
            </p:cNvPr>
            <p:cNvGrpSpPr/>
            <p:nvPr/>
          </p:nvGrpSpPr>
          <p:grpSpPr>
            <a:xfrm rot="16200000">
              <a:off x="1452699" y="2198927"/>
              <a:ext cx="4720585" cy="570845"/>
              <a:chOff x="470440" y="5222054"/>
              <a:chExt cx="4720585" cy="570845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C66ACDA-BE60-57CA-12E4-CA3D7AF07B41}"/>
                  </a:ext>
                </a:extLst>
              </p:cNvPr>
              <p:cNvSpPr txBox="1"/>
              <p:nvPr/>
            </p:nvSpPr>
            <p:spPr>
              <a:xfrm>
                <a:off x="3670367" y="5507232"/>
                <a:ext cx="1354753" cy="2856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cs typeface="Times New Roman" panose="02020603050405020304" pitchFamily="18" charset="0"/>
                  </a:rPr>
                  <a:t>Tuberculosis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7B47C5F-9790-7BB5-C8A7-D1727A672516}"/>
                  </a:ext>
                </a:extLst>
              </p:cNvPr>
              <p:cNvSpPr txBox="1"/>
              <p:nvPr/>
            </p:nvSpPr>
            <p:spPr>
              <a:xfrm>
                <a:off x="1297009" y="5486625"/>
                <a:ext cx="1088403" cy="285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cs typeface="Times New Roman" panose="02020603050405020304" pitchFamily="18" charset="0"/>
                  </a:rPr>
                  <a:t>Healthy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991D3BB-2553-9577-2FC6-484693D219A8}"/>
                  </a:ext>
                </a:extLst>
              </p:cNvPr>
              <p:cNvSpPr txBox="1"/>
              <p:nvPr/>
            </p:nvSpPr>
            <p:spPr>
              <a:xfrm>
                <a:off x="1912699" y="5222054"/>
                <a:ext cx="3278326" cy="3162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cs typeface="Times New Roman" panose="02020603050405020304" pitchFamily="18" charset="0"/>
                  </a:rPr>
                  <a:t>IL1 signaling network 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DE36B5E7-E709-11C6-5FD6-0C3B39525566}"/>
                  </a:ext>
                </a:extLst>
              </p:cNvPr>
              <p:cNvSpPr/>
              <p:nvPr/>
            </p:nvSpPr>
            <p:spPr>
              <a:xfrm rot="5400000">
                <a:off x="2645357" y="3080304"/>
                <a:ext cx="259837" cy="460967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F1D542FC-79D0-557E-E3BA-1D2336A7EBC4}"/>
                </a:ext>
              </a:extLst>
            </p:cNvPr>
            <p:cNvGrpSpPr/>
            <p:nvPr/>
          </p:nvGrpSpPr>
          <p:grpSpPr>
            <a:xfrm>
              <a:off x="4164836" y="140334"/>
              <a:ext cx="2332504" cy="4704307"/>
              <a:chOff x="3587061" y="2130539"/>
              <a:chExt cx="2332504" cy="4704307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92C88E16-B1AF-734F-4C39-830B35D145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90993" y="4548689"/>
                <a:ext cx="2328572" cy="2286157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5B7C0C5D-6622-C987-F4DD-07BED1F76C8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87061" y="2130539"/>
                <a:ext cx="2193712" cy="2267244"/>
              </a:xfrm>
              <a:prstGeom prst="rect">
                <a:avLst/>
              </a:prstGeom>
            </p:spPr>
          </p:pic>
        </p:grp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5A385552-B230-B604-4166-096A2EED976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72615" y="5312109"/>
            <a:ext cx="3598783" cy="189222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7E5C4C4-B2DD-1F0A-79DB-3BED9337C49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39607" y="3347413"/>
            <a:ext cx="1109517" cy="149708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CDC2DC6-8EA5-FF81-C663-A2248094601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55471" y="3359089"/>
            <a:ext cx="1109517" cy="149708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FC558F0-A1F0-FCC7-D477-4CC83E35460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95959" y="3359089"/>
            <a:ext cx="1109516" cy="1497088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F62BDC59-F310-7784-8220-C0BBD45CA973}"/>
              </a:ext>
            </a:extLst>
          </p:cNvPr>
          <p:cNvGrpSpPr/>
          <p:nvPr/>
        </p:nvGrpSpPr>
        <p:grpSpPr>
          <a:xfrm>
            <a:off x="673135" y="1127647"/>
            <a:ext cx="1796157" cy="1724840"/>
            <a:chOff x="673135" y="1127647"/>
            <a:chExt cx="1796157" cy="172484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9607D351-EAC1-34CA-4CAE-05C0E2E1D8F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673135" y="1127647"/>
              <a:ext cx="1796157" cy="172484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B054720-3501-3900-B2C3-D9A90E4BFC27}"/>
                </a:ext>
              </a:extLst>
            </p:cNvPr>
            <p:cNvSpPr txBox="1"/>
            <p:nvPr/>
          </p:nvSpPr>
          <p:spPr>
            <a:xfrm>
              <a:off x="824085" y="1263329"/>
              <a:ext cx="590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solidFill>
                    <a:srgbClr val="F17BE6"/>
                  </a:solidFill>
                </a:rPr>
                <a:t>505</a:t>
              </a:r>
              <a:r>
                <a:rPr lang="en-US" sz="400" dirty="0"/>
                <a:t>/</a:t>
              </a:r>
              <a:r>
                <a:rPr lang="en-US" sz="400" dirty="0">
                  <a:solidFill>
                    <a:schemeClr val="accent1">
                      <a:lumMod val="75000"/>
                    </a:schemeClr>
                  </a:solidFill>
                </a:rPr>
                <a:t>504</a:t>
              </a:r>
            </a:p>
            <a:p>
              <a:r>
                <a:rPr lang="en-US" sz="400" dirty="0"/>
                <a:t>Total: 7602</a:t>
              </a:r>
              <a:endParaRPr lang="en-IN" sz="400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B3DF4143-69D2-740A-22A0-F936B3064FAE}"/>
              </a:ext>
            </a:extLst>
          </p:cNvPr>
          <p:cNvGrpSpPr/>
          <p:nvPr/>
        </p:nvGrpSpPr>
        <p:grpSpPr>
          <a:xfrm>
            <a:off x="2516540" y="1118978"/>
            <a:ext cx="1801062" cy="1733509"/>
            <a:chOff x="2516540" y="1118978"/>
            <a:chExt cx="1801062" cy="1733509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2CAF488-1CDB-01A1-AF75-B44FF5FAFD4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2516540" y="1118978"/>
              <a:ext cx="1801062" cy="1733509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FBE28B8-853B-86F1-F9FB-D1F5121F6F61}"/>
                </a:ext>
              </a:extLst>
            </p:cNvPr>
            <p:cNvSpPr txBox="1"/>
            <p:nvPr/>
          </p:nvSpPr>
          <p:spPr>
            <a:xfrm>
              <a:off x="2654384" y="1263329"/>
              <a:ext cx="590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solidFill>
                    <a:srgbClr val="F17BE6"/>
                  </a:solidFill>
                </a:rPr>
                <a:t>624</a:t>
              </a:r>
              <a:r>
                <a:rPr lang="en-US" sz="400" dirty="0"/>
                <a:t>/</a:t>
              </a:r>
              <a:r>
                <a:rPr lang="en-US" sz="400" dirty="0">
                  <a:solidFill>
                    <a:schemeClr val="accent1">
                      <a:lumMod val="75000"/>
                    </a:schemeClr>
                  </a:solidFill>
                </a:rPr>
                <a:t>627</a:t>
              </a:r>
            </a:p>
            <a:p>
              <a:r>
                <a:rPr lang="en-US" sz="400" dirty="0"/>
                <a:t>Total: 8812</a:t>
              </a:r>
              <a:endParaRPr lang="en-IN" sz="400" dirty="0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98C90B7-D20A-6395-76A6-B900FCB9586C}"/>
              </a:ext>
            </a:extLst>
          </p:cNvPr>
          <p:cNvGrpSpPr/>
          <p:nvPr/>
        </p:nvGrpSpPr>
        <p:grpSpPr>
          <a:xfrm>
            <a:off x="4440346" y="1116821"/>
            <a:ext cx="1782276" cy="1733510"/>
            <a:chOff x="4440346" y="1116821"/>
            <a:chExt cx="1782276" cy="173351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F4D590B-3937-5B24-AC74-5A4BBA84FD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4440346" y="1116821"/>
              <a:ext cx="1782276" cy="173351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6BB2507-BFEF-7498-A7E3-28DA817A94AD}"/>
                </a:ext>
              </a:extLst>
            </p:cNvPr>
            <p:cNvSpPr txBox="1"/>
            <p:nvPr/>
          </p:nvSpPr>
          <p:spPr>
            <a:xfrm>
              <a:off x="4607009" y="1263329"/>
              <a:ext cx="590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solidFill>
                    <a:srgbClr val="F17BE6"/>
                  </a:solidFill>
                </a:rPr>
                <a:t>654</a:t>
              </a:r>
              <a:r>
                <a:rPr lang="en-US" sz="400" dirty="0"/>
                <a:t>/</a:t>
              </a:r>
              <a:r>
                <a:rPr lang="en-US" sz="400" dirty="0">
                  <a:solidFill>
                    <a:schemeClr val="accent1">
                      <a:lumMod val="75000"/>
                    </a:schemeClr>
                  </a:solidFill>
                </a:rPr>
                <a:t>807</a:t>
              </a:r>
            </a:p>
            <a:p>
              <a:r>
                <a:rPr lang="en-US" sz="400" dirty="0"/>
                <a:t>Total: 8973</a:t>
              </a:r>
              <a:endParaRPr lang="en-IN" sz="400" dirty="0"/>
            </a:p>
          </p:txBody>
        </p:sp>
      </p:grp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3003332-55FB-CC4E-A014-1390DD04C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2</a:t>
            </a:fld>
            <a:endParaRPr lang="en-IN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1B89E20-FDB9-116E-8DD8-8B4C4A2DBED9}"/>
              </a:ext>
            </a:extLst>
          </p:cNvPr>
          <p:cNvGrpSpPr/>
          <p:nvPr/>
        </p:nvGrpSpPr>
        <p:grpSpPr>
          <a:xfrm>
            <a:off x="763518" y="3120048"/>
            <a:ext cx="2012058" cy="944586"/>
            <a:chOff x="0" y="6208808"/>
            <a:chExt cx="3502580" cy="145867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C944A37-58A5-BD5A-B50E-EC02EF5890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0" y="6353472"/>
              <a:ext cx="3428999" cy="1314013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EBF88F2-64EE-92FE-28D4-0F4BED51266A}"/>
                </a:ext>
              </a:extLst>
            </p:cNvPr>
            <p:cNvSpPr txBox="1"/>
            <p:nvPr/>
          </p:nvSpPr>
          <p:spPr>
            <a:xfrm>
              <a:off x="2652242" y="6208808"/>
              <a:ext cx="850338" cy="1871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Percent Expressed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6B83682D-9A8B-9666-7F74-04ED194DAFE6}"/>
              </a:ext>
            </a:extLst>
          </p:cNvPr>
          <p:cNvSpPr txBox="1"/>
          <p:nvPr/>
        </p:nvSpPr>
        <p:spPr>
          <a:xfrm>
            <a:off x="648966" y="2972683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7919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1A66DA-BAD2-7083-B98D-846651D78A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5BC5119D-CDB2-2653-8D41-1B664DDF45EB}"/>
              </a:ext>
            </a:extLst>
          </p:cNvPr>
          <p:cNvSpPr txBox="1"/>
          <p:nvPr/>
        </p:nvSpPr>
        <p:spPr>
          <a:xfrm>
            <a:off x="486902" y="450154"/>
            <a:ext cx="3580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5B9AF17-8CCB-052B-6BB2-6CC37E272F5F}"/>
              </a:ext>
            </a:extLst>
          </p:cNvPr>
          <p:cNvGrpSpPr/>
          <p:nvPr/>
        </p:nvGrpSpPr>
        <p:grpSpPr>
          <a:xfrm>
            <a:off x="4550518" y="1447950"/>
            <a:ext cx="1725030" cy="1541693"/>
            <a:chOff x="5972183" y="419099"/>
            <a:chExt cx="5346953" cy="3634074"/>
          </a:xfrm>
        </p:grpSpPr>
        <p:sp>
          <p:nvSpPr>
            <p:cNvPr id="5" name="Flowchart: Manual Operation 27">
              <a:extLst>
                <a:ext uri="{FF2B5EF4-FFF2-40B4-BE49-F238E27FC236}">
                  <a16:creationId xmlns:a16="http://schemas.microsoft.com/office/drawing/2014/main" id="{E0C02E56-BCB6-FE29-F77E-C2D66A347B1F}"/>
                </a:ext>
              </a:extLst>
            </p:cNvPr>
            <p:cNvSpPr/>
            <p:nvPr/>
          </p:nvSpPr>
          <p:spPr>
            <a:xfrm>
              <a:off x="5972183" y="419099"/>
              <a:ext cx="5346953" cy="757845"/>
            </a:xfrm>
            <a:custGeom>
              <a:avLst/>
              <a:gdLst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2000 w 10000"/>
                <a:gd name="connsiteY3" fmla="*/ 10000 h 10000"/>
                <a:gd name="connsiteX4" fmla="*/ 0 w 10000"/>
                <a:gd name="connsiteY4" fmla="*/ 0 h 10000"/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353 w 10000"/>
                <a:gd name="connsiteY3" fmla="*/ 1769 h 10000"/>
                <a:gd name="connsiteX4" fmla="*/ 0 w 10000"/>
                <a:gd name="connsiteY4" fmla="*/ 0 h 10000"/>
                <a:gd name="connsiteX0" fmla="*/ 0 w 10000"/>
                <a:gd name="connsiteY0" fmla="*/ 0 h 1922"/>
                <a:gd name="connsiteX1" fmla="*/ 10000 w 10000"/>
                <a:gd name="connsiteY1" fmla="*/ 0 h 1922"/>
                <a:gd name="connsiteX2" fmla="*/ 9604 w 10000"/>
                <a:gd name="connsiteY2" fmla="*/ 1922 h 1922"/>
                <a:gd name="connsiteX3" fmla="*/ 353 w 10000"/>
                <a:gd name="connsiteY3" fmla="*/ 1769 h 1922"/>
                <a:gd name="connsiteX4" fmla="*/ 0 w 10000"/>
                <a:gd name="connsiteY4" fmla="*/ 0 h 1922"/>
                <a:gd name="connsiteX0" fmla="*/ 0 w 10000"/>
                <a:gd name="connsiteY0" fmla="*/ 0 h 9657"/>
                <a:gd name="connsiteX1" fmla="*/ 10000 w 10000"/>
                <a:gd name="connsiteY1" fmla="*/ 0 h 9657"/>
                <a:gd name="connsiteX2" fmla="*/ 9691 w 10000"/>
                <a:gd name="connsiteY2" fmla="*/ 9657 h 9657"/>
                <a:gd name="connsiteX3" fmla="*/ 353 w 10000"/>
                <a:gd name="connsiteY3" fmla="*/ 9204 h 9657"/>
                <a:gd name="connsiteX4" fmla="*/ 0 w 10000"/>
                <a:gd name="connsiteY4" fmla="*/ 0 h 96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000" h="9657">
                  <a:moveTo>
                    <a:pt x="0" y="0"/>
                  </a:moveTo>
                  <a:lnTo>
                    <a:pt x="10000" y="0"/>
                  </a:lnTo>
                  <a:lnTo>
                    <a:pt x="9691" y="9657"/>
                  </a:lnTo>
                  <a:lnTo>
                    <a:pt x="353" y="9204"/>
                  </a:lnTo>
                  <a:cubicBezTo>
                    <a:pt x="235" y="6134"/>
                    <a:pt x="118" y="3070"/>
                    <a:pt x="0" y="0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19050"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molecular features  (1468)</a:t>
              </a:r>
              <a:endParaRPr lang="en-I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Flowchart: Manual Operation 27">
              <a:extLst>
                <a:ext uri="{FF2B5EF4-FFF2-40B4-BE49-F238E27FC236}">
                  <a16:creationId xmlns:a16="http://schemas.microsoft.com/office/drawing/2014/main" id="{D7D23E73-DAA3-9F21-E7F2-27F4AA016242}"/>
                </a:ext>
              </a:extLst>
            </p:cNvPr>
            <p:cNvSpPr/>
            <p:nvPr/>
          </p:nvSpPr>
          <p:spPr>
            <a:xfrm>
              <a:off x="6151131" y="1265900"/>
              <a:ext cx="5020971" cy="918955"/>
            </a:xfrm>
            <a:custGeom>
              <a:avLst/>
              <a:gdLst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2000 w 10000"/>
                <a:gd name="connsiteY3" fmla="*/ 10000 h 10000"/>
                <a:gd name="connsiteX4" fmla="*/ 0 w 10000"/>
                <a:gd name="connsiteY4" fmla="*/ 0 h 10000"/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353 w 10000"/>
                <a:gd name="connsiteY3" fmla="*/ 1769 h 10000"/>
                <a:gd name="connsiteX4" fmla="*/ 0 w 10000"/>
                <a:gd name="connsiteY4" fmla="*/ 0 h 10000"/>
                <a:gd name="connsiteX0" fmla="*/ 0 w 10000"/>
                <a:gd name="connsiteY0" fmla="*/ 0 h 1922"/>
                <a:gd name="connsiteX1" fmla="*/ 10000 w 10000"/>
                <a:gd name="connsiteY1" fmla="*/ 0 h 1922"/>
                <a:gd name="connsiteX2" fmla="*/ 9604 w 10000"/>
                <a:gd name="connsiteY2" fmla="*/ 1922 h 1922"/>
                <a:gd name="connsiteX3" fmla="*/ 353 w 10000"/>
                <a:gd name="connsiteY3" fmla="*/ 1769 h 1922"/>
                <a:gd name="connsiteX4" fmla="*/ 0 w 10000"/>
                <a:gd name="connsiteY4" fmla="*/ 0 h 1922"/>
                <a:gd name="connsiteX0" fmla="*/ 0 w 10000"/>
                <a:gd name="connsiteY0" fmla="*/ 0 h 9657"/>
                <a:gd name="connsiteX1" fmla="*/ 10000 w 10000"/>
                <a:gd name="connsiteY1" fmla="*/ 0 h 9657"/>
                <a:gd name="connsiteX2" fmla="*/ 9691 w 10000"/>
                <a:gd name="connsiteY2" fmla="*/ 9657 h 9657"/>
                <a:gd name="connsiteX3" fmla="*/ 353 w 10000"/>
                <a:gd name="connsiteY3" fmla="*/ 9204 h 9657"/>
                <a:gd name="connsiteX4" fmla="*/ 0 w 10000"/>
                <a:gd name="connsiteY4" fmla="*/ 0 h 9657"/>
                <a:gd name="connsiteX0" fmla="*/ 0 w 10000"/>
                <a:gd name="connsiteY0" fmla="*/ 0 h 10237"/>
                <a:gd name="connsiteX1" fmla="*/ 10000 w 10000"/>
                <a:gd name="connsiteY1" fmla="*/ 0 h 10237"/>
                <a:gd name="connsiteX2" fmla="*/ 8673 w 10000"/>
                <a:gd name="connsiteY2" fmla="*/ 10237 h 10237"/>
                <a:gd name="connsiteX3" fmla="*/ 353 w 10000"/>
                <a:gd name="connsiteY3" fmla="*/ 9531 h 10237"/>
                <a:gd name="connsiteX4" fmla="*/ 0 w 10000"/>
                <a:gd name="connsiteY4" fmla="*/ 0 h 10237"/>
                <a:gd name="connsiteX0" fmla="*/ 0 w 9112"/>
                <a:gd name="connsiteY0" fmla="*/ 0 h 10237"/>
                <a:gd name="connsiteX1" fmla="*/ 9112 w 9112"/>
                <a:gd name="connsiteY1" fmla="*/ 591 h 10237"/>
                <a:gd name="connsiteX2" fmla="*/ 8673 w 9112"/>
                <a:gd name="connsiteY2" fmla="*/ 10237 h 10237"/>
                <a:gd name="connsiteX3" fmla="*/ 353 w 9112"/>
                <a:gd name="connsiteY3" fmla="*/ 9531 h 10237"/>
                <a:gd name="connsiteX4" fmla="*/ 0 w 9112"/>
                <a:gd name="connsiteY4" fmla="*/ 0 h 10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112" h="10237">
                  <a:moveTo>
                    <a:pt x="0" y="0"/>
                  </a:moveTo>
                  <a:lnTo>
                    <a:pt x="9112" y="591"/>
                  </a:lnTo>
                  <a:cubicBezTo>
                    <a:pt x="8966" y="3806"/>
                    <a:pt x="8819" y="7022"/>
                    <a:pt x="8673" y="10237"/>
                  </a:cubicBezTo>
                  <a:lnTo>
                    <a:pt x="353" y="9531"/>
                  </a:lnTo>
                  <a:cubicBezTo>
                    <a:pt x="235" y="6352"/>
                    <a:pt x="118" y="3179"/>
                    <a:pt x="0" y="0"/>
                  </a:cubicBezTo>
                  <a:close/>
                </a:path>
              </a:pathLst>
            </a:custGeom>
            <a:solidFill>
              <a:schemeClr val="accent5">
                <a:lumMod val="40000"/>
                <a:lumOff val="60000"/>
              </a:schemeClr>
            </a:solidFill>
            <a:ln w="19050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d unannotated </a:t>
              </a:r>
            </a:p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520) </a:t>
              </a:r>
              <a:endParaRPr lang="en-I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Flowchart: Manual Operation 27">
              <a:extLst>
                <a:ext uri="{FF2B5EF4-FFF2-40B4-BE49-F238E27FC236}">
                  <a16:creationId xmlns:a16="http://schemas.microsoft.com/office/drawing/2014/main" id="{38D5860B-06CB-841A-DF57-FE57F43C3275}"/>
                </a:ext>
              </a:extLst>
            </p:cNvPr>
            <p:cNvSpPr/>
            <p:nvPr/>
          </p:nvSpPr>
          <p:spPr>
            <a:xfrm>
              <a:off x="6458803" y="2274576"/>
              <a:ext cx="4442792" cy="832571"/>
            </a:xfrm>
            <a:custGeom>
              <a:avLst/>
              <a:gdLst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2000 w 10000"/>
                <a:gd name="connsiteY3" fmla="*/ 10000 h 10000"/>
                <a:gd name="connsiteX4" fmla="*/ 0 w 10000"/>
                <a:gd name="connsiteY4" fmla="*/ 0 h 10000"/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353 w 10000"/>
                <a:gd name="connsiteY3" fmla="*/ 1769 h 10000"/>
                <a:gd name="connsiteX4" fmla="*/ 0 w 10000"/>
                <a:gd name="connsiteY4" fmla="*/ 0 h 10000"/>
                <a:gd name="connsiteX0" fmla="*/ 0 w 10000"/>
                <a:gd name="connsiteY0" fmla="*/ 0 h 1922"/>
                <a:gd name="connsiteX1" fmla="*/ 10000 w 10000"/>
                <a:gd name="connsiteY1" fmla="*/ 0 h 1922"/>
                <a:gd name="connsiteX2" fmla="*/ 9604 w 10000"/>
                <a:gd name="connsiteY2" fmla="*/ 1922 h 1922"/>
                <a:gd name="connsiteX3" fmla="*/ 353 w 10000"/>
                <a:gd name="connsiteY3" fmla="*/ 1769 h 1922"/>
                <a:gd name="connsiteX4" fmla="*/ 0 w 10000"/>
                <a:gd name="connsiteY4" fmla="*/ 0 h 1922"/>
                <a:gd name="connsiteX0" fmla="*/ 0 w 10000"/>
                <a:gd name="connsiteY0" fmla="*/ 0 h 9657"/>
                <a:gd name="connsiteX1" fmla="*/ 10000 w 10000"/>
                <a:gd name="connsiteY1" fmla="*/ 0 h 9657"/>
                <a:gd name="connsiteX2" fmla="*/ 9691 w 10000"/>
                <a:gd name="connsiteY2" fmla="*/ 9657 h 9657"/>
                <a:gd name="connsiteX3" fmla="*/ 353 w 10000"/>
                <a:gd name="connsiteY3" fmla="*/ 9204 h 9657"/>
                <a:gd name="connsiteX4" fmla="*/ 0 w 10000"/>
                <a:gd name="connsiteY4" fmla="*/ 0 h 9657"/>
                <a:gd name="connsiteX0" fmla="*/ 0 w 10000"/>
                <a:gd name="connsiteY0" fmla="*/ 0 h 10237"/>
                <a:gd name="connsiteX1" fmla="*/ 10000 w 10000"/>
                <a:gd name="connsiteY1" fmla="*/ 0 h 10237"/>
                <a:gd name="connsiteX2" fmla="*/ 8673 w 10000"/>
                <a:gd name="connsiteY2" fmla="*/ 10237 h 10237"/>
                <a:gd name="connsiteX3" fmla="*/ 353 w 10000"/>
                <a:gd name="connsiteY3" fmla="*/ 9531 h 10237"/>
                <a:gd name="connsiteX4" fmla="*/ 0 w 10000"/>
                <a:gd name="connsiteY4" fmla="*/ 0 h 10237"/>
                <a:gd name="connsiteX0" fmla="*/ 0 w 9112"/>
                <a:gd name="connsiteY0" fmla="*/ 0 h 10237"/>
                <a:gd name="connsiteX1" fmla="*/ 9112 w 9112"/>
                <a:gd name="connsiteY1" fmla="*/ 591 h 10237"/>
                <a:gd name="connsiteX2" fmla="*/ 8673 w 9112"/>
                <a:gd name="connsiteY2" fmla="*/ 10237 h 10237"/>
                <a:gd name="connsiteX3" fmla="*/ 353 w 9112"/>
                <a:gd name="connsiteY3" fmla="*/ 9531 h 10237"/>
                <a:gd name="connsiteX4" fmla="*/ 0 w 9112"/>
                <a:gd name="connsiteY4" fmla="*/ 0 h 10237"/>
                <a:gd name="connsiteX0" fmla="*/ 0 w 9540"/>
                <a:gd name="connsiteY0" fmla="*/ 0 h 10000"/>
                <a:gd name="connsiteX1" fmla="*/ 9096 w 9540"/>
                <a:gd name="connsiteY1" fmla="*/ 461 h 10000"/>
                <a:gd name="connsiteX2" fmla="*/ 9518 w 9540"/>
                <a:gd name="connsiteY2" fmla="*/ 10000 h 10000"/>
                <a:gd name="connsiteX3" fmla="*/ 387 w 9540"/>
                <a:gd name="connsiteY3" fmla="*/ 9310 h 10000"/>
                <a:gd name="connsiteX4" fmla="*/ 0 w 9540"/>
                <a:gd name="connsiteY4" fmla="*/ 0 h 10000"/>
                <a:gd name="connsiteX0" fmla="*/ 0 w 9535"/>
                <a:gd name="connsiteY0" fmla="*/ 0 h 9769"/>
                <a:gd name="connsiteX1" fmla="*/ 9535 w 9535"/>
                <a:gd name="connsiteY1" fmla="*/ 461 h 9769"/>
                <a:gd name="connsiteX2" fmla="*/ 9080 w 9535"/>
                <a:gd name="connsiteY2" fmla="*/ 9769 h 9769"/>
                <a:gd name="connsiteX3" fmla="*/ 406 w 9535"/>
                <a:gd name="connsiteY3" fmla="*/ 9310 h 9769"/>
                <a:gd name="connsiteX4" fmla="*/ 0 w 9535"/>
                <a:gd name="connsiteY4" fmla="*/ 0 h 97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535" h="9769">
                  <a:moveTo>
                    <a:pt x="0" y="0"/>
                  </a:moveTo>
                  <a:lnTo>
                    <a:pt x="9535" y="461"/>
                  </a:lnTo>
                  <a:cubicBezTo>
                    <a:pt x="9367" y="3602"/>
                    <a:pt x="9248" y="6628"/>
                    <a:pt x="9080" y="9769"/>
                  </a:cubicBezTo>
                  <a:lnTo>
                    <a:pt x="406" y="9310"/>
                  </a:lnTo>
                  <a:cubicBezTo>
                    <a:pt x="270" y="6205"/>
                    <a:pt x="135" y="3105"/>
                    <a:pt x="0" y="0"/>
                  </a:cubicBezTo>
                  <a:close/>
                </a:path>
              </a:pathLst>
            </a:custGeom>
            <a:solidFill>
              <a:schemeClr val="tx2">
                <a:lumMod val="40000"/>
                <a:lumOff val="60000"/>
              </a:schemeClr>
            </a:solidFill>
            <a:ln w="19050">
              <a:solidFill>
                <a:schemeClr val="tx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d duplicates (379)</a:t>
              </a:r>
              <a:endParaRPr lang="en-I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Flowchart: Manual Operation 27">
              <a:extLst>
                <a:ext uri="{FF2B5EF4-FFF2-40B4-BE49-F238E27FC236}">
                  <a16:creationId xmlns:a16="http://schemas.microsoft.com/office/drawing/2014/main" id="{3525E84D-5F35-8E3F-240A-786B39E0D123}"/>
                </a:ext>
              </a:extLst>
            </p:cNvPr>
            <p:cNvSpPr/>
            <p:nvPr/>
          </p:nvSpPr>
          <p:spPr>
            <a:xfrm>
              <a:off x="6696323" y="3197340"/>
              <a:ext cx="3975290" cy="855833"/>
            </a:xfrm>
            <a:custGeom>
              <a:avLst/>
              <a:gdLst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2000 w 10000"/>
                <a:gd name="connsiteY3" fmla="*/ 10000 h 10000"/>
                <a:gd name="connsiteX4" fmla="*/ 0 w 10000"/>
                <a:gd name="connsiteY4" fmla="*/ 0 h 10000"/>
                <a:gd name="connsiteX0" fmla="*/ 0 w 10000"/>
                <a:gd name="connsiteY0" fmla="*/ 0 h 10000"/>
                <a:gd name="connsiteX1" fmla="*/ 10000 w 10000"/>
                <a:gd name="connsiteY1" fmla="*/ 0 h 10000"/>
                <a:gd name="connsiteX2" fmla="*/ 8000 w 10000"/>
                <a:gd name="connsiteY2" fmla="*/ 10000 h 10000"/>
                <a:gd name="connsiteX3" fmla="*/ 353 w 10000"/>
                <a:gd name="connsiteY3" fmla="*/ 1769 h 10000"/>
                <a:gd name="connsiteX4" fmla="*/ 0 w 10000"/>
                <a:gd name="connsiteY4" fmla="*/ 0 h 10000"/>
                <a:gd name="connsiteX0" fmla="*/ 0 w 10000"/>
                <a:gd name="connsiteY0" fmla="*/ 0 h 1922"/>
                <a:gd name="connsiteX1" fmla="*/ 10000 w 10000"/>
                <a:gd name="connsiteY1" fmla="*/ 0 h 1922"/>
                <a:gd name="connsiteX2" fmla="*/ 9604 w 10000"/>
                <a:gd name="connsiteY2" fmla="*/ 1922 h 1922"/>
                <a:gd name="connsiteX3" fmla="*/ 353 w 10000"/>
                <a:gd name="connsiteY3" fmla="*/ 1769 h 1922"/>
                <a:gd name="connsiteX4" fmla="*/ 0 w 10000"/>
                <a:gd name="connsiteY4" fmla="*/ 0 h 1922"/>
                <a:gd name="connsiteX0" fmla="*/ 0 w 10000"/>
                <a:gd name="connsiteY0" fmla="*/ 0 h 9657"/>
                <a:gd name="connsiteX1" fmla="*/ 10000 w 10000"/>
                <a:gd name="connsiteY1" fmla="*/ 0 h 9657"/>
                <a:gd name="connsiteX2" fmla="*/ 9691 w 10000"/>
                <a:gd name="connsiteY2" fmla="*/ 9657 h 9657"/>
                <a:gd name="connsiteX3" fmla="*/ 353 w 10000"/>
                <a:gd name="connsiteY3" fmla="*/ 9204 h 9657"/>
                <a:gd name="connsiteX4" fmla="*/ 0 w 10000"/>
                <a:gd name="connsiteY4" fmla="*/ 0 h 9657"/>
                <a:gd name="connsiteX0" fmla="*/ 0 w 10000"/>
                <a:gd name="connsiteY0" fmla="*/ 0 h 10237"/>
                <a:gd name="connsiteX1" fmla="*/ 10000 w 10000"/>
                <a:gd name="connsiteY1" fmla="*/ 0 h 10237"/>
                <a:gd name="connsiteX2" fmla="*/ 8673 w 10000"/>
                <a:gd name="connsiteY2" fmla="*/ 10237 h 10237"/>
                <a:gd name="connsiteX3" fmla="*/ 353 w 10000"/>
                <a:gd name="connsiteY3" fmla="*/ 9531 h 10237"/>
                <a:gd name="connsiteX4" fmla="*/ 0 w 10000"/>
                <a:gd name="connsiteY4" fmla="*/ 0 h 10237"/>
                <a:gd name="connsiteX0" fmla="*/ 0 w 9112"/>
                <a:gd name="connsiteY0" fmla="*/ 0 h 10237"/>
                <a:gd name="connsiteX1" fmla="*/ 9112 w 9112"/>
                <a:gd name="connsiteY1" fmla="*/ 591 h 10237"/>
                <a:gd name="connsiteX2" fmla="*/ 8673 w 9112"/>
                <a:gd name="connsiteY2" fmla="*/ 10237 h 10237"/>
                <a:gd name="connsiteX3" fmla="*/ 353 w 9112"/>
                <a:gd name="connsiteY3" fmla="*/ 9531 h 10237"/>
                <a:gd name="connsiteX4" fmla="*/ 0 w 9112"/>
                <a:gd name="connsiteY4" fmla="*/ 0 h 10237"/>
                <a:gd name="connsiteX0" fmla="*/ 0 w 9540"/>
                <a:gd name="connsiteY0" fmla="*/ 0 h 10000"/>
                <a:gd name="connsiteX1" fmla="*/ 9096 w 9540"/>
                <a:gd name="connsiteY1" fmla="*/ 461 h 10000"/>
                <a:gd name="connsiteX2" fmla="*/ 9518 w 9540"/>
                <a:gd name="connsiteY2" fmla="*/ 10000 h 10000"/>
                <a:gd name="connsiteX3" fmla="*/ 387 w 9540"/>
                <a:gd name="connsiteY3" fmla="*/ 9310 h 10000"/>
                <a:gd name="connsiteX4" fmla="*/ 0 w 9540"/>
                <a:gd name="connsiteY4" fmla="*/ 0 h 10000"/>
                <a:gd name="connsiteX0" fmla="*/ 0 w 9535"/>
                <a:gd name="connsiteY0" fmla="*/ 0 h 9769"/>
                <a:gd name="connsiteX1" fmla="*/ 9535 w 9535"/>
                <a:gd name="connsiteY1" fmla="*/ 461 h 9769"/>
                <a:gd name="connsiteX2" fmla="*/ 9080 w 9535"/>
                <a:gd name="connsiteY2" fmla="*/ 9769 h 9769"/>
                <a:gd name="connsiteX3" fmla="*/ 406 w 9535"/>
                <a:gd name="connsiteY3" fmla="*/ 9310 h 9769"/>
                <a:gd name="connsiteX4" fmla="*/ 0 w 9535"/>
                <a:gd name="connsiteY4" fmla="*/ 0 h 9769"/>
                <a:gd name="connsiteX0" fmla="*/ 0 w 9545"/>
                <a:gd name="connsiteY0" fmla="*/ 0 h 10000"/>
                <a:gd name="connsiteX1" fmla="*/ 8954 w 9545"/>
                <a:gd name="connsiteY1" fmla="*/ 472 h 10000"/>
                <a:gd name="connsiteX2" fmla="*/ 9523 w 9545"/>
                <a:gd name="connsiteY2" fmla="*/ 10000 h 10000"/>
                <a:gd name="connsiteX3" fmla="*/ 426 w 9545"/>
                <a:gd name="connsiteY3" fmla="*/ 9530 h 10000"/>
                <a:gd name="connsiteX4" fmla="*/ 0 w 9545"/>
                <a:gd name="connsiteY4" fmla="*/ 0 h 10000"/>
                <a:gd name="connsiteX0" fmla="*/ 0 w 9381"/>
                <a:gd name="connsiteY0" fmla="*/ 0 h 10118"/>
                <a:gd name="connsiteX1" fmla="*/ 9381 w 9381"/>
                <a:gd name="connsiteY1" fmla="*/ 472 h 10118"/>
                <a:gd name="connsiteX2" fmla="*/ 8854 w 9381"/>
                <a:gd name="connsiteY2" fmla="*/ 10118 h 10118"/>
                <a:gd name="connsiteX3" fmla="*/ 446 w 9381"/>
                <a:gd name="connsiteY3" fmla="*/ 9530 h 10118"/>
                <a:gd name="connsiteX4" fmla="*/ 0 w 9381"/>
                <a:gd name="connsiteY4" fmla="*/ 0 h 101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381" h="10118">
                  <a:moveTo>
                    <a:pt x="0" y="0"/>
                  </a:moveTo>
                  <a:lnTo>
                    <a:pt x="9381" y="472"/>
                  </a:lnTo>
                  <a:cubicBezTo>
                    <a:pt x="9196" y="3687"/>
                    <a:pt x="9038" y="6903"/>
                    <a:pt x="8854" y="10118"/>
                  </a:cubicBezTo>
                  <a:lnTo>
                    <a:pt x="446" y="9530"/>
                  </a:lnTo>
                  <a:cubicBezTo>
                    <a:pt x="296" y="6352"/>
                    <a:pt x="149" y="3178"/>
                    <a:pt x="0" y="0"/>
                  </a:cubicBez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 w="1905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d solvent hits (364)</a:t>
              </a:r>
              <a:endParaRPr lang="en-IN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942ED8D0-0CDA-CB6F-4E83-952200DE34D5}"/>
              </a:ext>
            </a:extLst>
          </p:cNvPr>
          <p:cNvSpPr txBox="1"/>
          <p:nvPr/>
        </p:nvSpPr>
        <p:spPr>
          <a:xfrm>
            <a:off x="4291402" y="989974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890142F2-015F-2A99-CAA0-D9506828BACE}"/>
              </a:ext>
            </a:extLst>
          </p:cNvPr>
          <p:cNvGrpSpPr/>
          <p:nvPr/>
        </p:nvGrpSpPr>
        <p:grpSpPr>
          <a:xfrm>
            <a:off x="694467" y="1128474"/>
            <a:ext cx="3372511" cy="3283214"/>
            <a:chOff x="271575" y="862937"/>
            <a:chExt cx="3150637" cy="2996836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BD6AA590-0C84-09D3-B0D5-F0AA852A9015}"/>
                </a:ext>
              </a:extLst>
            </p:cNvPr>
            <p:cNvGrpSpPr/>
            <p:nvPr/>
          </p:nvGrpSpPr>
          <p:grpSpPr>
            <a:xfrm>
              <a:off x="271575" y="895692"/>
              <a:ext cx="3150637" cy="2964081"/>
              <a:chOff x="229241" y="762053"/>
              <a:chExt cx="3150637" cy="2964081"/>
            </a:xfrm>
          </p:grpSpPr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AB098552-44C4-D49D-008A-A53D3DB9EC02}"/>
                  </a:ext>
                </a:extLst>
              </p:cNvPr>
              <p:cNvGrpSpPr/>
              <p:nvPr/>
            </p:nvGrpSpPr>
            <p:grpSpPr>
              <a:xfrm>
                <a:off x="324231" y="762053"/>
                <a:ext cx="2960299" cy="2964081"/>
                <a:chOff x="77776" y="643312"/>
                <a:chExt cx="2960299" cy="2964081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C19C68B5-8DB0-BEC6-0F90-23DE727F56F1}"/>
                    </a:ext>
                  </a:extLst>
                </p:cNvPr>
                <p:cNvSpPr txBox="1"/>
                <p:nvPr/>
              </p:nvSpPr>
              <p:spPr>
                <a:xfrm>
                  <a:off x="1906285" y="1670686"/>
                  <a:ext cx="113179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earched using ChemSpider</a:t>
                  </a:r>
                  <a:endParaRPr lang="en-I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" name="Rectangle: Rounded Corners 1">
                  <a:extLst>
                    <a:ext uri="{FF2B5EF4-FFF2-40B4-BE49-F238E27FC236}">
                      <a16:creationId xmlns:a16="http://schemas.microsoft.com/office/drawing/2014/main" id="{31280C69-C11A-E839-CA5A-2EA2759528B3}"/>
                    </a:ext>
                  </a:extLst>
                </p:cNvPr>
                <p:cNvSpPr/>
                <p:nvPr/>
              </p:nvSpPr>
              <p:spPr>
                <a:xfrm>
                  <a:off x="699253" y="643312"/>
                  <a:ext cx="1367208" cy="270178"/>
                </a:xfrm>
                <a:prstGeom prst="roundRect">
                  <a:avLst/>
                </a:prstGeom>
                <a:noFill/>
                <a:ln w="19050">
                  <a:solidFill>
                    <a:schemeClr val="accent6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w MS/MS input </a:t>
                  </a:r>
                  <a:endParaRPr lang="en-IN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8" name="Straight Arrow Connector 47">
                  <a:extLst>
                    <a:ext uri="{FF2B5EF4-FFF2-40B4-BE49-F238E27FC236}">
                      <a16:creationId xmlns:a16="http://schemas.microsoft.com/office/drawing/2014/main" id="{933F614D-2E03-6F43-BFA6-64B8BADA08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9092" y="937870"/>
                  <a:ext cx="0" cy="222388"/>
                </a:xfrm>
                <a:prstGeom prst="straightConnector1">
                  <a:avLst/>
                </a:prstGeom>
                <a:ln w="28575">
                  <a:solidFill>
                    <a:schemeClr val="accent6">
                      <a:lumMod val="50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Rectangle: Rounded Corners 54">
                  <a:extLst>
                    <a:ext uri="{FF2B5EF4-FFF2-40B4-BE49-F238E27FC236}">
                      <a16:creationId xmlns:a16="http://schemas.microsoft.com/office/drawing/2014/main" id="{91E11001-7A94-CD45-8D5C-862D68785B64}"/>
                    </a:ext>
                  </a:extLst>
                </p:cNvPr>
                <p:cNvSpPr/>
                <p:nvPr/>
              </p:nvSpPr>
              <p:spPr>
                <a:xfrm>
                  <a:off x="812249" y="1195780"/>
                  <a:ext cx="1137121" cy="215566"/>
                </a:xfrm>
                <a:prstGeom prst="round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elect spectra</a:t>
                  </a:r>
                  <a:endParaRPr lang="en-I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6" name="Straight Arrow Connector 55">
                  <a:extLst>
                    <a:ext uri="{FF2B5EF4-FFF2-40B4-BE49-F238E27FC236}">
                      <a16:creationId xmlns:a16="http://schemas.microsoft.com/office/drawing/2014/main" id="{2B61AED3-D6AC-00E5-634F-17CC3791DA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69092" y="1428935"/>
                  <a:ext cx="0" cy="222388"/>
                </a:xfrm>
                <a:prstGeom prst="straightConnector1">
                  <a:avLst/>
                </a:prstGeom>
                <a:ln w="28575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Rectangle: Rounded Corners 56">
                  <a:extLst>
                    <a:ext uri="{FF2B5EF4-FFF2-40B4-BE49-F238E27FC236}">
                      <a16:creationId xmlns:a16="http://schemas.microsoft.com/office/drawing/2014/main" id="{C8F71915-7084-BBD5-4809-0C4635BA75C8}"/>
                    </a:ext>
                  </a:extLst>
                </p:cNvPr>
                <p:cNvSpPr/>
                <p:nvPr/>
              </p:nvSpPr>
              <p:spPr>
                <a:xfrm>
                  <a:off x="731897" y="1670686"/>
                  <a:ext cx="1274390" cy="432268"/>
                </a:xfrm>
                <a:prstGeom prst="roundRect">
                  <a:avLst/>
                </a:prstGeom>
                <a:noFill/>
                <a:ln w="19050"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accent5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lign RT, detect compounds</a:t>
                  </a:r>
                  <a:endParaRPr lang="en-IN" sz="12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8" name="Straight Arrow Connector 57">
                  <a:extLst>
                    <a:ext uri="{FF2B5EF4-FFF2-40B4-BE49-F238E27FC236}">
                      <a16:creationId xmlns:a16="http://schemas.microsoft.com/office/drawing/2014/main" id="{D55D00AB-3B98-F4BE-0DD2-B05FF049B2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921141" y="2121276"/>
                  <a:ext cx="322008" cy="208036"/>
                </a:xfrm>
                <a:prstGeom prst="straightConnector1">
                  <a:avLst/>
                </a:prstGeom>
                <a:ln w="28575">
                  <a:solidFill>
                    <a:schemeClr val="accent5">
                      <a:lumMod val="60000"/>
                      <a:lumOff val="40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Straight Arrow Connector 61">
                  <a:extLst>
                    <a:ext uri="{FF2B5EF4-FFF2-40B4-BE49-F238E27FC236}">
                      <a16:creationId xmlns:a16="http://schemas.microsoft.com/office/drawing/2014/main" id="{ABBAB38D-036C-0690-4839-0CAA917B50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97149" y="2121276"/>
                  <a:ext cx="224994" cy="218127"/>
                </a:xfrm>
                <a:prstGeom prst="straightConnector1">
                  <a:avLst/>
                </a:prstGeom>
                <a:ln w="28575">
                  <a:solidFill>
                    <a:schemeClr val="accent5">
                      <a:lumMod val="60000"/>
                      <a:lumOff val="40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Rectangle: Rounded Corners 66">
                  <a:extLst>
                    <a:ext uri="{FF2B5EF4-FFF2-40B4-BE49-F238E27FC236}">
                      <a16:creationId xmlns:a16="http://schemas.microsoft.com/office/drawing/2014/main" id="{8A5EDC39-D03D-3813-1776-3294A9149CEF}"/>
                    </a:ext>
                  </a:extLst>
                </p:cNvPr>
                <p:cNvSpPr/>
                <p:nvPr/>
              </p:nvSpPr>
              <p:spPr>
                <a:xfrm>
                  <a:off x="77776" y="2389676"/>
                  <a:ext cx="1495318" cy="580958"/>
                </a:xfrm>
                <a:prstGeom prst="roundRect">
                  <a:avLst/>
                </a:prstGeom>
                <a:noFill/>
                <a:ln w="19050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ssign annotations</a:t>
                  </a:r>
                </a:p>
                <a:p>
                  <a:pPr algn="ctr"/>
                  <a:r>
                    <a:rPr lang="en-US" sz="12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Mass tolerance</a:t>
                  </a:r>
                </a:p>
                <a:p>
                  <a:pPr algn="ctr"/>
                  <a:r>
                    <a:rPr lang="en-US" sz="12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&gt;5ppm, S/N&gt;3</a:t>
                  </a:r>
                  <a:endParaRPr lang="en-IN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Rectangle: Rounded Corners 67">
                  <a:extLst>
                    <a:ext uri="{FF2B5EF4-FFF2-40B4-BE49-F238E27FC236}">
                      <a16:creationId xmlns:a16="http://schemas.microsoft.com/office/drawing/2014/main" id="{8E5CD19E-86FD-D33B-A294-2E6EF53CEA81}"/>
                    </a:ext>
                  </a:extLst>
                </p:cNvPr>
                <p:cNvSpPr/>
                <p:nvPr/>
              </p:nvSpPr>
              <p:spPr>
                <a:xfrm>
                  <a:off x="1705142" y="2420546"/>
                  <a:ext cx="1331889" cy="395036"/>
                </a:xfrm>
                <a:prstGeom prst="roundRect">
                  <a:avLst/>
                </a:prstGeom>
                <a:noFill/>
                <a:ln w="19050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rmalize with spike in standard</a:t>
                  </a:r>
                  <a:endParaRPr lang="en-IN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9" name="Straight Arrow Connector 68">
                  <a:extLst>
                    <a:ext uri="{FF2B5EF4-FFF2-40B4-BE49-F238E27FC236}">
                      <a16:creationId xmlns:a16="http://schemas.microsoft.com/office/drawing/2014/main" id="{207AD11C-77AC-A8FD-B4E8-B33804486C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71098" y="3018698"/>
                  <a:ext cx="0" cy="222388"/>
                </a:xfrm>
                <a:prstGeom prst="straightConnector1">
                  <a:avLst/>
                </a:prstGeom>
                <a:ln w="28575">
                  <a:solidFill>
                    <a:schemeClr val="accent4">
                      <a:lumMod val="7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Arrow Connector 69">
                  <a:extLst>
                    <a:ext uri="{FF2B5EF4-FFF2-40B4-BE49-F238E27FC236}">
                      <a16:creationId xmlns:a16="http://schemas.microsoft.com/office/drawing/2014/main" id="{EA6280D9-5BA2-65CA-163A-712A121D20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34150" y="3011155"/>
                  <a:ext cx="0" cy="229931"/>
                </a:xfrm>
                <a:prstGeom prst="straightConnector1">
                  <a:avLst/>
                </a:prstGeom>
                <a:ln w="28575">
                  <a:solidFill>
                    <a:schemeClr val="accent4">
                      <a:lumMod val="7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Rectangle: Rounded Corners 70">
                  <a:extLst>
                    <a:ext uri="{FF2B5EF4-FFF2-40B4-BE49-F238E27FC236}">
                      <a16:creationId xmlns:a16="http://schemas.microsoft.com/office/drawing/2014/main" id="{D7F74763-CF2F-1DB5-F393-50199393A063}"/>
                    </a:ext>
                  </a:extLst>
                </p:cNvPr>
                <p:cNvSpPr/>
                <p:nvPr/>
              </p:nvSpPr>
              <p:spPr>
                <a:xfrm>
                  <a:off x="259519" y="3290313"/>
                  <a:ext cx="2329052" cy="317080"/>
                </a:xfrm>
                <a:prstGeom prst="roundRect">
                  <a:avLst/>
                </a:prstGeom>
                <a:noFill/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inal output (1468 molecular hits)</a:t>
                  </a:r>
                  <a:endParaRPr lang="en-IN" sz="12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86451B62-7DA9-5581-0894-28975A29D5AF}"/>
                  </a:ext>
                </a:extLst>
              </p:cNvPr>
              <p:cNvSpPr/>
              <p:nvPr/>
            </p:nvSpPr>
            <p:spPr>
              <a:xfrm>
                <a:off x="229241" y="2478464"/>
                <a:ext cx="3150637" cy="632667"/>
              </a:xfrm>
              <a:prstGeom prst="rect">
                <a:avLst/>
              </a:prstGeom>
              <a:noFill/>
              <a:ln w="19050"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26" name="Picture 2" descr="LC-MS/MS-Based Serum Metabolomics and ...">
              <a:extLst>
                <a:ext uri="{FF2B5EF4-FFF2-40B4-BE49-F238E27FC236}">
                  <a16:creationId xmlns:a16="http://schemas.microsoft.com/office/drawing/2014/main" id="{58CEA027-FB3D-BCD8-B9D8-50E32F31968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06034" y="862937"/>
              <a:ext cx="835316" cy="3490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F251C76F-E0F7-A553-86BC-48E6D0EBB8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77479" y="1359446"/>
              <a:ext cx="863871" cy="349052"/>
            </a:xfrm>
            <a:prstGeom prst="rect">
              <a:avLst/>
            </a:prstGeom>
          </p:spPr>
        </p:pic>
      </p:grpSp>
      <p:sp>
        <p:nvSpPr>
          <p:cNvPr id="94" name="TextBox 93">
            <a:extLst>
              <a:ext uri="{FF2B5EF4-FFF2-40B4-BE49-F238E27FC236}">
                <a16:creationId xmlns:a16="http://schemas.microsoft.com/office/drawing/2014/main" id="{36AF9918-AF80-04B0-1414-8DB7FEDDE4AF}"/>
              </a:ext>
            </a:extLst>
          </p:cNvPr>
          <p:cNvSpPr txBox="1"/>
          <p:nvPr/>
        </p:nvSpPr>
        <p:spPr>
          <a:xfrm>
            <a:off x="694467" y="4751901"/>
            <a:ext cx="59626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Pipeline used for metabolite analysis in th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bone marrow-derived macrophages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showing the workflow adapted for LC-MS/MS data analysis using Compound Discoverer Software (version 3.0)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teria used for down-selection of molecular features to get the final matrix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um tuberculo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37Rv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81F296-C043-D6E6-B980-44C35CCAB656}"/>
              </a:ext>
            </a:extLst>
          </p:cNvPr>
          <p:cNvSpPr txBox="1"/>
          <p:nvPr/>
        </p:nvSpPr>
        <p:spPr>
          <a:xfrm>
            <a:off x="621347" y="998794"/>
            <a:ext cx="518231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9A72948-86AB-8545-B691-DA99E066B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9843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54D525D-F6AF-639E-F26C-A8439E3A0B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8442044"/>
              </p:ext>
            </p:extLst>
          </p:nvPr>
        </p:nvGraphicFramePr>
        <p:xfrm>
          <a:off x="381000" y="4449763"/>
          <a:ext cx="3249613" cy="199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701835" imgH="2533292" progId="Prism8.Document">
                  <p:embed/>
                </p:oleObj>
              </mc:Choice>
              <mc:Fallback>
                <p:oleObj name="Prism 8" r:id="rId2" imgW="3701835" imgH="2533292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C34671F-04F8-C8C9-026C-DA70E6529D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1000" y="4449763"/>
                        <a:ext cx="3249613" cy="199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5AF76C73-9BEA-E18A-5853-CCFA2854C1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6897873"/>
              </p:ext>
            </p:extLst>
          </p:nvPr>
        </p:nvGraphicFramePr>
        <p:xfrm>
          <a:off x="3100388" y="4652963"/>
          <a:ext cx="2455862" cy="1098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6026511" imgH="2694953" progId="Prism8.Document">
                  <p:embed/>
                </p:oleObj>
              </mc:Choice>
              <mc:Fallback>
                <p:oleObj name="Prism 8" r:id="rId4" imgW="6026511" imgH="2694953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0A7D4E7C-A17A-E0FC-B135-1AA3C0AA7F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00388" y="4652963"/>
                        <a:ext cx="2455862" cy="1098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DCF7E3C7-F13E-C3EF-5A2A-98FFDB7F54E4}"/>
              </a:ext>
            </a:extLst>
          </p:cNvPr>
          <p:cNvSpPr txBox="1"/>
          <p:nvPr/>
        </p:nvSpPr>
        <p:spPr>
          <a:xfrm>
            <a:off x="425876" y="6024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432E209-4946-681E-1EC2-6A31241B1D02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F9DE7C-84B3-54F7-E372-EFAF3B1EBB96}"/>
              </a:ext>
            </a:extLst>
          </p:cNvPr>
          <p:cNvSpPr txBox="1"/>
          <p:nvPr/>
        </p:nvSpPr>
        <p:spPr>
          <a:xfrm>
            <a:off x="425875" y="2423217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F22F2E-9B27-DE6C-BDAE-24D9194DDA03}"/>
              </a:ext>
            </a:extLst>
          </p:cNvPr>
          <p:cNvSpPr txBox="1"/>
          <p:nvPr/>
        </p:nvSpPr>
        <p:spPr>
          <a:xfrm>
            <a:off x="425875" y="443495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ACA8D2-D4B9-EB15-D850-382207468B4A}"/>
              </a:ext>
            </a:extLst>
          </p:cNvPr>
          <p:cNvSpPr txBox="1"/>
          <p:nvPr/>
        </p:nvSpPr>
        <p:spPr>
          <a:xfrm>
            <a:off x="558395" y="6523160"/>
            <a:ext cx="574121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Multivariate analysis of the metabolites data of th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bone marrow-derived macrophages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plots showing clustering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samples and uninfected controls at 0, 4, 24 hp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s showing deregulated metabolic features at 0 and 4 hp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way enrichment plots at 0, 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CA: Principal component analysis, hpi: hours post-infection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ycobacterium tuberculosis H37Rv, BMDMs: Bone marrow-derived macrophages.</a:t>
            </a:r>
          </a:p>
          <a:p>
            <a:pPr algn="just"/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Object 37">
            <a:extLst>
              <a:ext uri="{FF2B5EF4-FFF2-40B4-BE49-F238E27FC236}">
                <a16:creationId xmlns:a16="http://schemas.microsoft.com/office/drawing/2014/main" id="{84D3D979-76E9-3925-0D91-166F98631D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2862915"/>
              </p:ext>
            </p:extLst>
          </p:nvPr>
        </p:nvGraphicFramePr>
        <p:xfrm>
          <a:off x="365125" y="738188"/>
          <a:ext cx="2246313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253466" imgH="2752560" progId="Prism8.Document">
                  <p:embed/>
                </p:oleObj>
              </mc:Choice>
              <mc:Fallback>
                <p:oleObj name="Prism 8" r:id="rId6" imgW="3253466" imgH="2752560" progId="Prism8.Document">
                  <p:embed/>
                  <p:pic>
                    <p:nvPicPr>
                      <p:cNvPr id="2097" name="Object 37">
                        <a:extLst>
                          <a:ext uri="{FF2B5EF4-FFF2-40B4-BE49-F238E27FC236}">
                            <a16:creationId xmlns:a16="http://schemas.microsoft.com/office/drawing/2014/main" id="{29B6A957-584D-79C9-B795-9AFAFE9CCF6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125" y="738188"/>
                        <a:ext cx="2246313" cy="1752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41">
            <a:extLst>
              <a:ext uri="{FF2B5EF4-FFF2-40B4-BE49-F238E27FC236}">
                <a16:creationId xmlns:a16="http://schemas.microsoft.com/office/drawing/2014/main" id="{21E9B660-47C6-0CC9-6D0D-41D7C33E17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5958154"/>
              </p:ext>
            </p:extLst>
          </p:nvPr>
        </p:nvGraphicFramePr>
        <p:xfrm>
          <a:off x="2251075" y="731838"/>
          <a:ext cx="2176463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379874" imgH="2760481" progId="Prism8.Document">
                  <p:embed/>
                </p:oleObj>
              </mc:Choice>
              <mc:Fallback>
                <p:oleObj name="Prism 8" r:id="rId8" imgW="3379874" imgH="2760481" progId="Prism8.Document">
                  <p:embed/>
                  <p:pic>
                    <p:nvPicPr>
                      <p:cNvPr id="2098" name="Object 41">
                        <a:extLst>
                          <a:ext uri="{FF2B5EF4-FFF2-40B4-BE49-F238E27FC236}">
                            <a16:creationId xmlns:a16="http://schemas.microsoft.com/office/drawing/2014/main" id="{8FEB6A13-B9E0-24DF-D96B-71845886052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51075" y="731838"/>
                        <a:ext cx="2176463" cy="1724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54">
            <a:extLst>
              <a:ext uri="{FF2B5EF4-FFF2-40B4-BE49-F238E27FC236}">
                <a16:creationId xmlns:a16="http://schemas.microsoft.com/office/drawing/2014/main" id="{B945A8C6-1600-6BA4-3985-88171FE6A2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836195"/>
              </p:ext>
            </p:extLst>
          </p:nvPr>
        </p:nvGraphicFramePr>
        <p:xfrm>
          <a:off x="4116388" y="711200"/>
          <a:ext cx="2111375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373751" imgH="2760481" progId="Prism8.Document">
                  <p:embed/>
                </p:oleObj>
              </mc:Choice>
              <mc:Fallback>
                <p:oleObj name="Prism 8" r:id="rId10" imgW="3373751" imgH="2760481" progId="Prism8.Document">
                  <p:embed/>
                  <p:pic>
                    <p:nvPicPr>
                      <p:cNvPr id="2099" name="Object 54">
                        <a:extLst>
                          <a:ext uri="{FF2B5EF4-FFF2-40B4-BE49-F238E27FC236}">
                            <a16:creationId xmlns:a16="http://schemas.microsoft.com/office/drawing/2014/main" id="{A4D91265-8AE5-F516-48DF-B88EF3A91D6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16388" y="711200"/>
                        <a:ext cx="2111375" cy="1724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59363CF-CCC4-3672-72CF-C687678AC3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688842"/>
              </p:ext>
            </p:extLst>
          </p:nvPr>
        </p:nvGraphicFramePr>
        <p:xfrm>
          <a:off x="3100388" y="2579688"/>
          <a:ext cx="4837112" cy="191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7356132" imgH="2915662" progId="Prism8.Document">
                  <p:embed/>
                </p:oleObj>
              </mc:Choice>
              <mc:Fallback>
                <p:oleObj name="Prism 8" r:id="rId12" imgW="7356132" imgH="291566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100388" y="2579688"/>
                        <a:ext cx="4837112" cy="1917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0F3954C-FCA8-A14F-5C2B-AD836BDE0D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1053848"/>
              </p:ext>
            </p:extLst>
          </p:nvPr>
        </p:nvGraphicFramePr>
        <p:xfrm>
          <a:off x="-1066800" y="2554288"/>
          <a:ext cx="6173788" cy="1968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9164374" imgH="2920342" progId="Prism8.Document">
                  <p:embed/>
                </p:oleObj>
              </mc:Choice>
              <mc:Fallback>
                <p:oleObj name="Prism 8" r:id="rId14" imgW="9164374" imgH="292034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-1066800" y="2554288"/>
                        <a:ext cx="6173788" cy="1968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17443218-5B92-8F4C-A22C-D061181B1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7145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4F43CAF-F41F-FA0D-64BB-CB04A78B57EE}"/>
              </a:ext>
            </a:extLst>
          </p:cNvPr>
          <p:cNvSpPr txBox="1"/>
          <p:nvPr/>
        </p:nvSpPr>
        <p:spPr>
          <a:xfrm>
            <a:off x="618264" y="356810"/>
            <a:ext cx="448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A44DEFA-29D8-B7B1-35DC-DF425BBE4E1B}"/>
              </a:ext>
            </a:extLst>
          </p:cNvPr>
          <p:cNvGrpSpPr/>
          <p:nvPr/>
        </p:nvGrpSpPr>
        <p:grpSpPr>
          <a:xfrm>
            <a:off x="4841448" y="4253231"/>
            <a:ext cx="1587808" cy="465773"/>
            <a:chOff x="5792797" y="622624"/>
            <a:chExt cx="1587808" cy="465773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BF35BF38-B9FE-5DDA-00BC-77DCBE745509}"/>
                </a:ext>
              </a:extLst>
            </p:cNvPr>
            <p:cNvGrpSpPr/>
            <p:nvPr/>
          </p:nvGrpSpPr>
          <p:grpSpPr>
            <a:xfrm>
              <a:off x="5792797" y="622624"/>
              <a:ext cx="1587808" cy="458074"/>
              <a:chOff x="5342058" y="724356"/>
              <a:chExt cx="1587808" cy="458074"/>
            </a:xfrm>
          </p:grpSpPr>
          <p:sp>
            <p:nvSpPr>
              <p:cNvPr id="22" name="Oval 2">
                <a:extLst>
                  <a:ext uri="{FF2B5EF4-FFF2-40B4-BE49-F238E27FC236}">
                    <a16:creationId xmlns:a16="http://schemas.microsoft.com/office/drawing/2014/main" id="{A680A9D6-F8D8-4B07-BA07-083A23FB0E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9349" y="956268"/>
                <a:ext cx="92869" cy="91899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 w="9525" algn="ctr">
                <a:solidFill>
                  <a:schemeClr val="accent6">
                    <a:lumMod val="75000"/>
                  </a:schemeClr>
                </a:solidFill>
                <a:round/>
                <a:headEnd/>
                <a:tailEnd/>
              </a:ln>
            </p:spPr>
            <p:txBody>
              <a:bodyPr/>
              <a:lstStyle>
                <a:lvl1pPr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endParaRPr lang="en-IN" altLang="en-US" sz="1800">
                  <a:cs typeface="Arial" panose="020B0604020202020204" pitchFamily="34" charset="0"/>
                </a:endParaRPr>
              </a:p>
            </p:txBody>
          </p:sp>
          <p:sp>
            <p:nvSpPr>
              <p:cNvPr id="23" name="Oval 4">
                <a:extLst>
                  <a:ext uri="{FF2B5EF4-FFF2-40B4-BE49-F238E27FC236}">
                    <a16:creationId xmlns:a16="http://schemas.microsoft.com/office/drawing/2014/main" id="{EBA7D355-D15B-4E73-97FC-C3CD594A41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2058" y="959070"/>
                <a:ext cx="92869" cy="91899"/>
              </a:xfrm>
              <a:prstGeom prst="ellipse">
                <a:avLst/>
              </a:prstGeom>
              <a:solidFill>
                <a:srgbClr val="FF0000"/>
              </a:solidFill>
              <a:ln w="9525" algn="ctr">
                <a:solidFill>
                  <a:srgbClr val="FF0000"/>
                </a:solidFill>
                <a:round/>
                <a:headEnd/>
                <a:tailEnd/>
              </a:ln>
            </p:spPr>
            <p:txBody>
              <a:bodyPr/>
              <a:lstStyle>
                <a:lvl1pPr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 defTabSz="1279525"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1279525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endParaRPr lang="en-IN" altLang="en-US" sz="1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5556E2A-3291-3B42-F0A2-C5486A599E36}"/>
                  </a:ext>
                </a:extLst>
              </p:cNvPr>
              <p:cNvSpPr txBox="1"/>
              <p:nvPr/>
            </p:nvSpPr>
            <p:spPr bwMode="auto">
              <a:xfrm>
                <a:off x="5577767" y="724356"/>
                <a:ext cx="1352099" cy="45807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  <a:defRPr/>
                </a:pP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: </a:t>
                </a:r>
                <a:r>
                  <a:rPr lang="en-US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tb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04BF0F7-F6E0-97E1-8E46-AC2111F2E273}"/>
                </a:ext>
              </a:extLst>
            </p:cNvPr>
            <p:cNvSpPr txBox="1"/>
            <p:nvPr/>
          </p:nvSpPr>
          <p:spPr>
            <a:xfrm>
              <a:off x="5819004" y="719065"/>
              <a:ext cx="5248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endParaRPr lang="en-I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A16BBF0E-BF7E-96B6-5AE4-64EBC7C96263}"/>
              </a:ext>
            </a:extLst>
          </p:cNvPr>
          <p:cNvSpPr txBox="1"/>
          <p:nvPr/>
        </p:nvSpPr>
        <p:spPr>
          <a:xfrm>
            <a:off x="568740" y="6678341"/>
            <a:ext cx="588687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: Expression of proteins involved in various metabolic processes and immune responses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macrophages as obtained from LC-MS/MS analysis (A to F). 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at different time points in Methionine-supplemented (MS), restricted (MR), and control group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and uninfected BMDMs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ycobacterium tuberculosis H37Rv, n=4/group for 0, 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=3/group for 2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-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0.01 at 95% confidence</a:t>
            </a:r>
          </a:p>
          <a:p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BC6143F9-0C36-7495-8B07-9DA5B1130C6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3883" y="834114"/>
            <a:ext cx="1981972" cy="179751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340996D-F6A6-7094-EF4F-C6B880BFDCFB}"/>
              </a:ext>
            </a:extLst>
          </p:cNvPr>
          <p:cNvSpPr txBox="1"/>
          <p:nvPr/>
        </p:nvSpPr>
        <p:spPr>
          <a:xfrm>
            <a:off x="661992" y="72944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98B71C2-2317-5733-C940-0DDCBDD131A9}"/>
              </a:ext>
            </a:extLst>
          </p:cNvPr>
          <p:cNvSpPr txBox="1"/>
          <p:nvPr/>
        </p:nvSpPr>
        <p:spPr>
          <a:xfrm>
            <a:off x="4217676" y="688436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CBF654E-1174-8CE7-AF1D-883462C0213E}"/>
              </a:ext>
            </a:extLst>
          </p:cNvPr>
          <p:cNvSpPr txBox="1"/>
          <p:nvPr/>
        </p:nvSpPr>
        <p:spPr>
          <a:xfrm>
            <a:off x="2663683" y="69561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1F9EF3D-2856-A067-52E8-4EC9680D849C}"/>
              </a:ext>
            </a:extLst>
          </p:cNvPr>
          <p:cNvSpPr txBox="1"/>
          <p:nvPr/>
        </p:nvSpPr>
        <p:spPr>
          <a:xfrm>
            <a:off x="697567" y="2535045"/>
            <a:ext cx="426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ABD8B8B-5775-2768-1DA1-41F03B35A98D}"/>
              </a:ext>
            </a:extLst>
          </p:cNvPr>
          <p:cNvSpPr txBox="1"/>
          <p:nvPr/>
        </p:nvSpPr>
        <p:spPr>
          <a:xfrm>
            <a:off x="2856234" y="2542883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34A8C73-EAE5-D858-38AC-445B28A27422}"/>
              </a:ext>
            </a:extLst>
          </p:cNvPr>
          <p:cNvSpPr txBox="1"/>
          <p:nvPr/>
        </p:nvSpPr>
        <p:spPr>
          <a:xfrm>
            <a:off x="4588479" y="2547347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BDA4779-62A0-3676-C2E2-F465D1EEC0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5853728"/>
              </p:ext>
            </p:extLst>
          </p:nvPr>
        </p:nvGraphicFramePr>
        <p:xfrm>
          <a:off x="979145" y="2756577"/>
          <a:ext cx="1717675" cy="1582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753238" imgH="2691712" progId="Prism8.Document">
                  <p:embed/>
                </p:oleObj>
              </mc:Choice>
              <mc:Fallback>
                <p:oleObj name="Prism 8" r:id="rId3" imgW="2753238" imgH="269171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BDA4779-62A0-3676-C2E2-F465D1EEC0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9145" y="2756577"/>
                        <a:ext cx="1717675" cy="1582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629265D-5599-F492-885A-AE43506462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4088061"/>
              </p:ext>
            </p:extLst>
          </p:nvPr>
        </p:nvGraphicFramePr>
        <p:xfrm>
          <a:off x="4495545" y="798793"/>
          <a:ext cx="1871662" cy="185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753238" imgH="2722316" progId="Prism8.Document">
                  <p:embed/>
                </p:oleObj>
              </mc:Choice>
              <mc:Fallback>
                <p:oleObj name="Prism 8" r:id="rId5" imgW="2753238" imgH="2722316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629265D-5599-F492-885A-AE43506462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95545" y="798793"/>
                        <a:ext cx="1871662" cy="185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2BCABB0-0039-048D-4629-18A7EA9777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8613757"/>
              </p:ext>
            </p:extLst>
          </p:nvPr>
        </p:nvGraphicFramePr>
        <p:xfrm>
          <a:off x="2696820" y="816758"/>
          <a:ext cx="1863725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753238" imgH="2708635" progId="Prism8.Document">
                  <p:embed/>
                </p:oleObj>
              </mc:Choice>
              <mc:Fallback>
                <p:oleObj name="Prism 8" r:id="rId7" imgW="2753238" imgH="2708635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22BCABB0-0039-048D-4629-18A7EA9777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96820" y="816758"/>
                        <a:ext cx="1863725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" name="Group 10">
            <a:extLst>
              <a:ext uri="{FF2B5EF4-FFF2-40B4-BE49-F238E27FC236}">
                <a16:creationId xmlns:a16="http://schemas.microsoft.com/office/drawing/2014/main" id="{F11E6D78-CD57-5CB4-5954-FE564D1856C8}"/>
              </a:ext>
            </a:extLst>
          </p:cNvPr>
          <p:cNvGrpSpPr/>
          <p:nvPr/>
        </p:nvGrpSpPr>
        <p:grpSpPr>
          <a:xfrm>
            <a:off x="619888" y="3345470"/>
            <a:ext cx="1298773" cy="1264855"/>
            <a:chOff x="10345" y="3865508"/>
            <a:chExt cx="1298773" cy="1264855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34D48D0A-F049-0873-D3B3-62EE7B89FF1C}"/>
                </a:ext>
              </a:extLst>
            </p:cNvPr>
            <p:cNvGrpSpPr/>
            <p:nvPr/>
          </p:nvGrpSpPr>
          <p:grpSpPr>
            <a:xfrm>
              <a:off x="10345" y="3865508"/>
              <a:ext cx="1132630" cy="1072250"/>
              <a:chOff x="10345" y="3865508"/>
              <a:chExt cx="1132630" cy="1072250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524217EA-273F-EAE9-3A1A-4633F05118F2}"/>
                  </a:ext>
                </a:extLst>
              </p:cNvPr>
              <p:cNvGrpSpPr/>
              <p:nvPr/>
            </p:nvGrpSpPr>
            <p:grpSpPr>
              <a:xfrm>
                <a:off x="330501" y="3955277"/>
                <a:ext cx="812474" cy="977084"/>
                <a:chOff x="488475" y="3825064"/>
                <a:chExt cx="339869" cy="940922"/>
              </a:xfrm>
            </p:grpSpPr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FB1821B8-296D-48D1-1692-32B54B9A35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0781" y="3825064"/>
                  <a:ext cx="0" cy="94092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9BEA7258-CA46-29E1-6421-CC8A7763480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88475" y="4758458"/>
                  <a:ext cx="339869" cy="752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FEC452B-7F87-7FF1-26F7-500F06F366D5}"/>
                  </a:ext>
                </a:extLst>
              </p:cNvPr>
              <p:cNvSpPr txBox="1"/>
              <p:nvPr/>
            </p:nvSpPr>
            <p:spPr>
              <a:xfrm rot="16200000">
                <a:off x="-356503" y="4232356"/>
                <a:ext cx="107225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</a:p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abundance (A.U.)</a:t>
                </a:r>
                <a:endParaRPr lang="en-I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05D5DF8-4067-2342-38F8-C5E650FFCB5D}"/>
                </a:ext>
              </a:extLst>
            </p:cNvPr>
            <p:cNvSpPr txBox="1"/>
            <p:nvPr/>
          </p:nvSpPr>
          <p:spPr>
            <a:xfrm>
              <a:off x="176497" y="4914919"/>
              <a:ext cx="11326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points (hpi)</a:t>
              </a:r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FBEC6DCB-5634-7AA9-CE0C-EB596D598EC7}"/>
              </a:ext>
            </a:extLst>
          </p:cNvPr>
          <p:cNvGrpSpPr/>
          <p:nvPr/>
        </p:nvGrpSpPr>
        <p:grpSpPr>
          <a:xfrm>
            <a:off x="2033246" y="4378033"/>
            <a:ext cx="1922072" cy="530538"/>
            <a:chOff x="124045" y="913613"/>
            <a:chExt cx="2389572" cy="875211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81E67A33-6016-74B5-28D6-BC64770205D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l="83700" r="4832" b="59996"/>
            <a:stretch>
              <a:fillRect/>
            </a:stretch>
          </p:blipFill>
          <p:spPr>
            <a:xfrm>
              <a:off x="124045" y="913613"/>
              <a:ext cx="418357" cy="860229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D72E6CE-AA8A-103B-2F7C-AAE22E47723F}"/>
                </a:ext>
              </a:extLst>
            </p:cNvPr>
            <p:cNvSpPr txBox="1"/>
            <p:nvPr/>
          </p:nvSpPr>
          <p:spPr>
            <a:xfrm>
              <a:off x="526987" y="916650"/>
              <a:ext cx="1986630" cy="355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tb internalization</a:t>
              </a:r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19D7565-01E0-409B-DC9C-211B037A5953}"/>
                </a:ext>
              </a:extLst>
            </p:cNvPr>
            <p:cNvSpPr txBox="1"/>
            <p:nvPr/>
          </p:nvSpPr>
          <p:spPr>
            <a:xfrm>
              <a:off x="487096" y="1178810"/>
              <a:ext cx="1986630" cy="355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arly phase of infection</a:t>
              </a:r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C0A93AD-E133-F04E-C09B-60719F9C1D99}"/>
                </a:ext>
              </a:extLst>
            </p:cNvPr>
            <p:cNvSpPr txBox="1"/>
            <p:nvPr/>
          </p:nvSpPr>
          <p:spPr>
            <a:xfrm>
              <a:off x="501101" y="1433413"/>
              <a:ext cx="1986630" cy="355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 phase of infection</a:t>
              </a:r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586C791-5E28-FE4A-7521-CF00AA33D0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9527697"/>
              </p:ext>
            </p:extLst>
          </p:nvPr>
        </p:nvGraphicFramePr>
        <p:xfrm>
          <a:off x="2820161" y="5021217"/>
          <a:ext cx="2084387" cy="163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331255" imgH="2607821" progId="Prism8.Document">
                  <p:embed/>
                </p:oleObj>
              </mc:Choice>
              <mc:Fallback>
                <p:oleObj name="Prism 8" r:id="rId10" imgW="3331255" imgH="260782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586C791-5E28-FE4A-7521-CF00AA33D0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820161" y="5021217"/>
                        <a:ext cx="2084387" cy="1631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BA66221D-DE97-A568-2AF6-B9D0D1EC0D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9163698"/>
              </p:ext>
            </p:extLst>
          </p:nvPr>
        </p:nvGraphicFramePr>
        <p:xfrm>
          <a:off x="923092" y="5074017"/>
          <a:ext cx="2262187" cy="1604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491156" imgH="2606381" progId="Prism8.Document">
                  <p:embed/>
                </p:oleObj>
              </mc:Choice>
              <mc:Fallback>
                <p:oleObj name="Prism 8" r:id="rId12" imgW="3491156" imgH="2606381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A66221D-DE97-A568-2AF6-B9D0D1EC0D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23092" y="5074017"/>
                        <a:ext cx="2262187" cy="1604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C0411A13-A67E-FB2C-94DA-A3EF029CBDD2}"/>
              </a:ext>
            </a:extLst>
          </p:cNvPr>
          <p:cNvSpPr txBox="1"/>
          <p:nvPr/>
        </p:nvSpPr>
        <p:spPr>
          <a:xfrm>
            <a:off x="620935" y="4862012"/>
            <a:ext cx="426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6DBC7A90-9CA5-CA98-1CB4-4814B1B3B8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4457281"/>
              </p:ext>
            </p:extLst>
          </p:nvPr>
        </p:nvGraphicFramePr>
        <p:xfrm>
          <a:off x="2913125" y="2770829"/>
          <a:ext cx="1719262" cy="157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753238" imgH="2673350" progId="Prism8.Document">
                  <p:embed/>
                </p:oleObj>
              </mc:Choice>
              <mc:Fallback>
                <p:oleObj name="Prism 8" r:id="rId14" imgW="2753238" imgH="2673350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8DC359DF-2C6B-4CC9-A5A5-8F7BEC4395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13125" y="2770829"/>
                        <a:ext cx="1719262" cy="1571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1146012-D8EA-131C-4389-3F424344B3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112071"/>
              </p:ext>
            </p:extLst>
          </p:nvPr>
        </p:nvGraphicFramePr>
        <p:xfrm>
          <a:off x="4483015" y="2788363"/>
          <a:ext cx="1746250" cy="157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753238" imgH="2653547" progId="Prism8.Document">
                  <p:embed/>
                </p:oleObj>
              </mc:Choice>
              <mc:Fallback>
                <p:oleObj name="Prism 8" r:id="rId16" imgW="2753238" imgH="2653547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7DF2EDB-5373-231D-D22A-A705C1A4EB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483015" y="2788363"/>
                        <a:ext cx="1746250" cy="157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F6E936-E085-F24F-9445-96D3DB7B2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06547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1752193-B5E0-87FC-BE6D-258579DCF21D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86709C2-13CF-3DEE-885E-82EB40D12A3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799224" y="2078234"/>
          <a:ext cx="1638136" cy="15623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198919" imgH="4958209" progId="Prism8.Document">
                  <p:embed/>
                </p:oleObj>
              </mc:Choice>
              <mc:Fallback>
                <p:oleObj name="Prism 8" r:id="rId2" imgW="5198919" imgH="4958209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86709C2-13CF-3DEE-885E-82EB40D12A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99224" y="2078234"/>
                        <a:ext cx="1638136" cy="15623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D063932-2FB2-F931-FD14-5038B6FF61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0164696"/>
              </p:ext>
            </p:extLst>
          </p:nvPr>
        </p:nvGraphicFramePr>
        <p:xfrm>
          <a:off x="4602060" y="2078234"/>
          <a:ext cx="1960123" cy="1499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209169" imgH="2455521" progId="Prism8.Document">
                  <p:embed/>
                </p:oleObj>
              </mc:Choice>
              <mc:Fallback>
                <p:oleObj name="Prism 8" r:id="rId4" imgW="3209169" imgH="245552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D063932-2FB2-F931-FD14-5038B6FF61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02060" y="2078234"/>
                        <a:ext cx="1960123" cy="1499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6417DAF-76F3-34CD-33A8-6F88B8E6DD5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07899" y="643497"/>
          <a:ext cx="2258740" cy="14559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809876" imgH="2455521" progId="Prism8.Document">
                  <p:embed/>
                </p:oleObj>
              </mc:Choice>
              <mc:Fallback>
                <p:oleObj name="Prism 8" r:id="rId6" imgW="3809876" imgH="245552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6417DAF-76F3-34CD-33A8-6F88B8E6DD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07899" y="643497"/>
                        <a:ext cx="2258740" cy="14559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FEA0994-1679-5C42-99BA-6AFF89C430C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8567" y="1878880"/>
          <a:ext cx="2304789" cy="2687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5308400" imgH="6189930" progId="Prism8.Document">
                  <p:embed/>
                </p:oleObj>
              </mc:Choice>
              <mc:Fallback>
                <p:oleObj name="Prism 8" r:id="rId8" imgW="5308400" imgH="6189930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FEA0994-1679-5C42-99BA-6AFF89C430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8567" y="1878880"/>
                        <a:ext cx="2304789" cy="2687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66" name="Group 365">
            <a:extLst>
              <a:ext uri="{FF2B5EF4-FFF2-40B4-BE49-F238E27FC236}">
                <a16:creationId xmlns:a16="http://schemas.microsoft.com/office/drawing/2014/main" id="{046509BF-49A4-3CCC-5A64-1C849E183B69}"/>
              </a:ext>
            </a:extLst>
          </p:cNvPr>
          <p:cNvGrpSpPr/>
          <p:nvPr/>
        </p:nvGrpSpPr>
        <p:grpSpPr>
          <a:xfrm>
            <a:off x="448305" y="6100727"/>
            <a:ext cx="4222763" cy="1254852"/>
            <a:chOff x="1676488" y="3975379"/>
            <a:chExt cx="5897895" cy="1900712"/>
          </a:xfrm>
        </p:grpSpPr>
        <p:graphicFrame>
          <p:nvGraphicFramePr>
            <p:cNvPr id="367" name="Object 366">
              <a:extLst>
                <a:ext uri="{FF2B5EF4-FFF2-40B4-BE49-F238E27FC236}">
                  <a16:creationId xmlns:a16="http://schemas.microsoft.com/office/drawing/2014/main" id="{0AFE419C-496E-39B3-CCBA-197971FDDE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93486938"/>
                </p:ext>
              </p:extLst>
            </p:nvPr>
          </p:nvGraphicFramePr>
          <p:xfrm>
            <a:off x="3184046" y="3989017"/>
            <a:ext cx="1749232" cy="18870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276058" imgH="2455521" progId="Prism8.Document">
                    <p:embed/>
                  </p:oleObj>
                </mc:Choice>
                <mc:Fallback>
                  <p:oleObj name="Prism 8" r:id="rId10" imgW="2276058" imgH="2455521" progId="Prism8.Document">
                    <p:embed/>
                    <p:pic>
                      <p:nvPicPr>
                        <p:cNvPr id="366" name="Object 365">
                          <a:extLst>
                            <a:ext uri="{FF2B5EF4-FFF2-40B4-BE49-F238E27FC236}">
                              <a16:creationId xmlns:a16="http://schemas.microsoft.com/office/drawing/2014/main" id="{0AFE419C-496E-39B3-CCBA-197971FDDE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184046" y="3989017"/>
                          <a:ext cx="1749232" cy="188707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68" name="Object 367">
              <a:extLst>
                <a:ext uri="{FF2B5EF4-FFF2-40B4-BE49-F238E27FC236}">
                  <a16:creationId xmlns:a16="http://schemas.microsoft.com/office/drawing/2014/main" id="{24364B64-1719-33C8-E2C2-640B2738F9F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676488" y="3978080"/>
            <a:ext cx="1926032" cy="188819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504744" imgH="2455521" progId="Prism8.Document">
                    <p:embed/>
                  </p:oleObj>
                </mc:Choice>
                <mc:Fallback>
                  <p:oleObj name="Prism 8" r:id="rId12" imgW="2504744" imgH="2455521" progId="Prism8.Document">
                    <p:embed/>
                    <p:pic>
                      <p:nvPicPr>
                        <p:cNvPr id="367" name="Object 366">
                          <a:extLst>
                            <a:ext uri="{FF2B5EF4-FFF2-40B4-BE49-F238E27FC236}">
                              <a16:creationId xmlns:a16="http://schemas.microsoft.com/office/drawing/2014/main" id="{24364B64-1719-33C8-E2C2-640B2738F9F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676488" y="3978080"/>
                          <a:ext cx="1926032" cy="188819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69" name="Object 368">
              <a:extLst>
                <a:ext uri="{FF2B5EF4-FFF2-40B4-BE49-F238E27FC236}">
                  <a16:creationId xmlns:a16="http://schemas.microsoft.com/office/drawing/2014/main" id="{82A69B2E-ABB9-A8C4-5BA1-EF9F98EF63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6045799"/>
                </p:ext>
              </p:extLst>
            </p:nvPr>
          </p:nvGraphicFramePr>
          <p:xfrm>
            <a:off x="5879015" y="3975379"/>
            <a:ext cx="1695368" cy="18264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2279299" imgH="2455521" progId="Prism8.Document">
                    <p:embed/>
                  </p:oleObj>
                </mc:Choice>
                <mc:Fallback>
                  <p:oleObj name="Prism 8" r:id="rId14" imgW="2279299" imgH="2455521" progId="Prism8.Document">
                    <p:embed/>
                    <p:pic>
                      <p:nvPicPr>
                        <p:cNvPr id="368" name="Object 367">
                          <a:extLst>
                            <a:ext uri="{FF2B5EF4-FFF2-40B4-BE49-F238E27FC236}">
                              <a16:creationId xmlns:a16="http://schemas.microsoft.com/office/drawing/2014/main" id="{82A69B2E-ABB9-A8C4-5BA1-EF9F98EF63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879015" y="3975379"/>
                          <a:ext cx="1695368" cy="18264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0" name="Object 369">
              <a:extLst>
                <a:ext uri="{FF2B5EF4-FFF2-40B4-BE49-F238E27FC236}">
                  <a16:creationId xmlns:a16="http://schemas.microsoft.com/office/drawing/2014/main" id="{E2AB342C-9076-1D54-06B8-2247217573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97860807"/>
                </p:ext>
              </p:extLst>
            </p:nvPr>
          </p:nvGraphicFramePr>
          <p:xfrm>
            <a:off x="4411364" y="3989017"/>
            <a:ext cx="1940633" cy="18128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2628270" imgH="2455521" progId="Prism8.Document">
                    <p:embed/>
                  </p:oleObj>
                </mc:Choice>
                <mc:Fallback>
                  <p:oleObj name="Prism 8" r:id="rId16" imgW="2628270" imgH="2455521" progId="Prism8.Document">
                    <p:embed/>
                    <p:pic>
                      <p:nvPicPr>
                        <p:cNvPr id="369" name="Object 368">
                          <a:extLst>
                            <a:ext uri="{FF2B5EF4-FFF2-40B4-BE49-F238E27FC236}">
                              <a16:creationId xmlns:a16="http://schemas.microsoft.com/office/drawing/2014/main" id="{E2AB342C-9076-1D54-06B8-2247217573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411364" y="3989017"/>
                          <a:ext cx="1940633" cy="18128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pic>
        <p:nvPicPr>
          <p:cNvPr id="371" name="Picture 370">
            <a:extLst>
              <a:ext uri="{FF2B5EF4-FFF2-40B4-BE49-F238E27FC236}">
                <a16:creationId xmlns:a16="http://schemas.microsoft.com/office/drawing/2014/main" id="{94132607-03E9-14CF-9225-312DED228005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37360" y="6193309"/>
            <a:ext cx="2355849" cy="1245848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48C44158-4A27-7096-C851-06312021EB29}"/>
              </a:ext>
            </a:extLst>
          </p:cNvPr>
          <p:cNvGrpSpPr/>
          <p:nvPr/>
        </p:nvGrpSpPr>
        <p:grpSpPr>
          <a:xfrm>
            <a:off x="390277" y="4696630"/>
            <a:ext cx="6439433" cy="1180338"/>
            <a:chOff x="425876" y="4657540"/>
            <a:chExt cx="6439433" cy="1180338"/>
          </a:xfrm>
        </p:grpSpPr>
        <p:pic>
          <p:nvPicPr>
            <p:cNvPr id="375" name="Picture 374">
              <a:extLst>
                <a:ext uri="{FF2B5EF4-FFF2-40B4-BE49-F238E27FC236}">
                  <a16:creationId xmlns:a16="http://schemas.microsoft.com/office/drawing/2014/main" id="{4E7D11DC-1E7B-27A5-E508-5C0200784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757394" y="4808278"/>
              <a:ext cx="1102099" cy="1029600"/>
            </a:xfrm>
            <a:prstGeom prst="rect">
              <a:avLst/>
            </a:prstGeom>
          </p:spPr>
        </p:pic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8A3FF92D-4540-D93B-DAC7-A4F2278D28D4}"/>
                </a:ext>
              </a:extLst>
            </p:cNvPr>
            <p:cNvGrpSpPr/>
            <p:nvPr/>
          </p:nvGrpSpPr>
          <p:grpSpPr>
            <a:xfrm>
              <a:off x="425876" y="4657540"/>
              <a:ext cx="6439433" cy="1162477"/>
              <a:chOff x="425876" y="4657540"/>
              <a:chExt cx="6439433" cy="1162477"/>
            </a:xfrm>
          </p:grpSpPr>
          <p:pic>
            <p:nvPicPr>
              <p:cNvPr id="376" name="Picture 375">
                <a:extLst>
                  <a:ext uri="{FF2B5EF4-FFF2-40B4-BE49-F238E27FC236}">
                    <a16:creationId xmlns:a16="http://schemas.microsoft.com/office/drawing/2014/main" id="{891478AD-73D4-21F4-8067-008321351A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4769458" y="4790417"/>
                <a:ext cx="1162127" cy="1029600"/>
              </a:xfrm>
              <a:prstGeom prst="rect">
                <a:avLst/>
              </a:prstGeom>
            </p:spPr>
          </p:pic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0E9F09BB-E8CC-8982-5690-199B3612CC1A}"/>
                  </a:ext>
                </a:extLst>
              </p:cNvPr>
              <p:cNvGrpSpPr/>
              <p:nvPr/>
            </p:nvGrpSpPr>
            <p:grpSpPr>
              <a:xfrm>
                <a:off x="425876" y="4657540"/>
                <a:ext cx="6439433" cy="1151072"/>
                <a:chOff x="425876" y="4657540"/>
                <a:chExt cx="6439433" cy="1151072"/>
              </a:xfrm>
            </p:grpSpPr>
            <p:pic>
              <p:nvPicPr>
                <p:cNvPr id="372" name="Picture 371">
                  <a:extLst>
                    <a:ext uri="{FF2B5EF4-FFF2-40B4-BE49-F238E27FC236}">
                      <a16:creationId xmlns:a16="http://schemas.microsoft.com/office/drawing/2014/main" id="{4A403A26-8535-DAEE-F5DA-83CC2CD7B8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425876" y="4777073"/>
                  <a:ext cx="1217567" cy="1031539"/>
                </a:xfrm>
                <a:prstGeom prst="rect">
                  <a:avLst/>
                </a:prstGeom>
              </p:spPr>
            </p:pic>
            <p:pic>
              <p:nvPicPr>
                <p:cNvPr id="373" name="Picture 372">
                  <a:extLst>
                    <a:ext uri="{FF2B5EF4-FFF2-40B4-BE49-F238E27FC236}">
                      <a16:creationId xmlns:a16="http://schemas.microsoft.com/office/drawing/2014/main" id="{50764CAC-566C-7789-5DD6-FCCCCC2CE3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1566390" y="4779012"/>
                  <a:ext cx="1105879" cy="1029600"/>
                </a:xfrm>
                <a:prstGeom prst="rect">
                  <a:avLst/>
                </a:prstGeom>
              </p:spPr>
            </p:pic>
            <p:pic>
              <p:nvPicPr>
                <p:cNvPr id="374" name="Picture 373">
                  <a:extLst>
                    <a:ext uri="{FF2B5EF4-FFF2-40B4-BE49-F238E27FC236}">
                      <a16:creationId xmlns:a16="http://schemas.microsoft.com/office/drawing/2014/main" id="{B8EDCB06-8557-3C86-4719-6D05A9E8B4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2675176" y="4657540"/>
                  <a:ext cx="1116795" cy="1140568"/>
                </a:xfrm>
                <a:prstGeom prst="rect">
                  <a:avLst/>
                </a:prstGeom>
              </p:spPr>
            </p:pic>
            <p:pic>
              <p:nvPicPr>
                <p:cNvPr id="377" name="Picture 376">
                  <a:extLst>
                    <a:ext uri="{FF2B5EF4-FFF2-40B4-BE49-F238E27FC236}">
                      <a16:creationId xmlns:a16="http://schemas.microsoft.com/office/drawing/2014/main" id="{98213472-F85D-E232-DDA8-8446EF60F9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5796340" y="4769033"/>
                  <a:ext cx="1068969" cy="1029600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378" name="TextBox 377">
            <a:extLst>
              <a:ext uri="{FF2B5EF4-FFF2-40B4-BE49-F238E27FC236}">
                <a16:creationId xmlns:a16="http://schemas.microsoft.com/office/drawing/2014/main" id="{1B642B1A-B54C-906B-565C-EA825550B181}"/>
              </a:ext>
            </a:extLst>
          </p:cNvPr>
          <p:cNvSpPr txBox="1"/>
          <p:nvPr/>
        </p:nvSpPr>
        <p:spPr>
          <a:xfrm>
            <a:off x="425876" y="6024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6E8B0283-B359-3AB9-FACD-071C3F88121C}"/>
              </a:ext>
            </a:extLst>
          </p:cNvPr>
          <p:cNvSpPr txBox="1"/>
          <p:nvPr/>
        </p:nvSpPr>
        <p:spPr>
          <a:xfrm>
            <a:off x="3422604" y="528404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68F6872A-A954-FF0C-2CCB-36EC77A559E7}"/>
              </a:ext>
            </a:extLst>
          </p:cNvPr>
          <p:cNvSpPr txBox="1"/>
          <p:nvPr/>
        </p:nvSpPr>
        <p:spPr>
          <a:xfrm>
            <a:off x="425876" y="1764090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D4A1A1FB-5B94-DF1F-F39D-287995F34246}"/>
              </a:ext>
            </a:extLst>
          </p:cNvPr>
          <p:cNvSpPr txBox="1"/>
          <p:nvPr/>
        </p:nvSpPr>
        <p:spPr>
          <a:xfrm>
            <a:off x="2597396" y="1960943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2BB7DA59-9634-3AEE-7AA1-D163AF5F39F9}"/>
              </a:ext>
            </a:extLst>
          </p:cNvPr>
          <p:cNvSpPr txBox="1"/>
          <p:nvPr/>
        </p:nvSpPr>
        <p:spPr>
          <a:xfrm>
            <a:off x="4285895" y="2006776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D9D98097-61A9-B966-A78A-2EC391CE7E9B}"/>
              </a:ext>
            </a:extLst>
          </p:cNvPr>
          <p:cNvSpPr txBox="1"/>
          <p:nvPr/>
        </p:nvSpPr>
        <p:spPr>
          <a:xfrm>
            <a:off x="526569" y="450759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7C054700-2AC5-8F42-63C6-18D5B166E510}"/>
              </a:ext>
            </a:extLst>
          </p:cNvPr>
          <p:cNvSpPr txBox="1"/>
          <p:nvPr/>
        </p:nvSpPr>
        <p:spPr>
          <a:xfrm>
            <a:off x="4264680" y="59516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6A8D2D66-F5F7-0C4C-CBA6-34EC86A892AA}"/>
              </a:ext>
            </a:extLst>
          </p:cNvPr>
          <p:cNvSpPr txBox="1"/>
          <p:nvPr/>
        </p:nvSpPr>
        <p:spPr>
          <a:xfrm>
            <a:off x="526569" y="7455567"/>
            <a:ext cx="586780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: Methionine supplementation has a limited impact on body weight gain and alters the alveolar macrophage population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strategy adopted for the stud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 gain with time for the mouse group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ed and water intake during the stud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 blood glucose leve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 weight after 2 weeks of interven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llowed for lung macrophage profil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numbers and frequencies of monocytic and alveolar macrophages in the mice's lungs. Two-way ANOVA (mixed effect model) with Sidak’s multiple test is used to compare body weight, and Welch’s t-test is used to compare cell proportions, CT: control, MS: methionine supplemented, AMs: alveolar macrophages, MDMs: monocyte-derived macrophages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&lt;0.01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01 at 95% confidence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365E0A6-744E-22BA-6A8C-9A2EBAD81823}"/>
              </a:ext>
            </a:extLst>
          </p:cNvPr>
          <p:cNvSpPr txBox="1"/>
          <p:nvPr/>
        </p:nvSpPr>
        <p:spPr>
          <a:xfrm>
            <a:off x="474536" y="5880578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9E9F02D-5050-12E1-5C05-629E09150C55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14708" y="736502"/>
            <a:ext cx="2678217" cy="1086924"/>
          </a:xfrm>
          <a:prstGeom prst="rect">
            <a:avLst/>
          </a:prstGeom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46067DF3-D2E2-A343-90F5-23EF9C37B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6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1368162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1" name="Object 390">
            <a:extLst>
              <a:ext uri="{FF2B5EF4-FFF2-40B4-BE49-F238E27FC236}">
                <a16:creationId xmlns:a16="http://schemas.microsoft.com/office/drawing/2014/main" id="{BF20D44D-38A8-63B1-E355-3777234036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7064905"/>
              </p:ext>
            </p:extLst>
          </p:nvPr>
        </p:nvGraphicFramePr>
        <p:xfrm>
          <a:off x="3283452" y="3799923"/>
          <a:ext cx="1216414" cy="1474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41602" imgH="2837892" progId="Prism8.Document">
                  <p:embed/>
                </p:oleObj>
              </mc:Choice>
              <mc:Fallback>
                <p:oleObj name="Prism 8" r:id="rId2" imgW="2341602" imgH="2837892" progId="Prism8.Document">
                  <p:embed/>
                  <p:pic>
                    <p:nvPicPr>
                      <p:cNvPr id="391" name="Object 390">
                        <a:extLst>
                          <a:ext uri="{FF2B5EF4-FFF2-40B4-BE49-F238E27FC236}">
                            <a16:creationId xmlns:a16="http://schemas.microsoft.com/office/drawing/2014/main" id="{BF20D44D-38A8-63B1-E355-3777234036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83452" y="3799923"/>
                        <a:ext cx="1216414" cy="1474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2" name="Object 391">
            <a:extLst>
              <a:ext uri="{FF2B5EF4-FFF2-40B4-BE49-F238E27FC236}">
                <a16:creationId xmlns:a16="http://schemas.microsoft.com/office/drawing/2014/main" id="{D8FD7CAD-552F-C0F0-CDDB-A8C1B71AF4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5584850"/>
              </p:ext>
            </p:extLst>
          </p:nvPr>
        </p:nvGraphicFramePr>
        <p:xfrm>
          <a:off x="4622389" y="3749442"/>
          <a:ext cx="1253582" cy="1502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366092" imgH="2837892" progId="Prism8.Document">
                  <p:embed/>
                </p:oleObj>
              </mc:Choice>
              <mc:Fallback>
                <p:oleObj name="Prism 8" r:id="rId4" imgW="2366092" imgH="2837892" progId="Prism8.Document">
                  <p:embed/>
                  <p:pic>
                    <p:nvPicPr>
                      <p:cNvPr id="392" name="Object 391">
                        <a:extLst>
                          <a:ext uri="{FF2B5EF4-FFF2-40B4-BE49-F238E27FC236}">
                            <a16:creationId xmlns:a16="http://schemas.microsoft.com/office/drawing/2014/main" id="{D8FD7CAD-552F-C0F0-CDDB-A8C1B71AF4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22389" y="3749442"/>
                        <a:ext cx="1253582" cy="1502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3" name="Object 392">
            <a:extLst>
              <a:ext uri="{FF2B5EF4-FFF2-40B4-BE49-F238E27FC236}">
                <a16:creationId xmlns:a16="http://schemas.microsoft.com/office/drawing/2014/main" id="{CCE118F7-61E5-38EC-9E0C-A45A3A5DD9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3447595"/>
              </p:ext>
            </p:extLst>
          </p:nvPr>
        </p:nvGraphicFramePr>
        <p:xfrm>
          <a:off x="601392" y="3711342"/>
          <a:ext cx="1247669" cy="1614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193947" imgH="2837892" progId="Prism8.Document">
                  <p:embed/>
                </p:oleObj>
              </mc:Choice>
              <mc:Fallback>
                <p:oleObj name="Prism 8" r:id="rId6" imgW="2193947" imgH="2837892" progId="Prism8.Document">
                  <p:embed/>
                  <p:pic>
                    <p:nvPicPr>
                      <p:cNvPr id="393" name="Object 392">
                        <a:extLst>
                          <a:ext uri="{FF2B5EF4-FFF2-40B4-BE49-F238E27FC236}">
                            <a16:creationId xmlns:a16="http://schemas.microsoft.com/office/drawing/2014/main" id="{CCE118F7-61E5-38EC-9E0C-A45A3A5DD9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01392" y="3711342"/>
                        <a:ext cx="1247669" cy="1614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4" name="Object 393">
            <a:extLst>
              <a:ext uri="{FF2B5EF4-FFF2-40B4-BE49-F238E27FC236}">
                <a16:creationId xmlns:a16="http://schemas.microsoft.com/office/drawing/2014/main" id="{6567A75C-A351-1A6C-AA52-7F9A9255DD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7328076"/>
              </p:ext>
            </p:extLst>
          </p:nvPr>
        </p:nvGraphicFramePr>
        <p:xfrm>
          <a:off x="1849061" y="3711342"/>
          <a:ext cx="1311868" cy="1615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308110" imgH="2837892" progId="Prism8.Document">
                  <p:embed/>
                </p:oleObj>
              </mc:Choice>
              <mc:Fallback>
                <p:oleObj name="Prism 8" r:id="rId8" imgW="2308110" imgH="2837892" progId="Prism8.Document">
                  <p:embed/>
                  <p:pic>
                    <p:nvPicPr>
                      <p:cNvPr id="394" name="Object 393">
                        <a:extLst>
                          <a:ext uri="{FF2B5EF4-FFF2-40B4-BE49-F238E27FC236}">
                            <a16:creationId xmlns:a16="http://schemas.microsoft.com/office/drawing/2014/main" id="{6567A75C-A351-1A6C-AA52-7F9A9255DD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849061" y="3711342"/>
                        <a:ext cx="1311868" cy="1615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5" name="Object 394">
            <a:extLst>
              <a:ext uri="{FF2B5EF4-FFF2-40B4-BE49-F238E27FC236}">
                <a16:creationId xmlns:a16="http://schemas.microsoft.com/office/drawing/2014/main" id="{6B59B5A6-56F1-2CED-DF91-F5EBE69691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8891564"/>
              </p:ext>
            </p:extLst>
          </p:nvPr>
        </p:nvGraphicFramePr>
        <p:xfrm>
          <a:off x="1882727" y="5275393"/>
          <a:ext cx="1373714" cy="1665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341602" imgH="2837892" progId="Prism8.Document">
                  <p:embed/>
                </p:oleObj>
              </mc:Choice>
              <mc:Fallback>
                <p:oleObj name="Prism 8" r:id="rId10" imgW="2341602" imgH="2837892" progId="Prism8.Document">
                  <p:embed/>
                  <p:pic>
                    <p:nvPicPr>
                      <p:cNvPr id="395" name="Object 394">
                        <a:extLst>
                          <a:ext uri="{FF2B5EF4-FFF2-40B4-BE49-F238E27FC236}">
                            <a16:creationId xmlns:a16="http://schemas.microsoft.com/office/drawing/2014/main" id="{6B59B5A6-56F1-2CED-DF91-F5EBE69691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82727" y="5275393"/>
                        <a:ext cx="1373714" cy="16653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6" name="Object 395">
            <a:extLst>
              <a:ext uri="{FF2B5EF4-FFF2-40B4-BE49-F238E27FC236}">
                <a16:creationId xmlns:a16="http://schemas.microsoft.com/office/drawing/2014/main" id="{97390E71-7E12-B78D-D640-2EC969FBAF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8395690"/>
              </p:ext>
            </p:extLst>
          </p:nvPr>
        </p:nvGraphicFramePr>
        <p:xfrm>
          <a:off x="3390851" y="5228755"/>
          <a:ext cx="1373715" cy="16799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373654" imgH="2903780" progId="Prism8.Document">
                  <p:embed/>
                </p:oleObj>
              </mc:Choice>
              <mc:Fallback>
                <p:oleObj name="Prism 8" r:id="rId12" imgW="2373654" imgH="2903780" progId="Prism8.Document">
                  <p:embed/>
                  <p:pic>
                    <p:nvPicPr>
                      <p:cNvPr id="396" name="Object 395">
                        <a:extLst>
                          <a:ext uri="{FF2B5EF4-FFF2-40B4-BE49-F238E27FC236}">
                            <a16:creationId xmlns:a16="http://schemas.microsoft.com/office/drawing/2014/main" id="{97390E71-7E12-B78D-D640-2EC969FBAF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90851" y="5228755"/>
                        <a:ext cx="1373715" cy="16799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7" name="Object 396">
            <a:extLst>
              <a:ext uri="{FF2B5EF4-FFF2-40B4-BE49-F238E27FC236}">
                <a16:creationId xmlns:a16="http://schemas.microsoft.com/office/drawing/2014/main" id="{A7D57212-FECB-8A20-2CD8-D919072A34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3146549"/>
              </p:ext>
            </p:extLst>
          </p:nvPr>
        </p:nvGraphicFramePr>
        <p:xfrm>
          <a:off x="508663" y="5242362"/>
          <a:ext cx="1374840" cy="16856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314232" imgH="2837892" progId="Prism8.Document">
                  <p:embed/>
                </p:oleObj>
              </mc:Choice>
              <mc:Fallback>
                <p:oleObj name="Prism 8" r:id="rId14" imgW="2314232" imgH="2837892" progId="Prism8.Document">
                  <p:embed/>
                  <p:pic>
                    <p:nvPicPr>
                      <p:cNvPr id="397" name="Object 396">
                        <a:extLst>
                          <a:ext uri="{FF2B5EF4-FFF2-40B4-BE49-F238E27FC236}">
                            <a16:creationId xmlns:a16="http://schemas.microsoft.com/office/drawing/2014/main" id="{A7D57212-FECB-8A20-2CD8-D919072A34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08663" y="5242362"/>
                        <a:ext cx="1374840" cy="16856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816F7F8-BC7E-DAEF-3E09-8DFA867E6176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2F583B-B0B0-A6B9-6587-8A12A99FC005}"/>
              </a:ext>
            </a:extLst>
          </p:cNvPr>
          <p:cNvSpPr txBox="1"/>
          <p:nvPr/>
        </p:nvSpPr>
        <p:spPr>
          <a:xfrm>
            <a:off x="601392" y="7159645"/>
            <a:ext cx="574121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ionine-supplemented mice had a limited impact on glucose metabolism and impacted lung immune cell distribution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od and water intake profile of the mouse groups throughout the experimen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the body weight of the mouse groups with tim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 blood glucose levels and intraperitoneal glucose tolerance test after 6 hours of fasting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numbers of different immune cells in lungs and splee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mice groups at 21 dpi. Two-way ANOVA (mixed effect model) with Sidak’s multiple test is used to compare body weight, and One-way ANOVA with Tukey’s multiple comparisons is used to compare cell proportions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1 at 95% confidence.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02DC2F-D37E-BBD5-4399-9169D5B4FF38}"/>
              </a:ext>
            </a:extLst>
          </p:cNvPr>
          <p:cNvSpPr txBox="1"/>
          <p:nvPr/>
        </p:nvSpPr>
        <p:spPr>
          <a:xfrm>
            <a:off x="475240" y="361114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8CBE9BC-1DD3-7F02-8822-D90F13102795}"/>
              </a:ext>
            </a:extLst>
          </p:cNvPr>
          <p:cNvSpPr txBox="1"/>
          <p:nvPr/>
        </p:nvSpPr>
        <p:spPr>
          <a:xfrm>
            <a:off x="492517" y="5049048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CD82CB4-0B7D-47FC-AF8D-760E9826E9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0668706"/>
              </p:ext>
            </p:extLst>
          </p:nvPr>
        </p:nvGraphicFramePr>
        <p:xfrm>
          <a:off x="2946474" y="2159552"/>
          <a:ext cx="1223964" cy="14812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411829" imgH="2920342" progId="Prism8.Document">
                  <p:embed/>
                </p:oleObj>
              </mc:Choice>
              <mc:Fallback>
                <p:oleObj name="Prism 8" r:id="rId16" imgW="2411829" imgH="2920342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E076B5A-3791-694D-AA05-FEA5164814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946474" y="2159552"/>
                        <a:ext cx="1223964" cy="14812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B6171FB-05E8-4D1E-A4D4-02914032DA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4526209"/>
              </p:ext>
            </p:extLst>
          </p:nvPr>
        </p:nvGraphicFramePr>
        <p:xfrm>
          <a:off x="376230" y="695680"/>
          <a:ext cx="2514783" cy="2911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4639268" imgH="5374424" progId="Prism8.Document">
                  <p:embed/>
                </p:oleObj>
              </mc:Choice>
              <mc:Fallback>
                <p:oleObj name="Prism 8" r:id="rId18" imgW="4639268" imgH="5374424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14BAEE8-0DD4-27DC-AAEE-188A4DA1EC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76230" y="695680"/>
                        <a:ext cx="2514783" cy="2911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C2C70A76-D7B3-2A65-C51E-EB7BA5A79046}"/>
              </a:ext>
            </a:extLst>
          </p:cNvPr>
          <p:cNvGrpSpPr/>
          <p:nvPr/>
        </p:nvGrpSpPr>
        <p:grpSpPr>
          <a:xfrm>
            <a:off x="4225899" y="2210159"/>
            <a:ext cx="2104967" cy="1243095"/>
            <a:chOff x="4694552" y="2989321"/>
            <a:chExt cx="3412457" cy="2163003"/>
          </a:xfrm>
        </p:grpSpPr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936ED7BE-6338-5445-6FB1-DAC8E99799D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416590"/>
                </p:ext>
              </p:extLst>
            </p:nvPr>
          </p:nvGraphicFramePr>
          <p:xfrm>
            <a:off x="4694552" y="2989321"/>
            <a:ext cx="3412457" cy="21630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3854172" imgH="2443280" progId="Prism8.Document">
                    <p:embed/>
                  </p:oleObj>
                </mc:Choice>
                <mc:Fallback>
                  <p:oleObj name="Prism 8" r:id="rId20" imgW="3854172" imgH="2443280" progId="Prism8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AE972978-CD21-B158-C4CD-5CD9C13A603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694552" y="2989321"/>
                          <a:ext cx="3412457" cy="21630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E2D8AB28-5423-19D4-22D5-1CAF1A6191B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1105978"/>
                </p:ext>
              </p:extLst>
            </p:nvPr>
          </p:nvGraphicFramePr>
          <p:xfrm>
            <a:off x="6869892" y="4069825"/>
            <a:ext cx="697438" cy="6960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2" imgW="2202950" imgH="2202408" progId="Prism8.Document">
                    <p:embed/>
                  </p:oleObj>
                </mc:Choice>
                <mc:Fallback>
                  <p:oleObj name="Prism 8" r:id="rId22" imgW="2202950" imgH="2202408" progId="Prism8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E142488F-EB61-8DFA-FED9-5F9FA1607AA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6869892" y="4069825"/>
                          <a:ext cx="697438" cy="6960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605B836-9318-7051-BE96-CA82689A9386}"/>
              </a:ext>
            </a:extLst>
          </p:cNvPr>
          <p:cNvGrpSpPr/>
          <p:nvPr/>
        </p:nvGrpSpPr>
        <p:grpSpPr>
          <a:xfrm>
            <a:off x="2765748" y="653927"/>
            <a:ext cx="2246130" cy="1457476"/>
            <a:chOff x="7290460" y="-612907"/>
            <a:chExt cx="2960687" cy="3272354"/>
          </a:xfrm>
        </p:grpSpPr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73F2A2F3-1369-2E13-A6EB-DE5F5DC3640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81767228"/>
                </p:ext>
              </p:extLst>
            </p:nvPr>
          </p:nvGraphicFramePr>
          <p:xfrm>
            <a:off x="7290460" y="-612907"/>
            <a:ext cx="2960687" cy="327235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4" imgW="3732086" imgH="2438599" progId="Prism8.Document">
                    <p:embed/>
                  </p:oleObj>
                </mc:Choice>
                <mc:Fallback>
                  <p:oleObj name="Prism 8" r:id="rId24" imgW="3732086" imgH="2438599" progId="Prism8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5A66ACEB-FFC1-B148-81BB-36ED34A86D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7290460" y="-612907"/>
                          <a:ext cx="2960687" cy="327235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41AF83A5-3147-AFC9-B6F8-3A7F9C7358E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1452777"/>
                </p:ext>
              </p:extLst>
            </p:nvPr>
          </p:nvGraphicFramePr>
          <p:xfrm>
            <a:off x="9367363" y="1314567"/>
            <a:ext cx="540860" cy="6883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6" imgW="1731893" imgH="2202408" progId="Prism8.Document">
                    <p:embed/>
                  </p:oleObj>
                </mc:Choice>
                <mc:Fallback>
                  <p:oleObj name="Prism 8" r:id="rId26" imgW="1731893" imgH="2202408" progId="Prism8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077314AE-F5B9-D98C-9CE7-E3B0BC41E44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9367363" y="1314567"/>
                          <a:ext cx="540860" cy="6883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378D550-948E-DAC5-1986-89D2D7B752E8}"/>
              </a:ext>
            </a:extLst>
          </p:cNvPr>
          <p:cNvSpPr txBox="1"/>
          <p:nvPr/>
        </p:nvSpPr>
        <p:spPr>
          <a:xfrm>
            <a:off x="459747" y="588936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8248901-95C5-929A-2463-F799C1308018}"/>
              </a:ext>
            </a:extLst>
          </p:cNvPr>
          <p:cNvSpPr txBox="1"/>
          <p:nvPr/>
        </p:nvSpPr>
        <p:spPr>
          <a:xfrm>
            <a:off x="2539276" y="615030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797179-047D-18FD-48F8-D4755BC4199B}"/>
              </a:ext>
            </a:extLst>
          </p:cNvPr>
          <p:cNvSpPr txBox="1"/>
          <p:nvPr/>
        </p:nvSpPr>
        <p:spPr>
          <a:xfrm>
            <a:off x="2599254" y="2084702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Slide Number Placeholder 16">
            <a:extLst>
              <a:ext uri="{FF2B5EF4-FFF2-40B4-BE49-F238E27FC236}">
                <a16:creationId xmlns:a16="http://schemas.microsoft.com/office/drawing/2014/main" id="{A503A0FC-7698-DD46-91B0-81323A60E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7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34256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D37684-8882-6A66-72DA-81EE6D7AFFFB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76" name="Group 375">
            <a:extLst>
              <a:ext uri="{FF2B5EF4-FFF2-40B4-BE49-F238E27FC236}">
                <a16:creationId xmlns:a16="http://schemas.microsoft.com/office/drawing/2014/main" id="{FB06D9A3-9D39-EA92-8E40-D6EB0D0BDDBB}"/>
              </a:ext>
            </a:extLst>
          </p:cNvPr>
          <p:cNvGrpSpPr/>
          <p:nvPr/>
        </p:nvGrpSpPr>
        <p:grpSpPr>
          <a:xfrm>
            <a:off x="739964" y="2002595"/>
            <a:ext cx="1468186" cy="1786107"/>
            <a:chOff x="5607836" y="596478"/>
            <a:chExt cx="1557891" cy="2130708"/>
          </a:xfrm>
        </p:grpSpPr>
        <p:graphicFrame>
          <p:nvGraphicFramePr>
            <p:cNvPr id="377" name="Object 376">
              <a:extLst>
                <a:ext uri="{FF2B5EF4-FFF2-40B4-BE49-F238E27FC236}">
                  <a16:creationId xmlns:a16="http://schemas.microsoft.com/office/drawing/2014/main" id="{5504A519-A49B-3F54-123D-6B822C63405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5306464"/>
                </p:ext>
              </p:extLst>
            </p:nvPr>
          </p:nvGraphicFramePr>
          <p:xfrm>
            <a:off x="5607836" y="596478"/>
            <a:ext cx="1557891" cy="21307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2076543" imgH="2837892" progId="Prism8.Document">
                    <p:embed/>
                  </p:oleObj>
                </mc:Choice>
                <mc:Fallback>
                  <p:oleObj name="Prism 8" r:id="rId3" imgW="2076543" imgH="2837892" progId="Prism8.Document">
                    <p:embed/>
                    <p:pic>
                      <p:nvPicPr>
                        <p:cNvPr id="36" name="Object 35">
                          <a:extLst>
                            <a:ext uri="{FF2B5EF4-FFF2-40B4-BE49-F238E27FC236}">
                              <a16:creationId xmlns:a16="http://schemas.microsoft.com/office/drawing/2014/main" id="{4FD7E673-8FBA-6F9B-5B7A-6EC72E3D8A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607836" y="596478"/>
                          <a:ext cx="1557891" cy="21307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78" name="Picture 377">
              <a:extLst>
                <a:ext uri="{FF2B5EF4-FFF2-40B4-BE49-F238E27FC236}">
                  <a16:creationId xmlns:a16="http://schemas.microsoft.com/office/drawing/2014/main" id="{57B4B59A-5392-489F-77C9-F409986E7A7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6235077" y="613579"/>
              <a:ext cx="417978" cy="531424"/>
            </a:xfrm>
            <a:prstGeom prst="rect">
              <a:avLst/>
            </a:prstGeom>
          </p:spPr>
        </p:pic>
      </p:grpSp>
      <p:grpSp>
        <p:nvGrpSpPr>
          <p:cNvPr id="379" name="Group 378">
            <a:extLst>
              <a:ext uri="{FF2B5EF4-FFF2-40B4-BE49-F238E27FC236}">
                <a16:creationId xmlns:a16="http://schemas.microsoft.com/office/drawing/2014/main" id="{C3F70D7B-62B5-2BEC-AFB8-39BF7F6B47D6}"/>
              </a:ext>
            </a:extLst>
          </p:cNvPr>
          <p:cNvGrpSpPr/>
          <p:nvPr/>
        </p:nvGrpSpPr>
        <p:grpSpPr>
          <a:xfrm>
            <a:off x="2277749" y="2050861"/>
            <a:ext cx="1457847" cy="1726080"/>
            <a:chOff x="7609768" y="453894"/>
            <a:chExt cx="1642126" cy="2252365"/>
          </a:xfrm>
        </p:grpSpPr>
        <p:graphicFrame>
          <p:nvGraphicFramePr>
            <p:cNvPr id="380" name="Object 379">
              <a:extLst>
                <a:ext uri="{FF2B5EF4-FFF2-40B4-BE49-F238E27FC236}">
                  <a16:creationId xmlns:a16="http://schemas.microsoft.com/office/drawing/2014/main" id="{0B10ABAE-565E-863C-DC25-04D3FFE29E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02209538"/>
                </p:ext>
              </p:extLst>
            </p:nvPr>
          </p:nvGraphicFramePr>
          <p:xfrm>
            <a:off x="7609768" y="453894"/>
            <a:ext cx="1642126" cy="22523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070420" imgH="2837892" progId="Prism8.Document">
                    <p:embed/>
                  </p:oleObj>
                </mc:Choice>
                <mc:Fallback>
                  <p:oleObj name="Prism 8" r:id="rId6" imgW="2070420" imgH="2837892" progId="Prism8.Document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7E983B23-F6BC-56F3-49CB-FCFD702DF4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609768" y="453894"/>
                          <a:ext cx="1642126" cy="22523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81" name="Picture 380">
              <a:extLst>
                <a:ext uri="{FF2B5EF4-FFF2-40B4-BE49-F238E27FC236}">
                  <a16:creationId xmlns:a16="http://schemas.microsoft.com/office/drawing/2014/main" id="{9E66B5B9-9716-4ABB-8EBE-1A003C5AD40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240818" y="453894"/>
              <a:ext cx="133350" cy="531424"/>
            </a:xfrm>
            <a:prstGeom prst="rect">
              <a:avLst/>
            </a:prstGeom>
          </p:spPr>
        </p:pic>
      </p:grpSp>
      <p:grpSp>
        <p:nvGrpSpPr>
          <p:cNvPr id="382" name="Group 381">
            <a:extLst>
              <a:ext uri="{FF2B5EF4-FFF2-40B4-BE49-F238E27FC236}">
                <a16:creationId xmlns:a16="http://schemas.microsoft.com/office/drawing/2014/main" id="{A404D550-3FE9-2C9F-0CD5-8FA231238FCA}"/>
              </a:ext>
            </a:extLst>
          </p:cNvPr>
          <p:cNvGrpSpPr/>
          <p:nvPr/>
        </p:nvGrpSpPr>
        <p:grpSpPr>
          <a:xfrm>
            <a:off x="3860201" y="2062622"/>
            <a:ext cx="1527924" cy="1726080"/>
            <a:chOff x="9773435" y="545076"/>
            <a:chExt cx="1493088" cy="2130806"/>
          </a:xfrm>
        </p:grpSpPr>
        <p:graphicFrame>
          <p:nvGraphicFramePr>
            <p:cNvPr id="383" name="Object 382">
              <a:extLst>
                <a:ext uri="{FF2B5EF4-FFF2-40B4-BE49-F238E27FC236}">
                  <a16:creationId xmlns:a16="http://schemas.microsoft.com/office/drawing/2014/main" id="{4AA5695D-471B-1A96-E0B9-BC059040E38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59085018"/>
                </p:ext>
              </p:extLst>
            </p:nvPr>
          </p:nvGraphicFramePr>
          <p:xfrm>
            <a:off x="9773435" y="545076"/>
            <a:ext cx="1493088" cy="21308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1989750" imgH="2837892" progId="Prism8.Document">
                    <p:embed/>
                  </p:oleObj>
                </mc:Choice>
                <mc:Fallback>
                  <p:oleObj name="Prism 8" r:id="rId9" imgW="1989750" imgH="2837892" progId="Prism8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EB6A8685-F194-2007-626F-70EE0DE717B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773435" y="545076"/>
                          <a:ext cx="1493088" cy="21308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84" name="Picture 383">
              <a:extLst>
                <a:ext uri="{FF2B5EF4-FFF2-40B4-BE49-F238E27FC236}">
                  <a16:creationId xmlns:a16="http://schemas.microsoft.com/office/drawing/2014/main" id="{0ABC88DC-D394-30F7-D755-77850B3B8CA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10282600" y="552554"/>
              <a:ext cx="474759" cy="531424"/>
            </a:xfrm>
            <a:prstGeom prst="rect">
              <a:avLst/>
            </a:prstGeom>
          </p:spPr>
        </p:pic>
      </p:grpSp>
      <p:grpSp>
        <p:nvGrpSpPr>
          <p:cNvPr id="400" name="Group 399">
            <a:extLst>
              <a:ext uri="{FF2B5EF4-FFF2-40B4-BE49-F238E27FC236}">
                <a16:creationId xmlns:a16="http://schemas.microsoft.com/office/drawing/2014/main" id="{A20AADB0-D275-00FF-6AF7-34E2298E4E45}"/>
              </a:ext>
            </a:extLst>
          </p:cNvPr>
          <p:cNvGrpSpPr/>
          <p:nvPr/>
        </p:nvGrpSpPr>
        <p:grpSpPr>
          <a:xfrm>
            <a:off x="2476994" y="742473"/>
            <a:ext cx="1630773" cy="1179002"/>
            <a:chOff x="945117" y="3739023"/>
            <a:chExt cx="3754877" cy="2864388"/>
          </a:xfrm>
        </p:grpSpPr>
        <p:pic>
          <p:nvPicPr>
            <p:cNvPr id="401" name="Picture 400">
              <a:extLst>
                <a:ext uri="{FF2B5EF4-FFF2-40B4-BE49-F238E27FC236}">
                  <a16:creationId xmlns:a16="http://schemas.microsoft.com/office/drawing/2014/main" id="{812C56F6-D48B-8F1A-EEB3-E0EA13B93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945117" y="3739023"/>
              <a:ext cx="3754876" cy="700392"/>
            </a:xfrm>
            <a:prstGeom prst="rect">
              <a:avLst/>
            </a:prstGeom>
            <a:ln w="28575">
              <a:solidFill>
                <a:schemeClr val="accent1">
                  <a:lumMod val="75000"/>
                </a:schemeClr>
              </a:solidFill>
            </a:ln>
          </p:spPr>
        </p:pic>
        <p:pic>
          <p:nvPicPr>
            <p:cNvPr id="402" name="Picture 401">
              <a:extLst>
                <a:ext uri="{FF2B5EF4-FFF2-40B4-BE49-F238E27FC236}">
                  <a16:creationId xmlns:a16="http://schemas.microsoft.com/office/drawing/2014/main" id="{23B70403-17D3-44F1-4AFC-314CDF818C5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945117" y="4589755"/>
              <a:ext cx="3754875" cy="825078"/>
            </a:xfrm>
            <a:prstGeom prst="rect">
              <a:avLst/>
            </a:prstGeom>
            <a:ln w="28575">
              <a:solidFill>
                <a:schemeClr val="accent1">
                  <a:lumMod val="75000"/>
                </a:schemeClr>
              </a:solidFill>
            </a:ln>
          </p:spPr>
        </p:pic>
        <p:pic>
          <p:nvPicPr>
            <p:cNvPr id="403" name="Picture 402">
              <a:extLst>
                <a:ext uri="{FF2B5EF4-FFF2-40B4-BE49-F238E27FC236}">
                  <a16:creationId xmlns:a16="http://schemas.microsoft.com/office/drawing/2014/main" id="{E33B306E-BDEF-0DF5-0D06-8EEDE9C379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6200000">
              <a:off x="2317927" y="4221345"/>
              <a:ext cx="1009259" cy="3754874"/>
            </a:xfrm>
            <a:prstGeom prst="rect">
              <a:avLst/>
            </a:prstGeom>
            <a:ln w="28575">
              <a:solidFill>
                <a:schemeClr val="accent1">
                  <a:lumMod val="75000"/>
                </a:schemeClr>
              </a:solidFill>
            </a:ln>
          </p:spPr>
        </p:pic>
      </p:grpSp>
      <p:grpSp>
        <p:nvGrpSpPr>
          <p:cNvPr id="404" name="Group 403">
            <a:extLst>
              <a:ext uri="{FF2B5EF4-FFF2-40B4-BE49-F238E27FC236}">
                <a16:creationId xmlns:a16="http://schemas.microsoft.com/office/drawing/2014/main" id="{A00FA738-0D7E-C1EC-B753-187B171491C5}"/>
              </a:ext>
            </a:extLst>
          </p:cNvPr>
          <p:cNvGrpSpPr/>
          <p:nvPr/>
        </p:nvGrpSpPr>
        <p:grpSpPr>
          <a:xfrm>
            <a:off x="797386" y="724176"/>
            <a:ext cx="1535297" cy="1184534"/>
            <a:chOff x="886515" y="1333541"/>
            <a:chExt cx="1936040" cy="1483206"/>
          </a:xfrm>
        </p:grpSpPr>
        <p:pic>
          <p:nvPicPr>
            <p:cNvPr id="405" name="Picture 404">
              <a:extLst>
                <a:ext uri="{FF2B5EF4-FFF2-40B4-BE49-F238E27FC236}">
                  <a16:creationId xmlns:a16="http://schemas.microsoft.com/office/drawing/2014/main" id="{0DA73BDE-0119-7A3E-614A-46586AD85B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6200000">
              <a:off x="1665688" y="554368"/>
              <a:ext cx="366811" cy="1925158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</a:ln>
          </p:spPr>
        </p:pic>
        <p:pic>
          <p:nvPicPr>
            <p:cNvPr id="406" name="Picture 405">
              <a:extLst>
                <a:ext uri="{FF2B5EF4-FFF2-40B4-BE49-F238E27FC236}">
                  <a16:creationId xmlns:a16="http://schemas.microsoft.com/office/drawing/2014/main" id="{57767E6C-8D24-8BB1-764F-5AF9EAA6BB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6200000">
              <a:off x="1614919" y="1066378"/>
              <a:ext cx="481048" cy="1925159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</a:ln>
          </p:spPr>
        </p:pic>
        <p:pic>
          <p:nvPicPr>
            <p:cNvPr id="407" name="Picture 406">
              <a:extLst>
                <a:ext uri="{FF2B5EF4-FFF2-40B4-BE49-F238E27FC236}">
                  <a16:creationId xmlns:a16="http://schemas.microsoft.com/office/drawing/2014/main" id="{2C513414-BD16-1A98-302A-9C3323D4F2D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6200000">
              <a:off x="1632092" y="1626284"/>
              <a:ext cx="455768" cy="1925158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</a:ln>
          </p:spPr>
        </p:pic>
      </p:grpSp>
      <p:grpSp>
        <p:nvGrpSpPr>
          <p:cNvPr id="408" name="Group 407">
            <a:extLst>
              <a:ext uri="{FF2B5EF4-FFF2-40B4-BE49-F238E27FC236}">
                <a16:creationId xmlns:a16="http://schemas.microsoft.com/office/drawing/2014/main" id="{84B79A9D-9421-D054-9949-EA04BF54846A}"/>
              </a:ext>
            </a:extLst>
          </p:cNvPr>
          <p:cNvGrpSpPr/>
          <p:nvPr/>
        </p:nvGrpSpPr>
        <p:grpSpPr>
          <a:xfrm>
            <a:off x="4267750" y="736140"/>
            <a:ext cx="1576994" cy="1191776"/>
            <a:chOff x="816038" y="2777067"/>
            <a:chExt cx="3861980" cy="3035438"/>
          </a:xfrm>
        </p:grpSpPr>
        <p:pic>
          <p:nvPicPr>
            <p:cNvPr id="409" name="Picture 408">
              <a:extLst>
                <a:ext uri="{FF2B5EF4-FFF2-40B4-BE49-F238E27FC236}">
                  <a16:creationId xmlns:a16="http://schemas.microsoft.com/office/drawing/2014/main" id="{CCBD882B-E834-E930-546E-39EE7BF239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68018" y="2777067"/>
              <a:ext cx="3810000" cy="728133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  <a:prstDash val="sysDash"/>
            </a:ln>
          </p:spPr>
        </p:pic>
        <p:pic>
          <p:nvPicPr>
            <p:cNvPr id="410" name="Picture 409">
              <a:extLst>
                <a:ext uri="{FF2B5EF4-FFF2-40B4-BE49-F238E27FC236}">
                  <a16:creationId xmlns:a16="http://schemas.microsoft.com/office/drawing/2014/main" id="{B06E18E7-D8A7-B580-E804-6878498E1C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42028" y="3685185"/>
              <a:ext cx="3810000" cy="840154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  <a:prstDash val="sysDash"/>
            </a:ln>
          </p:spPr>
        </p:pic>
        <p:pic>
          <p:nvPicPr>
            <p:cNvPr id="411" name="Picture 410">
              <a:extLst>
                <a:ext uri="{FF2B5EF4-FFF2-40B4-BE49-F238E27FC236}">
                  <a16:creationId xmlns:a16="http://schemas.microsoft.com/office/drawing/2014/main" id="{4033F155-0173-F1E5-CADB-D70734467F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5400000">
              <a:off x="2180442" y="3340920"/>
              <a:ext cx="1107181" cy="3835989"/>
            </a:xfrm>
            <a:prstGeom prst="rect">
              <a:avLst/>
            </a:prstGeom>
            <a:ln w="28575">
              <a:solidFill>
                <a:schemeClr val="accent3">
                  <a:lumMod val="50000"/>
                </a:schemeClr>
              </a:solidFill>
              <a:prstDash val="sysDash"/>
            </a:ln>
          </p:spPr>
        </p:pic>
      </p:grpSp>
      <p:sp>
        <p:nvSpPr>
          <p:cNvPr id="416" name="TextBox 415">
            <a:extLst>
              <a:ext uri="{FF2B5EF4-FFF2-40B4-BE49-F238E27FC236}">
                <a16:creationId xmlns:a16="http://schemas.microsoft.com/office/drawing/2014/main" id="{4C28099C-0D49-AB51-6C1C-CAE493F03BA1}"/>
              </a:ext>
            </a:extLst>
          </p:cNvPr>
          <p:cNvSpPr txBox="1"/>
          <p:nvPr/>
        </p:nvSpPr>
        <p:spPr>
          <a:xfrm>
            <a:off x="425876" y="6024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EA7A3E3E-4D62-9901-5297-2C1F1B39079B}"/>
              </a:ext>
            </a:extLst>
          </p:cNvPr>
          <p:cNvSpPr txBox="1"/>
          <p:nvPr/>
        </p:nvSpPr>
        <p:spPr>
          <a:xfrm>
            <a:off x="437516" y="197256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6D3F7D34-EFCE-0641-C587-BCBF09A52734}"/>
              </a:ext>
            </a:extLst>
          </p:cNvPr>
          <p:cNvSpPr txBox="1"/>
          <p:nvPr/>
        </p:nvSpPr>
        <p:spPr>
          <a:xfrm>
            <a:off x="437516" y="7843796"/>
            <a:ext cx="599657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: Methionine-supplemented mice had a limited impact on tissue pathology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ss tissue pathology for the three mouse groups at 21 dpi. B. Tissue weights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mouse groups at 21 dp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 histology scoring and representative imag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logy scoring for spleen and liver, respectively, after H&amp;E staining. One-way ANOVA with Tukey’s multiple comparisons is used, CT: control, MS: methionine supplemented, MS to CT: Methionine supplemented for 2 weeks, then shifted to control pos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p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weeks post-dosing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p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weeks post-infection, H&amp;E: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atoxylin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osin staining</a:t>
            </a:r>
            <a:r>
              <a:rPr lang="en-IN" sz="1200" dirty="0"/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logy images are collected at 20</a:t>
            </a:r>
            <a:r>
              <a:rPr lang="en-US" sz="1200" dirty="0">
                <a:cs typeface="Times New Roman" panose="02020603050405020304" pitchFamily="18" charset="0"/>
              </a:rPr>
              <a:t>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gnification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645D0DE-6E91-F6B4-1DA6-CCC81BE1EE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5732114"/>
              </p:ext>
            </p:extLst>
          </p:nvPr>
        </p:nvGraphicFramePr>
        <p:xfrm>
          <a:off x="806015" y="3646295"/>
          <a:ext cx="1508125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2628270" imgH="2670470" progId="Prism8.Document">
                  <p:embed/>
                </p:oleObj>
              </mc:Choice>
              <mc:Fallback>
                <p:oleObj name="Prism 8" r:id="rId21" imgW="2628270" imgH="2670470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D825EC2-4219-597D-D4BF-1AF31B0826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06015" y="3646295"/>
                        <a:ext cx="1508125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D4504AD-2052-3962-8E6D-FC4D1254B1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6665802"/>
              </p:ext>
            </p:extLst>
          </p:nvPr>
        </p:nvGraphicFramePr>
        <p:xfrm>
          <a:off x="2370235" y="3582916"/>
          <a:ext cx="1506537" cy="174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2648078" imgH="3063641" progId="Prism8.Document">
                  <p:embed/>
                </p:oleObj>
              </mc:Choice>
              <mc:Fallback>
                <p:oleObj name="Prism 8" r:id="rId23" imgW="2648078" imgH="3063641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8D8DD0D-B49E-62F5-1FDA-CDBFE33A74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370235" y="3582916"/>
                        <a:ext cx="1506537" cy="1743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8A20EE8-7D47-0C31-0EDD-FFAFE491D6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0292572"/>
              </p:ext>
            </p:extLst>
          </p:nvPr>
        </p:nvGraphicFramePr>
        <p:xfrm>
          <a:off x="5266835" y="6337218"/>
          <a:ext cx="1371173" cy="15817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5" imgW="2460807" imgH="2837892" progId="Prism8.Document">
                  <p:embed/>
                </p:oleObj>
              </mc:Choice>
              <mc:Fallback>
                <p:oleObj name="Prism 8" r:id="rId25" imgW="2460807" imgH="2837892" progId="Prism8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2FA3F609-1E84-C112-BC02-3A71EF3593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266835" y="6337218"/>
                        <a:ext cx="1371173" cy="15817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744A481-9279-2C5B-407D-6186FDF2BD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1638604"/>
              </p:ext>
            </p:extLst>
          </p:nvPr>
        </p:nvGraphicFramePr>
        <p:xfrm>
          <a:off x="744281" y="6419548"/>
          <a:ext cx="1342264" cy="15483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7" imgW="2460807" imgH="2837892" progId="Prism8.Document">
                  <p:embed/>
                </p:oleObj>
              </mc:Choice>
              <mc:Fallback>
                <p:oleObj name="Prism 8" r:id="rId27" imgW="2460807" imgH="283789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C1982F4-1BE5-05D6-9AAD-96DCA95503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744281" y="6419548"/>
                        <a:ext cx="1342264" cy="15483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30CEBF5-EE0F-C897-4FA2-82F759FF97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3595041"/>
              </p:ext>
            </p:extLst>
          </p:nvPr>
        </p:nvGraphicFramePr>
        <p:xfrm>
          <a:off x="2086545" y="6369614"/>
          <a:ext cx="1342864" cy="15483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9" imgW="2460807" imgH="2837892" progId="Prism8.Document">
                  <p:embed/>
                </p:oleObj>
              </mc:Choice>
              <mc:Fallback>
                <p:oleObj name="Prism 8" r:id="rId29" imgW="2460807" imgH="2837892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CB5AFBF-AD3E-67AC-3C3A-9081119E54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086545" y="6369614"/>
                        <a:ext cx="1342864" cy="15483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0" name="Group 9">
            <a:extLst>
              <a:ext uri="{FF2B5EF4-FFF2-40B4-BE49-F238E27FC236}">
                <a16:creationId xmlns:a16="http://schemas.microsoft.com/office/drawing/2014/main" id="{6AB2FDEF-CA8F-9558-C474-808B89D7D1D8}"/>
              </a:ext>
            </a:extLst>
          </p:cNvPr>
          <p:cNvGrpSpPr/>
          <p:nvPr/>
        </p:nvGrpSpPr>
        <p:grpSpPr>
          <a:xfrm>
            <a:off x="5327222" y="3651439"/>
            <a:ext cx="1310786" cy="1163810"/>
            <a:chOff x="382281" y="2972852"/>
            <a:chExt cx="1561954" cy="101625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819DAA1-D76E-B35E-63C6-1B4449A551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98366" y="3144150"/>
              <a:ext cx="1245869" cy="812005"/>
            </a:xfrm>
            <a:prstGeom prst="rect">
              <a:avLst/>
            </a:prstGeom>
            <a:ln w="38100">
              <a:solidFill>
                <a:schemeClr val="accent1">
                  <a:lumMod val="75000"/>
                </a:schemeClr>
              </a:solidFill>
            </a:ln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BFE4AB-796D-5A53-4585-CFDBDFD46FB4}"/>
                </a:ext>
              </a:extLst>
            </p:cNvPr>
            <p:cNvSpPr txBox="1"/>
            <p:nvPr/>
          </p:nvSpPr>
          <p:spPr>
            <a:xfrm rot="16200000">
              <a:off x="68007" y="3287126"/>
              <a:ext cx="1016257" cy="3877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: 2 wpd</a:t>
              </a:r>
              <a:endParaRPr lang="en-IN" sz="12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E287586-843D-6D30-9642-12FCE72B5918}"/>
              </a:ext>
            </a:extLst>
          </p:cNvPr>
          <p:cNvGrpSpPr/>
          <p:nvPr/>
        </p:nvGrpSpPr>
        <p:grpSpPr>
          <a:xfrm>
            <a:off x="3883438" y="3688354"/>
            <a:ext cx="1308621" cy="1086194"/>
            <a:chOff x="337461" y="2899322"/>
            <a:chExt cx="1606767" cy="105683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3B28FB5-CDF0-B7B1-75AB-226B6E22F2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98362" y="3118586"/>
              <a:ext cx="1245866" cy="837571"/>
            </a:xfrm>
            <a:prstGeom prst="rect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8686038-A680-B1A6-7021-B736E2574E8C}"/>
                </a:ext>
              </a:extLst>
            </p:cNvPr>
            <p:cNvSpPr txBox="1"/>
            <p:nvPr/>
          </p:nvSpPr>
          <p:spPr>
            <a:xfrm rot="16200000">
              <a:off x="47908" y="3188875"/>
              <a:ext cx="1013607" cy="4345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2">
                      <a:lumMod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: 2 wpd</a:t>
              </a:r>
              <a:endParaRPr lang="en-IN" sz="1200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AC4FEA4B-166C-5CBE-399A-AA86F245FDBB}"/>
              </a:ext>
            </a:extLst>
          </p:cNvPr>
          <p:cNvGrpSpPr/>
          <p:nvPr/>
        </p:nvGrpSpPr>
        <p:grpSpPr>
          <a:xfrm>
            <a:off x="924892" y="5298910"/>
            <a:ext cx="1552102" cy="985178"/>
            <a:chOff x="403040" y="3118585"/>
            <a:chExt cx="1541193" cy="83757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051D5045-51C4-62A3-C5A9-41BF2CCC7E68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98365" y="3118585"/>
              <a:ext cx="1245868" cy="837571"/>
            </a:xfrm>
            <a:prstGeom prst="rect">
              <a:avLst/>
            </a:prstGeom>
            <a:ln w="38100">
              <a:solidFill>
                <a:schemeClr val="bg2">
                  <a:lumMod val="50000"/>
                </a:schemeClr>
              </a:solidFill>
            </a:ln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17A2986-5E90-4020-EE0F-DA4AF9FC09EE}"/>
                </a:ext>
              </a:extLst>
            </p:cNvPr>
            <p:cNvSpPr txBox="1"/>
            <p:nvPr/>
          </p:nvSpPr>
          <p:spPr>
            <a:xfrm rot="16200000">
              <a:off x="146663" y="3410394"/>
              <a:ext cx="727610" cy="2148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2">
                      <a:lumMod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: 3 wpi</a:t>
              </a:r>
              <a:endParaRPr lang="en-IN" sz="1200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73CD0D99-8B30-72B8-40B9-8D060D998E71}"/>
              </a:ext>
            </a:extLst>
          </p:cNvPr>
          <p:cNvGrpSpPr/>
          <p:nvPr/>
        </p:nvGrpSpPr>
        <p:grpSpPr>
          <a:xfrm>
            <a:off x="2524207" y="5076966"/>
            <a:ext cx="1575163" cy="1207825"/>
            <a:chOff x="380142" y="2929297"/>
            <a:chExt cx="1564092" cy="1026859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DAB1275F-D188-62E6-B543-2A0D1F69EA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98364" y="3118585"/>
              <a:ext cx="1245870" cy="837571"/>
            </a:xfrm>
            <a:prstGeom prst="rect">
              <a:avLst/>
            </a:prstGeom>
            <a:ln w="38100">
              <a:solidFill>
                <a:schemeClr val="accent1">
                  <a:lumMod val="75000"/>
                </a:schemeClr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71BA026-98DC-C9E6-2DA0-CFC58F770722}"/>
                </a:ext>
              </a:extLst>
            </p:cNvPr>
            <p:cNvSpPr txBox="1"/>
            <p:nvPr/>
          </p:nvSpPr>
          <p:spPr>
            <a:xfrm rot="16200000">
              <a:off x="44437" y="3265002"/>
              <a:ext cx="946461" cy="2750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: 3 wpi</a:t>
              </a:r>
              <a:endParaRPr lang="en-IN" sz="12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77AC845-4D9B-C044-5DEC-72F3F83B0880}"/>
              </a:ext>
            </a:extLst>
          </p:cNvPr>
          <p:cNvGrpSpPr/>
          <p:nvPr/>
        </p:nvGrpSpPr>
        <p:grpSpPr>
          <a:xfrm>
            <a:off x="4264229" y="4760672"/>
            <a:ext cx="1582489" cy="1614537"/>
            <a:chOff x="372868" y="2716194"/>
            <a:chExt cx="1571360" cy="1372634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D8CAE80-4EE5-CD77-707B-B71BEF8292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98363" y="3118585"/>
              <a:ext cx="1245865" cy="837571"/>
            </a:xfrm>
            <a:prstGeom prst="rect">
              <a:avLst/>
            </a:prstGeom>
            <a:ln w="38100">
              <a:solidFill>
                <a:schemeClr val="bg2">
                  <a:lumMod val="50000"/>
                </a:schemeClr>
              </a:solidFill>
              <a:prstDash val="sysDash"/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5D03584-8ADB-E025-B7C6-6BD3D7577E6B}"/>
                </a:ext>
              </a:extLst>
            </p:cNvPr>
            <p:cNvSpPr txBox="1"/>
            <p:nvPr/>
          </p:nvSpPr>
          <p:spPr>
            <a:xfrm rot="16200000">
              <a:off x="-175923" y="3264985"/>
              <a:ext cx="1372634" cy="2750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2">
                      <a:lumMod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 to CT: 3 wpi</a:t>
              </a:r>
              <a:endParaRPr lang="en-IN" sz="1200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5C4F40A4-0140-5F83-684D-ED0DB3A1BF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4792365"/>
              </p:ext>
            </p:extLst>
          </p:nvPr>
        </p:nvGraphicFramePr>
        <p:xfrm>
          <a:off x="3848085" y="6380822"/>
          <a:ext cx="1371173" cy="1581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6" imgW="2462248" imgH="2837892" progId="Prism8.Document">
                  <p:embed/>
                </p:oleObj>
              </mc:Choice>
              <mc:Fallback>
                <p:oleObj name="Prism 8" r:id="rId36" imgW="2462248" imgH="2837892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060A2BF3-65F6-D5E7-1E9F-E8D245C0C0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3848085" y="6380822"/>
                        <a:ext cx="1371173" cy="15817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806E3B89-D3EF-6106-F03B-B12171E714C9}"/>
              </a:ext>
            </a:extLst>
          </p:cNvPr>
          <p:cNvSpPr txBox="1"/>
          <p:nvPr/>
        </p:nvSpPr>
        <p:spPr>
          <a:xfrm>
            <a:off x="437516" y="3697337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A4C3218-1912-218F-4C8C-18690EE871FE}"/>
              </a:ext>
            </a:extLst>
          </p:cNvPr>
          <p:cNvSpPr txBox="1"/>
          <p:nvPr/>
        </p:nvSpPr>
        <p:spPr>
          <a:xfrm>
            <a:off x="516889" y="6315581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747799-8D59-BEC4-9EBA-F53EF6D9AB76}"/>
              </a:ext>
            </a:extLst>
          </p:cNvPr>
          <p:cNvSpPr txBox="1"/>
          <p:nvPr/>
        </p:nvSpPr>
        <p:spPr>
          <a:xfrm>
            <a:off x="3724117" y="6340246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C56417-4838-F24B-AF3A-01EE131A9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2671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3EFCE2-4A50-F738-A982-2BD7CCDB2812}"/>
              </a:ext>
            </a:extLst>
          </p:cNvPr>
          <p:cNvSpPr txBox="1"/>
          <p:nvPr/>
        </p:nvSpPr>
        <p:spPr>
          <a:xfrm>
            <a:off x="349601" y="338031"/>
            <a:ext cx="3820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8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DE50529-C584-B354-1FB1-09BEC7B67140}"/>
              </a:ext>
            </a:extLst>
          </p:cNvPr>
          <p:cNvSpPr txBox="1"/>
          <p:nvPr/>
        </p:nvSpPr>
        <p:spPr>
          <a:xfrm>
            <a:off x="425876" y="4960294"/>
            <a:ext cx="56944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8: Quality of the whole cell lysate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37Rv preparation used in this study. 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ver-stained gel imag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CL used for stimulating splenocytes for monitor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cytokine respons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portions of TNF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macrophages and IFN-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activated CD4+ T-cells after 12 hours of stimulation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CL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plots for the intracellular staining experiment. One-way ANOVA with Tukey’s multiple comparisons is used, WCL: whole cell lysate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cobacterium tuberculosis,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 value&lt; 0.0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&lt;0.01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&lt;0.001 at 95% confidence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AA41A31-A2E8-6427-F4BA-F7CA9EC6878E}"/>
              </a:ext>
            </a:extLst>
          </p:cNvPr>
          <p:cNvSpPr txBox="1"/>
          <p:nvPr/>
        </p:nvSpPr>
        <p:spPr>
          <a:xfrm>
            <a:off x="425876" y="602489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F4D2D55-9209-7976-0BA6-E563A93FF610}"/>
              </a:ext>
            </a:extLst>
          </p:cNvPr>
          <p:cNvSpPr txBox="1"/>
          <p:nvPr/>
        </p:nvSpPr>
        <p:spPr>
          <a:xfrm>
            <a:off x="2309749" y="581005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869AC26-8557-2781-F0EA-1E42EC909DAE}"/>
              </a:ext>
            </a:extLst>
          </p:cNvPr>
          <p:cNvSpPr txBox="1"/>
          <p:nvPr/>
        </p:nvSpPr>
        <p:spPr>
          <a:xfrm>
            <a:off x="425875" y="2510662"/>
            <a:ext cx="518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D8DCCAF-CCC2-6EB8-9FC0-D4E347A3B7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3033629"/>
              </p:ext>
            </p:extLst>
          </p:nvPr>
        </p:nvGraphicFramePr>
        <p:xfrm>
          <a:off x="3658557" y="838917"/>
          <a:ext cx="1191841" cy="1512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160454" imgH="2742119" progId="Prism8.Document">
                  <p:embed/>
                </p:oleObj>
              </mc:Choice>
              <mc:Fallback>
                <p:oleObj name="Prism 8" r:id="rId2" imgW="2160454" imgH="2742119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723544F1-7A06-B19E-5E68-C3899F16A5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58557" y="838917"/>
                        <a:ext cx="1191841" cy="1512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37E658F-AD91-5C2B-C796-44A9CD1C00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3822283"/>
              </p:ext>
            </p:extLst>
          </p:nvPr>
        </p:nvGraphicFramePr>
        <p:xfrm>
          <a:off x="2537364" y="792252"/>
          <a:ext cx="1131888" cy="156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021442" imgH="2796846" progId="Prism8.Document">
                  <p:embed/>
                </p:oleObj>
              </mc:Choice>
              <mc:Fallback>
                <p:oleObj name="Prism 8" r:id="rId4" imgW="2021442" imgH="2796846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3AA4F3E4-7159-3ED8-D2D9-082754BE60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37364" y="792252"/>
                        <a:ext cx="1131888" cy="156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2" name="Group 31">
            <a:extLst>
              <a:ext uri="{FF2B5EF4-FFF2-40B4-BE49-F238E27FC236}">
                <a16:creationId xmlns:a16="http://schemas.microsoft.com/office/drawing/2014/main" id="{676584BC-A67F-1ED8-D571-A15CD616302F}"/>
              </a:ext>
            </a:extLst>
          </p:cNvPr>
          <p:cNvGrpSpPr/>
          <p:nvPr/>
        </p:nvGrpSpPr>
        <p:grpSpPr>
          <a:xfrm>
            <a:off x="651504" y="2654746"/>
            <a:ext cx="2688065" cy="2267501"/>
            <a:chOff x="4432750" y="5064030"/>
            <a:chExt cx="2320784" cy="1815639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A90A3FF3-476A-DD3B-74EA-BC0AC7172C1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00733" y="5221924"/>
              <a:ext cx="660833" cy="569604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204136AD-EC10-DDFB-4508-4EC7E5A9557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332519" y="5221924"/>
              <a:ext cx="663400" cy="562707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431506BA-9BEC-8D8E-6C49-89F4BBBD07E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71569" y="5222140"/>
              <a:ext cx="634976" cy="562491"/>
            </a:xfrm>
            <a:prstGeom prst="rect">
              <a:avLst/>
            </a:prstGeom>
          </p:spPr>
        </p:pic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0947A47-9C32-A8E0-B9A4-AE5323AB4D63}"/>
                </a:ext>
              </a:extLst>
            </p:cNvPr>
            <p:cNvGrpSpPr/>
            <p:nvPr/>
          </p:nvGrpSpPr>
          <p:grpSpPr>
            <a:xfrm>
              <a:off x="4432750" y="5274592"/>
              <a:ext cx="764620" cy="735994"/>
              <a:chOff x="4432750" y="5274592"/>
              <a:chExt cx="764620" cy="735994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20060ADE-4382-272D-6929-02A27D5E0EB2}"/>
                  </a:ext>
                </a:extLst>
              </p:cNvPr>
              <p:cNvSpPr txBox="1"/>
              <p:nvPr/>
            </p:nvSpPr>
            <p:spPr>
              <a:xfrm rot="16200000">
                <a:off x="4309872" y="5397470"/>
                <a:ext cx="4304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/>
                  <a:t>F4/80</a:t>
                </a:r>
                <a:endParaRPr lang="en-IN" sz="600" b="1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EDEC7B3-19EF-68F6-3B06-39E16378C14E}"/>
                  </a:ext>
                </a:extLst>
              </p:cNvPr>
              <p:cNvSpPr txBox="1"/>
              <p:nvPr/>
            </p:nvSpPr>
            <p:spPr>
              <a:xfrm>
                <a:off x="4720464" y="5764365"/>
                <a:ext cx="4769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/>
                  <a:t>TNF-</a:t>
                </a:r>
                <a:r>
                  <a:rPr lang="el-GR" sz="1000" dirty="0"/>
                  <a:t>α</a:t>
                </a:r>
                <a:endParaRPr lang="en-IN" sz="1000" dirty="0"/>
              </a:p>
            </p:txBody>
          </p:sp>
          <p:cxnSp>
            <p:nvCxnSpPr>
              <p:cNvPr id="50" name="Connector: Elbow 49">
                <a:extLst>
                  <a:ext uri="{FF2B5EF4-FFF2-40B4-BE49-F238E27FC236}">
                    <a16:creationId xmlns:a16="http://schemas.microsoft.com/office/drawing/2014/main" id="{7E2480B9-E080-5480-B6D9-CD41F3F9439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4542831" y="5662106"/>
                <a:ext cx="203966" cy="195382"/>
              </a:xfrm>
              <a:prstGeom prst="bentConnector2">
                <a:avLst/>
              </a:prstGeom>
              <a:ln w="9525">
                <a:solidFill>
                  <a:schemeClr val="tx1"/>
                </a:solidFill>
                <a:headEnd type="triangl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548AC36-E14A-36C9-6586-5316983E18BA}"/>
                </a:ext>
              </a:extLst>
            </p:cNvPr>
            <p:cNvSpPr txBox="1"/>
            <p:nvPr/>
          </p:nvSpPr>
          <p:spPr>
            <a:xfrm>
              <a:off x="4757932" y="5065814"/>
              <a:ext cx="43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2">
                      <a:lumMod val="50000"/>
                    </a:schemeClr>
                  </a:solidFill>
                </a:rPr>
                <a:t>CT</a:t>
              </a:r>
              <a:endParaRPr lang="en-IN" sz="600" b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72742CD-9CFD-23B3-CE0E-55ABBA178456}"/>
                </a:ext>
              </a:extLst>
            </p:cNvPr>
            <p:cNvSpPr txBox="1"/>
            <p:nvPr/>
          </p:nvSpPr>
          <p:spPr>
            <a:xfrm>
              <a:off x="5508898" y="5065814"/>
              <a:ext cx="43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accent5">
                      <a:lumMod val="75000"/>
                    </a:schemeClr>
                  </a:solidFill>
                </a:rPr>
                <a:t>MS</a:t>
              </a:r>
              <a:endParaRPr lang="en-IN" sz="6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CA3AF16-F6BD-B5C1-C43A-28FFE837DA9B}"/>
                </a:ext>
              </a:extLst>
            </p:cNvPr>
            <p:cNvSpPr txBox="1"/>
            <p:nvPr/>
          </p:nvSpPr>
          <p:spPr>
            <a:xfrm>
              <a:off x="6159724" y="5064030"/>
              <a:ext cx="59381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2">
                      <a:lumMod val="50000"/>
                    </a:schemeClr>
                  </a:solidFill>
                </a:rPr>
                <a:t>MS to CT</a:t>
              </a:r>
              <a:endParaRPr lang="en-IN" sz="600" b="1" dirty="0">
                <a:solidFill>
                  <a:schemeClr val="bg2">
                    <a:lumMod val="50000"/>
                  </a:schemeClr>
                </a:solidFill>
              </a:endParaRP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67E46E8F-4765-74CB-AF12-84759C35FC87}"/>
                </a:ext>
              </a:extLst>
            </p:cNvPr>
            <p:cNvGrpSpPr/>
            <p:nvPr/>
          </p:nvGrpSpPr>
          <p:grpSpPr>
            <a:xfrm>
              <a:off x="4440017" y="6011090"/>
              <a:ext cx="2279313" cy="868579"/>
              <a:chOff x="4440017" y="6011090"/>
              <a:chExt cx="2279313" cy="868579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230F6F5B-7674-AF5C-239B-EBE80257DA8B}"/>
                  </a:ext>
                </a:extLst>
              </p:cNvPr>
              <p:cNvGrpSpPr/>
              <p:nvPr/>
            </p:nvGrpSpPr>
            <p:grpSpPr>
              <a:xfrm>
                <a:off x="4440017" y="6143675"/>
                <a:ext cx="764620" cy="735994"/>
                <a:chOff x="4432750" y="5274592"/>
                <a:chExt cx="764620" cy="735994"/>
              </a:xfrm>
            </p:grpSpPr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957B7243-9237-1A20-38DE-7FBBBBFC3645}"/>
                    </a:ext>
                  </a:extLst>
                </p:cNvPr>
                <p:cNvSpPr txBox="1"/>
                <p:nvPr/>
              </p:nvSpPr>
              <p:spPr>
                <a:xfrm rot="16200000">
                  <a:off x="4309872" y="5397470"/>
                  <a:ext cx="43042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/>
                    <a:t>CD44</a:t>
                  </a:r>
                  <a:endParaRPr lang="en-IN" sz="600" b="1" dirty="0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00D441AF-CAB2-8194-B674-7B1D1311AACB}"/>
                    </a:ext>
                  </a:extLst>
                </p:cNvPr>
                <p:cNvSpPr txBox="1"/>
                <p:nvPr/>
              </p:nvSpPr>
              <p:spPr>
                <a:xfrm>
                  <a:off x="4720464" y="5764365"/>
                  <a:ext cx="47690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/>
                    <a:t>IFN-</a:t>
                  </a:r>
                  <a:r>
                    <a:rPr lang="el-GR" sz="1000" dirty="0"/>
                    <a:t>γ</a:t>
                  </a:r>
                  <a:endParaRPr lang="en-IN" sz="1000" dirty="0"/>
                </a:p>
              </p:txBody>
            </p:sp>
            <p:cxnSp>
              <p:nvCxnSpPr>
                <p:cNvPr id="47" name="Connector: Elbow 46">
                  <a:extLst>
                    <a:ext uri="{FF2B5EF4-FFF2-40B4-BE49-F238E27FC236}">
                      <a16:creationId xmlns:a16="http://schemas.microsoft.com/office/drawing/2014/main" id="{95A4903C-E301-FE45-82E0-2F6E021AA3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 flipH="1">
                  <a:off x="4542831" y="5662106"/>
                  <a:ext cx="203966" cy="195382"/>
                </a:xfrm>
                <a:prstGeom prst="bentConnector2">
                  <a:avLst/>
                </a:prstGeom>
                <a:ln w="9525">
                  <a:solidFill>
                    <a:schemeClr val="tx1"/>
                  </a:solidFill>
                  <a:headEnd type="triangl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040A0032-48BB-708E-A467-B6A8886985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106312" y="6018548"/>
                <a:ext cx="613018" cy="607299"/>
              </a:xfrm>
              <a:prstGeom prst="rect">
                <a:avLst/>
              </a:prstGeom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2242ABC1-3C80-BA75-45CC-66E6C47CA5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356322" y="6011090"/>
                <a:ext cx="639597" cy="631274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8797F2B0-DC2A-8015-61C8-8B71D8FBC7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44279" y="6015282"/>
                <a:ext cx="617287" cy="616126"/>
              </a:xfrm>
              <a:prstGeom prst="rect">
                <a:avLst/>
              </a:prstGeom>
            </p:spPr>
          </p:pic>
        </p:grp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859245E9-92D4-FBF6-CDB3-01B9454F800C}"/>
              </a:ext>
            </a:extLst>
          </p:cNvPr>
          <p:cNvGrpSpPr/>
          <p:nvPr/>
        </p:nvGrpSpPr>
        <p:grpSpPr>
          <a:xfrm>
            <a:off x="707583" y="733558"/>
            <a:ext cx="1739677" cy="1590656"/>
            <a:chOff x="3871230" y="4248221"/>
            <a:chExt cx="1739677" cy="1590656"/>
          </a:xfrm>
        </p:grpSpPr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B05CFD06-DA26-B7A6-1B51-5DFC7BE91795}"/>
                </a:ext>
              </a:extLst>
            </p:cNvPr>
            <p:cNvGrpSpPr/>
            <p:nvPr/>
          </p:nvGrpSpPr>
          <p:grpSpPr>
            <a:xfrm>
              <a:off x="3871230" y="4248221"/>
              <a:ext cx="1739677" cy="1590656"/>
              <a:chOff x="3871230" y="4151971"/>
              <a:chExt cx="1739677" cy="1590656"/>
            </a:xfrm>
          </p:grpSpPr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36D01A42-E9B8-2A4E-072B-3280163B80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4095493" y="4450568"/>
                <a:ext cx="721337" cy="1292059"/>
              </a:xfrm>
              <a:prstGeom prst="rect">
                <a:avLst/>
              </a:prstGeom>
            </p:spPr>
          </p:pic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A66AE3CD-6239-69FF-9D68-2278045E7872}"/>
                  </a:ext>
                </a:extLst>
              </p:cNvPr>
              <p:cNvGrpSpPr/>
              <p:nvPr/>
            </p:nvGrpSpPr>
            <p:grpSpPr>
              <a:xfrm>
                <a:off x="4816830" y="4472737"/>
                <a:ext cx="436705" cy="1187362"/>
                <a:chOff x="1071648" y="3480895"/>
                <a:chExt cx="728502" cy="2658799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65A45272-6793-AA73-A25E-AC8290EB7E75}"/>
                    </a:ext>
                  </a:extLst>
                </p:cNvPr>
                <p:cNvSpPr txBox="1"/>
                <p:nvPr/>
              </p:nvSpPr>
              <p:spPr>
                <a:xfrm>
                  <a:off x="1075354" y="3480895"/>
                  <a:ext cx="682691" cy="3137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solidFill>
                        <a:srgbClr val="FF66CC"/>
                      </a:solidFill>
                    </a:rPr>
                    <a:t>270</a:t>
                  </a:r>
                </a:p>
              </p:txBody>
            </p:sp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5DABFE47-BAE5-C251-FBB6-E9460BE729A8}"/>
                    </a:ext>
                  </a:extLst>
                </p:cNvPr>
                <p:cNvGrpSpPr/>
                <p:nvPr/>
              </p:nvGrpSpPr>
              <p:grpSpPr>
                <a:xfrm>
                  <a:off x="1071648" y="3821661"/>
                  <a:ext cx="728502" cy="2318033"/>
                  <a:chOff x="1071648" y="3821661"/>
                  <a:chExt cx="728502" cy="2318033"/>
                </a:xfrm>
              </p:grpSpPr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E5A04E0D-3504-A3EC-F1BB-560A28B3ED0C}"/>
                      </a:ext>
                    </a:extLst>
                  </p:cNvPr>
                  <p:cNvSpPr txBox="1"/>
                  <p:nvPr/>
                </p:nvSpPr>
                <p:spPr>
                  <a:xfrm>
                    <a:off x="1071648" y="3821661"/>
                    <a:ext cx="706586" cy="313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</a:rPr>
                      <a:t>130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B10F67BA-0292-A73B-94B3-65602CFDA09C}"/>
                      </a:ext>
                    </a:extLst>
                  </p:cNvPr>
                  <p:cNvSpPr txBox="1"/>
                  <p:nvPr/>
                </p:nvSpPr>
                <p:spPr>
                  <a:xfrm>
                    <a:off x="1114328" y="4113227"/>
                    <a:ext cx="663906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chemeClr val="accent1">
                            <a:lumMod val="75000"/>
                          </a:schemeClr>
                        </a:solidFill>
                      </a:rPr>
                      <a:t>95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C5E7A800-C130-0AFC-FB94-247F74F62A4A}"/>
                      </a:ext>
                    </a:extLst>
                  </p:cNvPr>
                  <p:cNvSpPr txBox="1"/>
                  <p:nvPr/>
                </p:nvSpPr>
                <p:spPr>
                  <a:xfrm>
                    <a:off x="1093564" y="4462841"/>
                    <a:ext cx="706586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chemeClr val="tx2">
                            <a:lumMod val="40000"/>
                            <a:lumOff val="60000"/>
                          </a:schemeClr>
                        </a:solidFill>
                      </a:rPr>
                      <a:t>66</a:t>
                    </a: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649F5D29-2DCB-C871-8630-698AC016E926}"/>
                      </a:ext>
                    </a:extLst>
                  </p:cNvPr>
                  <p:cNvSpPr txBox="1"/>
                  <p:nvPr/>
                </p:nvSpPr>
                <p:spPr>
                  <a:xfrm>
                    <a:off x="1093564" y="4872265"/>
                    <a:ext cx="593679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FFCC00"/>
                        </a:solidFill>
                      </a:rPr>
                      <a:t>52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11D1FD95-2748-7349-7B1D-D8E5FC0966E5}"/>
                      </a:ext>
                    </a:extLst>
                  </p:cNvPr>
                  <p:cNvSpPr txBox="1"/>
                  <p:nvPr/>
                </p:nvSpPr>
                <p:spPr>
                  <a:xfrm>
                    <a:off x="1106186" y="5187086"/>
                    <a:ext cx="581058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FF66CC"/>
                        </a:solidFill>
                      </a:rPr>
                      <a:t>30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2B4C649A-BE54-5244-EFEE-0AE5594A371D}"/>
                      </a:ext>
                    </a:extLst>
                  </p:cNvPr>
                  <p:cNvSpPr txBox="1"/>
                  <p:nvPr/>
                </p:nvSpPr>
                <p:spPr>
                  <a:xfrm>
                    <a:off x="1114328" y="5501912"/>
                    <a:ext cx="618417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chemeClr val="accent5">
                            <a:lumMod val="75000"/>
                          </a:schemeClr>
                        </a:solidFill>
                      </a:rPr>
                      <a:t>16</a:t>
                    </a:r>
                  </a:p>
                </p:txBody>
              </p:sp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96E0C5A1-3220-11EB-B3B2-36A08087595D}"/>
                      </a:ext>
                    </a:extLst>
                  </p:cNvPr>
                  <p:cNvSpPr txBox="1"/>
                  <p:nvPr/>
                </p:nvSpPr>
                <p:spPr>
                  <a:xfrm>
                    <a:off x="1110258" y="5825943"/>
                    <a:ext cx="672050" cy="31375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chemeClr val="accent5">
                            <a:lumMod val="75000"/>
                          </a:schemeClr>
                        </a:solidFill>
                      </a:rPr>
                      <a:t>6.5</a:t>
                    </a:r>
                  </a:p>
                </p:txBody>
              </p:sp>
            </p:grp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49CA423-6F0D-B2D0-BD1F-9B71B60AE4BD}"/>
                  </a:ext>
                </a:extLst>
              </p:cNvPr>
              <p:cNvSpPr txBox="1"/>
              <p:nvPr/>
            </p:nvSpPr>
            <p:spPr>
              <a:xfrm>
                <a:off x="4472594" y="4151971"/>
                <a:ext cx="11383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solidFill>
                      <a:srgbClr val="7030A0"/>
                    </a:solidFill>
                  </a:rPr>
                  <a:t>Protein marker</a:t>
                </a:r>
                <a:endParaRPr lang="en-IN" sz="1000" dirty="0">
                  <a:solidFill>
                    <a:srgbClr val="7030A0"/>
                  </a:solidFill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A3636F65-5EDB-FEDB-66D6-158064A84FF0}"/>
                  </a:ext>
                </a:extLst>
              </p:cNvPr>
              <p:cNvSpPr txBox="1"/>
              <p:nvPr/>
            </p:nvSpPr>
            <p:spPr>
              <a:xfrm>
                <a:off x="3871230" y="4222546"/>
                <a:ext cx="7715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err="1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b</a:t>
                </a:r>
                <a:r>
                  <a:rPr lang="en-US" sz="1000" b="1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WCL</a:t>
                </a:r>
                <a:endParaRPr lang="en-IN" sz="1000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09AAC37B-6DD8-7445-7420-114E8297A763}"/>
                  </a:ext>
                </a:extLst>
              </p:cNvPr>
              <p:cNvSpPr/>
              <p:nvPr/>
            </p:nvSpPr>
            <p:spPr>
              <a:xfrm>
                <a:off x="4072347" y="4423366"/>
                <a:ext cx="463391" cy="1319261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id="{8C7049EA-AC64-0496-08B0-BD45D92D71E6}"/>
                  </a:ext>
                </a:extLst>
              </p:cNvPr>
              <p:cNvCxnSpPr>
                <a:cxnSpLocks/>
                <a:stCxn id="59" idx="3"/>
              </p:cNvCxnSpPr>
              <p:nvPr/>
            </p:nvCxnSpPr>
            <p:spPr>
              <a:xfrm>
                <a:off x="4642819" y="4345657"/>
                <a:ext cx="0" cy="123110"/>
              </a:xfrm>
              <a:prstGeom prst="straightConnector1">
                <a:avLst/>
              </a:prstGeom>
              <a:ln w="12700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A67E548-C4B6-2793-0633-2DDBA08B4FEA}"/>
                </a:ext>
              </a:extLst>
            </p:cNvPr>
            <p:cNvSpPr txBox="1"/>
            <p:nvPr/>
          </p:nvSpPr>
          <p:spPr>
            <a:xfrm>
              <a:off x="4779210" y="4395473"/>
              <a:ext cx="37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kDa</a:t>
              </a:r>
              <a:endParaRPr lang="en-US" sz="1000" dirty="0"/>
            </a:p>
          </p:txBody>
        </p:sp>
      </p:grp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838631-9441-CE49-8981-9E017C87F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2A8AD-D833-4F86-84ED-DA4B57ECCBB0}" type="slidenum">
              <a:rPr lang="en-IN" smtClean="0"/>
              <a:t>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4816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6833</TotalTime>
  <Words>1841</Words>
  <Application>Microsoft Office PowerPoint</Application>
  <PresentationFormat>A4 Paper (210x297 mm)</PresentationFormat>
  <Paragraphs>154</Paragraphs>
  <Slides>1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3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Prism 8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DHI YADAV</dc:creator>
  <cp:lastModifiedBy>NIDHI YADAV</cp:lastModifiedBy>
  <cp:revision>169</cp:revision>
  <dcterms:created xsi:type="dcterms:W3CDTF">2024-12-30T10:25:58Z</dcterms:created>
  <dcterms:modified xsi:type="dcterms:W3CDTF">2026-07-06T09:57:10Z</dcterms:modified>
</cp:coreProperties>
</file>